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64" r:id="rId3"/>
    <p:sldId id="260" r:id="rId4"/>
    <p:sldId id="256" r:id="rId5"/>
    <p:sldId id="261" r:id="rId6"/>
    <p:sldId id="262" r:id="rId7"/>
  </p:sldIdLst>
  <p:sldSz cx="13208000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B4C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6353" autoAdjust="0"/>
  </p:normalViewPr>
  <p:slideViewPr>
    <p:cSldViewPr snapToGrid="0">
      <p:cViewPr varScale="1">
        <p:scale>
          <a:sx n="83" d="100"/>
          <a:sy n="83" d="100"/>
        </p:scale>
        <p:origin x="129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吉武 和敏" userId="e4825ba96748af9c" providerId="LiveId" clId="{217C50B4-A483-4C27-9859-CC9E78347B11}"/>
    <pc:docChg chg="custSel">
      <pc:chgData name="吉武 和敏" userId="e4825ba96748af9c" providerId="LiveId" clId="{217C50B4-A483-4C27-9859-CC9E78347B11}" dt="2022-03-02T03:01:57.622" v="0" actId="1592"/>
      <pc:docMkLst>
        <pc:docMk/>
      </pc:docMkLst>
      <pc:sldChg chg="delCm">
        <pc:chgData name="吉武 和敏" userId="e4825ba96748af9c" providerId="LiveId" clId="{217C50B4-A483-4C27-9859-CC9E78347B11}" dt="2022-03-02T03:01:57.622" v="0" actId="1592"/>
        <pc:sldMkLst>
          <pc:docMk/>
          <pc:sldMk cId="363600399" sldId="260"/>
        </pc:sldMkLst>
      </pc:sldChg>
    </pc:docChg>
  </pc:docChgLst>
  <pc:docChgLst>
    <pc:chgData name="吉武 和敏" userId="e4825ba96748af9c" providerId="LiveId" clId="{82A9641A-7A2D-4A3E-B324-A4EDAFB6209E}"/>
    <pc:docChg chg="modSld">
      <pc:chgData name="吉武 和敏" userId="e4825ba96748af9c" providerId="LiveId" clId="{82A9641A-7A2D-4A3E-B324-A4EDAFB6209E}" dt="2021-06-18T09:57:15.490" v="3" actId="20577"/>
      <pc:docMkLst>
        <pc:docMk/>
      </pc:docMkLst>
      <pc:sldChg chg="modSp mod">
        <pc:chgData name="吉武 和敏" userId="e4825ba96748af9c" providerId="LiveId" clId="{82A9641A-7A2D-4A3E-B324-A4EDAFB6209E}" dt="2021-06-18T09:57:15.490" v="3" actId="20577"/>
        <pc:sldMkLst>
          <pc:docMk/>
          <pc:sldMk cId="4258909056" sldId="273"/>
        </pc:sldMkLst>
        <pc:graphicFrameChg chg="modGraphic">
          <ac:chgData name="吉武 和敏" userId="e4825ba96748af9c" providerId="LiveId" clId="{82A9641A-7A2D-4A3E-B324-A4EDAFB6209E}" dt="2021-06-18T09:56:59.060" v="2" actId="20577"/>
          <ac:graphicFrameMkLst>
            <pc:docMk/>
            <pc:sldMk cId="4258909056" sldId="273"/>
            <ac:graphicFrameMk id="26" creationId="{84B46B27-8B9C-42BD-8C55-80201C51B369}"/>
          </ac:graphicFrameMkLst>
        </pc:graphicFrameChg>
        <pc:graphicFrameChg chg="modGraphic">
          <ac:chgData name="吉武 和敏" userId="e4825ba96748af9c" providerId="LiveId" clId="{82A9641A-7A2D-4A3E-B324-A4EDAFB6209E}" dt="2021-06-18T09:57:15.490" v="3" actId="20577"/>
          <ac:graphicFrameMkLst>
            <pc:docMk/>
            <pc:sldMk cId="4258909056" sldId="273"/>
            <ac:graphicFrameMk id="27" creationId="{AD6E767D-92D6-4EDB-90B5-96632AA35D78}"/>
          </ac:graphicFrameMkLst>
        </pc:graphicFrameChg>
      </pc:sldChg>
    </pc:docChg>
  </pc:docChgLst>
  <pc:docChgLst>
    <pc:chgData name="吉武 和敏" userId="e4825ba96748af9c" providerId="LiveId" clId="{917B18EA-CFD2-4842-A770-C54A8DAF286E}"/>
    <pc:docChg chg="undo redo custSel addSld delSld modSld sldOrd">
      <pc:chgData name="吉武 和敏" userId="e4825ba96748af9c" providerId="LiveId" clId="{917B18EA-CFD2-4842-A770-C54A8DAF286E}" dt="2020-12-01T05:05:18.677" v="2256" actId="47"/>
      <pc:docMkLst>
        <pc:docMk/>
      </pc:docMkLst>
      <pc:sldChg chg="modSp mod">
        <pc:chgData name="吉武 和敏" userId="e4825ba96748af9c" providerId="LiveId" clId="{917B18EA-CFD2-4842-A770-C54A8DAF286E}" dt="2020-11-30T09:25:35.551" v="2231" actId="1076"/>
        <pc:sldMkLst>
          <pc:docMk/>
          <pc:sldMk cId="3007290250" sldId="257"/>
        </pc:sldMkLst>
        <pc:spChg chg="mod">
          <ac:chgData name="吉武 和敏" userId="e4825ba96748af9c" providerId="LiveId" clId="{917B18EA-CFD2-4842-A770-C54A8DAF286E}" dt="2020-11-30T09:25:35.551" v="2231" actId="1076"/>
          <ac:spMkLst>
            <pc:docMk/>
            <pc:sldMk cId="3007290250" sldId="257"/>
            <ac:spMk id="4" creationId="{772CF3D9-A51C-4BE2-9EDC-B5361442FF11}"/>
          </ac:spMkLst>
        </pc:spChg>
        <pc:graphicFrameChg chg="mod modGraphic">
          <ac:chgData name="吉武 和敏" userId="e4825ba96748af9c" providerId="LiveId" clId="{917B18EA-CFD2-4842-A770-C54A8DAF286E}" dt="2020-11-30T09:25:26.963" v="2230" actId="14734"/>
          <ac:graphicFrameMkLst>
            <pc:docMk/>
            <pc:sldMk cId="3007290250" sldId="257"/>
            <ac:graphicFrameMk id="2" creationId="{28B07E2B-B90F-4B4C-BBA3-E619BFFFA2B2}"/>
          </ac:graphicFrameMkLst>
        </pc:graphicFrameChg>
      </pc:sldChg>
      <pc:sldChg chg="del">
        <pc:chgData name="吉武 和敏" userId="e4825ba96748af9c" providerId="LiveId" clId="{917B18EA-CFD2-4842-A770-C54A8DAF286E}" dt="2020-11-30T05:56:46.575" v="953" actId="47"/>
        <pc:sldMkLst>
          <pc:docMk/>
          <pc:sldMk cId="1470106984" sldId="258"/>
        </pc:sldMkLst>
      </pc:sldChg>
      <pc:sldChg chg="del">
        <pc:chgData name="吉武 和敏" userId="e4825ba96748af9c" providerId="LiveId" clId="{917B18EA-CFD2-4842-A770-C54A8DAF286E}" dt="2020-11-30T07:46:58.897" v="1646" actId="47"/>
        <pc:sldMkLst>
          <pc:docMk/>
          <pc:sldMk cId="3069005380" sldId="259"/>
        </pc:sldMkLst>
      </pc:sldChg>
      <pc:sldChg chg="modSp mod">
        <pc:chgData name="吉武 和敏" userId="e4825ba96748af9c" providerId="LiveId" clId="{917B18EA-CFD2-4842-A770-C54A8DAF286E}" dt="2020-11-18T07:41:51.278" v="27" actId="1076"/>
        <pc:sldMkLst>
          <pc:docMk/>
          <pc:sldMk cId="363600399" sldId="260"/>
        </pc:sldMkLst>
        <pc:spChg chg="mod">
          <ac:chgData name="吉武 和敏" userId="e4825ba96748af9c" providerId="LiveId" clId="{917B18EA-CFD2-4842-A770-C54A8DAF286E}" dt="2020-11-18T07:41:36.491" v="25" actId="1076"/>
          <ac:spMkLst>
            <pc:docMk/>
            <pc:sldMk cId="363600399" sldId="260"/>
            <ac:spMk id="2" creationId="{AC23B9C4-159D-4EF0-BDCB-2F71D15456B7}"/>
          </ac:spMkLst>
        </pc:spChg>
        <pc:spChg chg="mod">
          <ac:chgData name="吉武 和敏" userId="e4825ba96748af9c" providerId="LiveId" clId="{917B18EA-CFD2-4842-A770-C54A8DAF286E}" dt="2020-11-18T07:41:51.278" v="27" actId="1076"/>
          <ac:spMkLst>
            <pc:docMk/>
            <pc:sldMk cId="363600399" sldId="260"/>
            <ac:spMk id="7" creationId="{83FF8330-9C2D-4FC6-BC52-20C77FBEFEC5}"/>
          </ac:spMkLst>
        </pc:spChg>
      </pc:sldChg>
      <pc:sldChg chg="modSp del mod">
        <pc:chgData name="吉武 和敏" userId="e4825ba96748af9c" providerId="LiveId" clId="{917B18EA-CFD2-4842-A770-C54A8DAF286E}" dt="2020-12-01T05:05:18.677" v="2256" actId="47"/>
        <pc:sldMkLst>
          <pc:docMk/>
          <pc:sldMk cId="2480095649" sldId="261"/>
        </pc:sldMkLst>
        <pc:graphicFrameChg chg="modGraphic">
          <ac:chgData name="吉武 和敏" userId="e4825ba96748af9c" providerId="LiveId" clId="{917B18EA-CFD2-4842-A770-C54A8DAF286E}" dt="2020-11-18T07:55:09.494" v="48" actId="20577"/>
          <ac:graphicFrameMkLst>
            <pc:docMk/>
            <pc:sldMk cId="2480095649" sldId="261"/>
            <ac:graphicFrameMk id="4" creationId="{6AE222D2-36ED-442A-960E-72AFD1272AEA}"/>
          </ac:graphicFrameMkLst>
        </pc:graphicFrameChg>
      </pc:sldChg>
      <pc:sldChg chg="addSp delSp modSp mod ord">
        <pc:chgData name="吉武 和敏" userId="e4825ba96748af9c" providerId="LiveId" clId="{917B18EA-CFD2-4842-A770-C54A8DAF286E}" dt="2020-11-30T09:55:46.073" v="2255" actId="1076"/>
        <pc:sldMkLst>
          <pc:docMk/>
          <pc:sldMk cId="2234882533" sldId="262"/>
        </pc:sldMkLst>
        <pc:spChg chg="mod">
          <ac:chgData name="吉武 和敏" userId="e4825ba96748af9c" providerId="LiveId" clId="{917B18EA-CFD2-4842-A770-C54A8DAF286E}" dt="2020-11-30T09:55:46.073" v="2255" actId="1076"/>
          <ac:spMkLst>
            <pc:docMk/>
            <pc:sldMk cId="2234882533" sldId="262"/>
            <ac:spMk id="4" creationId="{772CF3D9-A51C-4BE2-9EDC-B5361442FF11}"/>
          </ac:spMkLst>
        </pc:spChg>
        <pc:spChg chg="add del mod">
          <ac:chgData name="吉武 和敏" userId="e4825ba96748af9c" providerId="LiveId" clId="{917B18EA-CFD2-4842-A770-C54A8DAF286E}" dt="2020-11-18T07:27:09.232" v="1"/>
          <ac:spMkLst>
            <pc:docMk/>
            <pc:sldMk cId="2234882533" sldId="262"/>
            <ac:spMk id="5" creationId="{14B0BF0F-9B76-42CB-8929-09AD7CED5832}"/>
          </ac:spMkLst>
        </pc:spChg>
        <pc:spChg chg="add del mod">
          <ac:chgData name="吉武 和敏" userId="e4825ba96748af9c" providerId="LiveId" clId="{917B18EA-CFD2-4842-A770-C54A8DAF286E}" dt="2020-11-18T07:27:09.232" v="1"/>
          <ac:spMkLst>
            <pc:docMk/>
            <pc:sldMk cId="2234882533" sldId="262"/>
            <ac:spMk id="50" creationId="{12324113-46D3-4075-B9C3-52DBC3FECBB5}"/>
          </ac:spMkLst>
        </pc:spChg>
        <pc:spChg chg="add del mod">
          <ac:chgData name="吉武 和敏" userId="e4825ba96748af9c" providerId="LiveId" clId="{917B18EA-CFD2-4842-A770-C54A8DAF286E}" dt="2020-11-18T07:27:09.232" v="1"/>
          <ac:spMkLst>
            <pc:docMk/>
            <pc:sldMk cId="2234882533" sldId="262"/>
            <ac:spMk id="51" creationId="{9ABD6761-9E1F-4BDD-9B66-EEABBE85495C}"/>
          </ac:spMkLst>
        </pc:spChg>
        <pc:spChg chg="add del mod">
          <ac:chgData name="吉武 和敏" userId="e4825ba96748af9c" providerId="LiveId" clId="{917B18EA-CFD2-4842-A770-C54A8DAF286E}" dt="2020-11-18T07:27:14.412" v="3"/>
          <ac:spMkLst>
            <pc:docMk/>
            <pc:sldMk cId="2234882533" sldId="262"/>
            <ac:spMk id="53" creationId="{36DD2CAF-EAF9-43BD-ABDE-1108584781F5}"/>
          </ac:spMkLst>
        </pc:spChg>
        <pc:spChg chg="add del mod">
          <ac:chgData name="吉武 和敏" userId="e4825ba96748af9c" providerId="LiveId" clId="{917B18EA-CFD2-4842-A770-C54A8DAF286E}" dt="2020-11-18T07:27:14.412" v="3"/>
          <ac:spMkLst>
            <pc:docMk/>
            <pc:sldMk cId="2234882533" sldId="262"/>
            <ac:spMk id="98" creationId="{A3C054B5-59F7-40AB-BB71-32ED7DEE3B16}"/>
          </ac:spMkLst>
        </pc:spChg>
        <pc:spChg chg="add del mod">
          <ac:chgData name="吉武 和敏" userId="e4825ba96748af9c" providerId="LiveId" clId="{917B18EA-CFD2-4842-A770-C54A8DAF286E}" dt="2020-11-18T07:27:14.412" v="3"/>
          <ac:spMkLst>
            <pc:docMk/>
            <pc:sldMk cId="2234882533" sldId="262"/>
            <ac:spMk id="99" creationId="{B2536AB8-65C5-4A05-B234-204B4F82081C}"/>
          </ac:spMkLst>
        </pc:spChg>
        <pc:spChg chg="add del mod">
          <ac:chgData name="吉武 和敏" userId="e4825ba96748af9c" providerId="LiveId" clId="{917B18EA-CFD2-4842-A770-C54A8DAF286E}" dt="2020-11-18T07:27:20.429" v="5"/>
          <ac:spMkLst>
            <pc:docMk/>
            <pc:sldMk cId="2234882533" sldId="262"/>
            <ac:spMk id="101" creationId="{840F0017-456F-459B-A521-4A831A2FBA99}"/>
          </ac:spMkLst>
        </pc:spChg>
        <pc:spChg chg="add del mod">
          <ac:chgData name="吉武 和敏" userId="e4825ba96748af9c" providerId="LiveId" clId="{917B18EA-CFD2-4842-A770-C54A8DAF286E}" dt="2020-11-18T07:27:20.429" v="5"/>
          <ac:spMkLst>
            <pc:docMk/>
            <pc:sldMk cId="2234882533" sldId="262"/>
            <ac:spMk id="146" creationId="{740E0146-1862-4935-BF39-5A0B099612A9}"/>
          </ac:spMkLst>
        </pc:spChg>
        <pc:spChg chg="add del mod">
          <ac:chgData name="吉武 和敏" userId="e4825ba96748af9c" providerId="LiveId" clId="{917B18EA-CFD2-4842-A770-C54A8DAF286E}" dt="2020-11-18T07:27:20.429" v="5"/>
          <ac:spMkLst>
            <pc:docMk/>
            <pc:sldMk cId="2234882533" sldId="262"/>
            <ac:spMk id="147" creationId="{2000307D-CD47-4331-9877-AE37EF62DF16}"/>
          </ac:spMkLst>
        </pc:spChg>
        <pc:grpChg chg="add del mod">
          <ac:chgData name="吉武 和敏" userId="e4825ba96748af9c" providerId="LiveId" clId="{917B18EA-CFD2-4842-A770-C54A8DAF286E}" dt="2020-11-18T07:27:09.232" v="1"/>
          <ac:grpSpMkLst>
            <pc:docMk/>
            <pc:sldMk cId="2234882533" sldId="262"/>
            <ac:grpSpMk id="6" creationId="{1A8B1FF3-AD36-4F60-ACE6-2959CE541FC6}"/>
          </ac:grpSpMkLst>
        </pc:grpChg>
        <pc:grpChg chg="add del mod">
          <ac:chgData name="吉武 和敏" userId="e4825ba96748af9c" providerId="LiveId" clId="{917B18EA-CFD2-4842-A770-C54A8DAF286E}" dt="2020-11-18T07:27:14.412" v="3"/>
          <ac:grpSpMkLst>
            <pc:docMk/>
            <pc:sldMk cId="2234882533" sldId="262"/>
            <ac:grpSpMk id="54" creationId="{6EC0662A-EC52-4EE4-8246-76E665BAD7C9}"/>
          </ac:grpSpMkLst>
        </pc:grpChg>
        <pc:grpChg chg="add del mod">
          <ac:chgData name="吉武 和敏" userId="e4825ba96748af9c" providerId="LiveId" clId="{917B18EA-CFD2-4842-A770-C54A8DAF286E}" dt="2020-11-18T07:27:20.429" v="5"/>
          <ac:grpSpMkLst>
            <pc:docMk/>
            <pc:sldMk cId="2234882533" sldId="262"/>
            <ac:grpSpMk id="102" creationId="{CFB2BF40-2F79-4F5B-BA18-6BFF791096B9}"/>
          </ac:grpSpMkLst>
        </pc:grpChg>
        <pc:graphicFrameChg chg="mod modGraphic">
          <ac:chgData name="吉武 和敏" userId="e4825ba96748af9c" providerId="LiveId" clId="{917B18EA-CFD2-4842-A770-C54A8DAF286E}" dt="2020-11-30T09:48:41.575" v="2254" actId="20577"/>
          <ac:graphicFrameMkLst>
            <pc:docMk/>
            <pc:sldMk cId="2234882533" sldId="262"/>
            <ac:graphicFrameMk id="2" creationId="{28B07E2B-B90F-4B4C-BBA3-E619BFFFA2B2}"/>
          </ac:graphicFrameMkLst>
        </pc:graphicFrameChg>
        <pc:picChg chg="mod">
          <ac:chgData name="吉武 和敏" userId="e4825ba96748af9c" providerId="LiveId" clId="{917B18EA-CFD2-4842-A770-C54A8DAF286E}" dt="2020-11-18T07:27:07.433" v="0"/>
          <ac:picMkLst>
            <pc:docMk/>
            <pc:sldMk cId="2234882533" sldId="262"/>
            <ac:picMk id="7" creationId="{E1879AD2-7F00-4005-9103-8DAA7533CF83}"/>
          </ac:picMkLst>
        </pc:picChg>
        <pc:picChg chg="mod">
          <ac:chgData name="吉武 和敏" userId="e4825ba96748af9c" providerId="LiveId" clId="{917B18EA-CFD2-4842-A770-C54A8DAF286E}" dt="2020-11-18T07:27:07.433" v="0"/>
          <ac:picMkLst>
            <pc:docMk/>
            <pc:sldMk cId="2234882533" sldId="262"/>
            <ac:picMk id="8" creationId="{4D51C486-83A9-4BBA-A24C-4A7038419650}"/>
          </ac:picMkLst>
        </pc:picChg>
        <pc:picChg chg="mod">
          <ac:chgData name="吉武 和敏" userId="e4825ba96748af9c" providerId="LiveId" clId="{917B18EA-CFD2-4842-A770-C54A8DAF286E}" dt="2020-11-18T07:27:13.171" v="2"/>
          <ac:picMkLst>
            <pc:docMk/>
            <pc:sldMk cId="2234882533" sldId="262"/>
            <ac:picMk id="55" creationId="{CBAFBD40-14BA-4D0A-928F-F4594D555B4A}"/>
          </ac:picMkLst>
        </pc:picChg>
        <pc:picChg chg="mod">
          <ac:chgData name="吉武 和敏" userId="e4825ba96748af9c" providerId="LiveId" clId="{917B18EA-CFD2-4842-A770-C54A8DAF286E}" dt="2020-11-18T07:27:13.171" v="2"/>
          <ac:picMkLst>
            <pc:docMk/>
            <pc:sldMk cId="2234882533" sldId="262"/>
            <ac:picMk id="56" creationId="{57671EE5-C05C-4EE4-AA63-4154424FD088}"/>
          </ac:picMkLst>
        </pc:picChg>
        <pc:picChg chg="mod">
          <ac:chgData name="吉武 和敏" userId="e4825ba96748af9c" providerId="LiveId" clId="{917B18EA-CFD2-4842-A770-C54A8DAF286E}" dt="2020-11-18T07:27:19.235" v="4"/>
          <ac:picMkLst>
            <pc:docMk/>
            <pc:sldMk cId="2234882533" sldId="262"/>
            <ac:picMk id="103" creationId="{C51E5031-DCEB-46D7-9DBD-5EF5707E75AD}"/>
          </ac:picMkLst>
        </pc:picChg>
        <pc:picChg chg="mod">
          <ac:chgData name="吉武 和敏" userId="e4825ba96748af9c" providerId="LiveId" clId="{917B18EA-CFD2-4842-A770-C54A8DAF286E}" dt="2020-11-18T07:27:19.235" v="4"/>
          <ac:picMkLst>
            <pc:docMk/>
            <pc:sldMk cId="2234882533" sldId="262"/>
            <ac:picMk id="104" creationId="{F5D39B5F-B0A6-43F1-8582-556DE7A9EBA6}"/>
          </ac:picMkLst>
        </pc:pic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9" creationId="{C9B2F824-25C7-493D-A333-E5268F9919F7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0" creationId="{1C963960-ADF7-460A-B697-2C673AF488DD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1" creationId="{0546A157-8E85-4F6A-9B91-B2826D480365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2" creationId="{9D2ABA74-2BAF-4570-BE74-390C3ECA546A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3" creationId="{E2CA057A-74FA-4ADD-B4F6-EF9C840F1125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4" creationId="{2F8CD727-7806-4FBF-BD53-16EC50FEBA69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5" creationId="{6A0018E6-C87F-4094-B4BD-8DDABC265550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6" creationId="{8E599E45-312F-4ABF-899D-87B7CB3FB3FA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7" creationId="{383180DC-DCC2-4736-9569-4E760734AF7F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8" creationId="{DF8BBF4D-13E5-43D9-8084-D59BF4FC25B2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19" creationId="{E34DE1AF-6C66-42D7-82BF-1C2FA00112C0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0" creationId="{D568868D-B2BA-4F7A-AB36-E596D7EB7D03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1" creationId="{9AC39E70-8CA5-42F1-9FC1-5ED4E24C7A68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2" creationId="{25587EB2-C7BB-4C52-8AF9-F842AB7B2902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3" creationId="{3155ED65-9552-49AD-A345-A16290FE9EB5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4" creationId="{F913F5D4-BBF9-4CEF-BF76-FE3343BDE1FC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5" creationId="{3307BEAF-401D-444F-A516-20CC919EC332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6" creationId="{DCB3B06C-B144-4EF6-A6D4-90C6C201FD95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7" creationId="{49DFC403-727F-4161-AF98-5A7D0031D871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8" creationId="{96C39334-B920-4489-9E5D-ACEA411857CC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29" creationId="{870595D9-F319-4993-9D08-3322FD518A69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0" creationId="{CF55D567-DEF6-4AA5-BCF3-8CB0512B6C94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1" creationId="{86BE8F01-42E3-4531-B8DF-E09CA5C5F416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2" creationId="{7CF73543-3433-43C7-9B57-8A36AFCE6C07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3" creationId="{546F2482-3091-44DE-8C0F-B20FF81E77E0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4" creationId="{2B0D4851-7A72-45E5-8A41-49B09272B5BE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5" creationId="{FE1E74EC-F330-4288-B311-02E48C5D08C9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6" creationId="{F3A1CE04-1C66-4F26-AD9B-F2C87E9CB0A8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7" creationId="{08F03F73-F454-4977-A695-A79C302682F6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8" creationId="{7128E13F-D6AD-4083-BA89-94214DC65C40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39" creationId="{ED8046C1-9075-480E-8692-5B80F006BF96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0" creationId="{F814EA4E-A0EE-4A42-B2D9-84321E7E3D8D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1" creationId="{7544C988-DED0-482A-B62A-F5A39B371F40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2" creationId="{A3798B0B-A265-400E-91E5-8D267791DC25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3" creationId="{76BFA899-7E85-426D-B04E-E58914A1A181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4" creationId="{20363349-59F6-4263-A176-D57B3F66EBA1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5" creationId="{6D2750B2-F6F6-4F5E-B98B-391B331AC14E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6" creationId="{0FBDC200-3A55-4065-BE47-7F50453D0EBA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7" creationId="{82B02710-15AE-44AE-B0C1-062A60EBC60D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8" creationId="{D0C382C2-973C-440B-9C4D-180924CBF6CC}"/>
          </ac:cxnSpMkLst>
        </pc:cxnChg>
        <pc:cxnChg chg="mod">
          <ac:chgData name="吉武 和敏" userId="e4825ba96748af9c" providerId="LiveId" clId="{917B18EA-CFD2-4842-A770-C54A8DAF286E}" dt="2020-11-18T07:27:07.433" v="0"/>
          <ac:cxnSpMkLst>
            <pc:docMk/>
            <pc:sldMk cId="2234882533" sldId="262"/>
            <ac:cxnSpMk id="49" creationId="{4B9A1A6A-A9D1-47D5-97F5-CDAE4F0F895F}"/>
          </ac:cxnSpMkLst>
        </pc:cxnChg>
        <pc:cxnChg chg="add del mod">
          <ac:chgData name="吉武 和敏" userId="e4825ba96748af9c" providerId="LiveId" clId="{917B18EA-CFD2-4842-A770-C54A8DAF286E}" dt="2020-11-18T07:27:09.232" v="1"/>
          <ac:cxnSpMkLst>
            <pc:docMk/>
            <pc:sldMk cId="2234882533" sldId="262"/>
            <ac:cxnSpMk id="52" creationId="{1F3B0FDF-9A7B-40E4-ACE1-D4620A777FE1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57" creationId="{6452681F-BBC1-4AEE-A5C5-7B7A9ABEE584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58" creationId="{EAC4B095-9D15-4DC3-BF78-EDA82C03E734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59" creationId="{9D57DC1D-80F6-454E-9071-FEDB4B215398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0" creationId="{7051E1B2-28B8-4B36-B23E-CFE673356158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1" creationId="{FBE5EF9A-F398-4476-B414-3CB67F931E1E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2" creationId="{B4A9F034-1E1B-46F0-9047-0434315FDD37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3" creationId="{95C92C7A-A5AE-4AE1-B199-A1D1E2E610C5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4" creationId="{E4A54F3F-1A94-4A86-8692-6A06181EB2F9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5" creationId="{2C996065-2828-40B1-AB9A-F9B062DA2705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6" creationId="{340F13DB-C531-4FD0-8AE5-6EBD79B11F86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7" creationId="{703AAFA8-429E-4658-95C7-B9411E358D0E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8" creationId="{73284013-C5D2-49B2-95B7-CA6F04331878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69" creationId="{6AEB4458-9543-4C9E-900F-A2B48B3E4DFD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0" creationId="{A5A66BFA-BFDE-4B63-8B06-2C62F5D25C83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1" creationId="{5B3F48D2-70B1-499C-A65C-B3B61913E131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2" creationId="{6EDB40A4-8E40-462F-93B6-DBF5F6A3BDE2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3" creationId="{CE57954E-67F0-44D6-A6D8-CAACCA66C158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4" creationId="{51130A1A-02F6-4666-BAF2-0A8DB598FE09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5" creationId="{D0A4EC9B-5F6E-4E31-9C21-4ED2FD2AA0CD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6" creationId="{E70ED501-399D-45F4-B239-DC3BE5071E50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7" creationId="{E9EB8F37-5610-4A2B-8417-BAA89667FA2B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8" creationId="{B6F8E4C2-710D-4786-96A3-74ED410E792F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79" creationId="{F3952EC7-D1AC-4005-A866-4F910236E44C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0" creationId="{5B057B96-826C-4E64-9A8E-BDB209128B2E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1" creationId="{9A8B2777-7859-404C-9905-487FD400EAFA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2" creationId="{7A3EF5DA-3CCE-4B47-BF5A-CE84D4325966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3" creationId="{835FDF06-6A00-49E6-B95F-510829731E08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4" creationId="{83090871-956D-473E-ACD5-A9B1C3016684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5" creationId="{A55AF225-9406-432C-B25A-BAE359079F43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6" creationId="{80960BF7-64E4-447A-9616-75488492E1EA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7" creationId="{17F87793-39AB-424F-B43B-2A8CE985F454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8" creationId="{9F62244E-014E-4666-BA69-4444C076FD56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89" creationId="{E9FB1533-D06C-4ACE-BEB7-A98FFD3737F1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90" creationId="{F31BFA00-7B21-4AED-A6B6-48988A2B95BC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91" creationId="{58AA1453-9566-42E7-960A-9246EFFA7E69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92" creationId="{ED998695-64FD-40A4-9874-7485D0B7EFAE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93" creationId="{EAEED2BF-7719-4843-B865-C6AA9B1A75DF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94" creationId="{712D611B-9F52-4CE6-B7F7-27359EE261AF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95" creationId="{667616F0-58AE-43A0-BA1C-53F5F7F56CBF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96" creationId="{8F7963BB-550F-476F-B5E2-2D56CC672C5E}"/>
          </ac:cxnSpMkLst>
        </pc:cxnChg>
        <pc:cxnChg chg="mod">
          <ac:chgData name="吉武 和敏" userId="e4825ba96748af9c" providerId="LiveId" clId="{917B18EA-CFD2-4842-A770-C54A8DAF286E}" dt="2020-11-18T07:27:13.171" v="2"/>
          <ac:cxnSpMkLst>
            <pc:docMk/>
            <pc:sldMk cId="2234882533" sldId="262"/>
            <ac:cxnSpMk id="97" creationId="{463BAF19-6423-47D5-8F53-1FFF4795A25F}"/>
          </ac:cxnSpMkLst>
        </pc:cxnChg>
        <pc:cxnChg chg="add del mod">
          <ac:chgData name="吉武 和敏" userId="e4825ba96748af9c" providerId="LiveId" clId="{917B18EA-CFD2-4842-A770-C54A8DAF286E}" dt="2020-11-18T07:27:14.412" v="3"/>
          <ac:cxnSpMkLst>
            <pc:docMk/>
            <pc:sldMk cId="2234882533" sldId="262"/>
            <ac:cxnSpMk id="100" creationId="{C8A5C596-F470-4C38-AB8C-44644222807C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05" creationId="{B9A9571B-9347-4975-BA3A-695AEA0F59D8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06" creationId="{007E5366-AA08-4920-BE5F-D1C5F2FED11B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07" creationId="{71EADA42-0CE1-4225-AA26-726F9C6C7BC2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08" creationId="{484412A1-0D46-4C3F-B523-25093474826C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09" creationId="{E0E12C08-94A1-4B5B-9C44-BCF520CD2FC0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0" creationId="{541B938D-593E-4316-AE21-DF98B3ED24E0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1" creationId="{38C935AD-00F7-4B83-86F3-08718DCBA1EA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2" creationId="{C33C6FE8-E80C-4035-91A0-DBAE947C6222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3" creationId="{41F6F114-3752-4803-AE68-DE08699E6D41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4" creationId="{2B3598BB-004B-4E41-A412-DF6D7BB79A61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5" creationId="{79A3C713-335E-486D-B499-B47E0A7E568F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6" creationId="{0AA2D447-D3AC-4CFD-AAA8-EE026E3437BB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7" creationId="{591E8810-6659-43EB-947E-0261C359E9AE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8" creationId="{39BA7B71-98B3-419C-B9B4-370B4F44B7CE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19" creationId="{8A1CAF2D-D222-4DE4-93F5-45E04F32739A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0" creationId="{732B9E5F-9F61-432F-8CBE-E35AC5600CBE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1" creationId="{23F613BB-A498-469E-8217-81725FDF54A5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2" creationId="{3D47600B-A20F-4007-A75D-63B1A255BB93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3" creationId="{4EA63C85-E92C-4342-A213-D9ED90CE78BA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4" creationId="{88D30EC3-AFDF-43B6-85A9-CD4CDB3E2FB0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5" creationId="{0FE95A95-BF41-4E28-ABA7-7DCBC10183E9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6" creationId="{D871BA90-617C-41C9-83E1-048FAE172B66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7" creationId="{C97A2D1D-D67E-40A2-91F7-4D3B4FEE3165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8" creationId="{45233115-E734-42C7-94D3-2CB307864EB7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29" creationId="{C0F99F29-6CB0-4757-B292-DB4DE15E389B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0" creationId="{C187FB30-1F3F-4D5D-AE2D-DB7905D8DA0C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1" creationId="{3E43FD99-14C6-482F-BADE-2686AA675BC8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2" creationId="{4A80218A-276E-40F1-AD48-66C81E280FBC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3" creationId="{E312DCA5-1141-458A-BEF2-79C1720F9DF4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4" creationId="{C8F34F3D-397C-4157-ABD0-C7741E9D6616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5" creationId="{A666ECD1-DD21-4465-ADBA-B49CE80C386D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6" creationId="{05FD64BD-F280-4D17-9915-9B6BD9B8A4D4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7" creationId="{8681924F-1655-4781-A8F6-BF719425D653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8" creationId="{1960CC89-B0AA-417E-A429-716AC674EA9A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39" creationId="{90A22778-1EA6-45A6-8E7A-3BAEE9CF453E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40" creationId="{1732257E-112C-43B3-8010-567E7771C82E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41" creationId="{8143E04A-A9CE-4E23-9D9D-161E2E5B099C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42" creationId="{12860DC6-1FB8-4F41-8FCB-A4F7B974A41C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43" creationId="{C274F961-7064-41DC-8A28-83B3621D2C10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44" creationId="{BD2D7C15-E72A-415C-8884-903C8757396D}"/>
          </ac:cxnSpMkLst>
        </pc:cxnChg>
        <pc:cxnChg chg="mod">
          <ac:chgData name="吉武 和敏" userId="e4825ba96748af9c" providerId="LiveId" clId="{917B18EA-CFD2-4842-A770-C54A8DAF286E}" dt="2020-11-18T07:27:19.235" v="4"/>
          <ac:cxnSpMkLst>
            <pc:docMk/>
            <pc:sldMk cId="2234882533" sldId="262"/>
            <ac:cxnSpMk id="145" creationId="{11A21192-C172-44CD-A244-D6D949399A1C}"/>
          </ac:cxnSpMkLst>
        </pc:cxnChg>
        <pc:cxnChg chg="add del mod">
          <ac:chgData name="吉武 和敏" userId="e4825ba96748af9c" providerId="LiveId" clId="{917B18EA-CFD2-4842-A770-C54A8DAF286E}" dt="2020-11-18T07:27:20.429" v="5"/>
          <ac:cxnSpMkLst>
            <pc:docMk/>
            <pc:sldMk cId="2234882533" sldId="262"/>
            <ac:cxnSpMk id="148" creationId="{D3CD3601-1095-4E69-8B09-3036821C07C5}"/>
          </ac:cxnSpMkLst>
        </pc:cxnChg>
      </pc:sldChg>
      <pc:sldChg chg="addSp delSp modSp new mod">
        <pc:chgData name="吉武 和敏" userId="e4825ba96748af9c" providerId="LiveId" clId="{917B18EA-CFD2-4842-A770-C54A8DAF286E}" dt="2020-11-30T07:55:04.224" v="1786" actId="1076"/>
        <pc:sldMkLst>
          <pc:docMk/>
          <pc:sldMk cId="2446118483" sldId="263"/>
        </pc:sldMkLst>
        <pc:spChg chg="add mod ord">
          <ac:chgData name="吉武 和敏" userId="e4825ba96748af9c" providerId="LiveId" clId="{917B18EA-CFD2-4842-A770-C54A8DAF286E}" dt="2020-11-30T05:55:39.136" v="952" actId="1076"/>
          <ac:spMkLst>
            <pc:docMk/>
            <pc:sldMk cId="2446118483" sldId="263"/>
            <ac:spMk id="2" creationId="{9BEF03B8-6E8D-4299-8A24-3BF389370517}"/>
          </ac:spMkLst>
        </pc:spChg>
        <pc:spChg chg="add del mod ord">
          <ac:chgData name="吉武 和敏" userId="e4825ba96748af9c" providerId="LiveId" clId="{917B18EA-CFD2-4842-A770-C54A8DAF286E}" dt="2020-11-30T05:54:57.078" v="944" actId="478"/>
          <ac:spMkLst>
            <pc:docMk/>
            <pc:sldMk cId="2446118483" sldId="263"/>
            <ac:spMk id="47" creationId="{EE56D4A4-1082-43A8-87E2-2E3133586751}"/>
          </ac:spMkLst>
        </pc:spChg>
        <pc:spChg chg="add mod ord">
          <ac:chgData name="吉武 和敏" userId="e4825ba96748af9c" providerId="LiveId" clId="{917B18EA-CFD2-4842-A770-C54A8DAF286E}" dt="2020-11-30T05:55:19.256" v="949" actId="1076"/>
          <ac:spMkLst>
            <pc:docMk/>
            <pc:sldMk cId="2446118483" sldId="263"/>
            <ac:spMk id="48" creationId="{8E0B23B2-6BBB-4B06-88D6-EC819802943F}"/>
          </ac:spMkLst>
        </pc:spChg>
        <pc:spChg chg="add del mod">
          <ac:chgData name="吉武 和敏" userId="e4825ba96748af9c" providerId="LiveId" clId="{917B18EA-CFD2-4842-A770-C54A8DAF286E}" dt="2020-11-30T05:44:44.135" v="430" actId="478"/>
          <ac:spMkLst>
            <pc:docMk/>
            <pc:sldMk cId="2446118483" sldId="263"/>
            <ac:spMk id="296" creationId="{CB04C805-B9B8-453C-974A-5084B51B6872}"/>
          </ac:spMkLst>
        </pc:spChg>
        <pc:spChg chg="add mod">
          <ac:chgData name="吉武 和敏" userId="e4825ba96748af9c" providerId="LiveId" clId="{917B18EA-CFD2-4842-A770-C54A8DAF286E}" dt="2020-11-30T07:55:04.224" v="1786" actId="1076"/>
          <ac:spMkLst>
            <pc:docMk/>
            <pc:sldMk cId="2446118483" sldId="263"/>
            <ac:spMk id="299" creationId="{185D7C35-276C-4F29-B5D3-6E60D665947A}"/>
          </ac:spMkLst>
        </pc:spChg>
        <pc:spChg chg="add mod">
          <ac:chgData name="吉武 和敏" userId="e4825ba96748af9c" providerId="LiveId" clId="{917B18EA-CFD2-4842-A770-C54A8DAF286E}" dt="2020-11-30T07:55:04.224" v="1786" actId="1076"/>
          <ac:spMkLst>
            <pc:docMk/>
            <pc:sldMk cId="2446118483" sldId="263"/>
            <ac:spMk id="300" creationId="{762AE8B9-B666-4105-89AC-11A6D21DDD9D}"/>
          </ac:spMkLst>
        </pc:spChg>
        <pc:spChg chg="add">
          <ac:chgData name="吉武 和敏" userId="e4825ba96748af9c" providerId="LiveId" clId="{917B18EA-CFD2-4842-A770-C54A8DAF286E}" dt="2020-11-30T06:30:10.287" v="1577" actId="22"/>
          <ac:spMkLst>
            <pc:docMk/>
            <pc:sldMk cId="2446118483" sldId="263"/>
            <ac:spMk id="302" creationId="{60C2DBD0-85CB-4B0B-A41C-0728A8C529C6}"/>
          </ac:spMkLst>
        </pc:spChg>
        <pc:grpChg chg="add del mod">
          <ac:chgData name="吉武 和敏" userId="e4825ba96748af9c" providerId="LiveId" clId="{917B18EA-CFD2-4842-A770-C54A8DAF286E}" dt="2020-11-30T05:36:04.634" v="153" actId="478"/>
          <ac:grpSpMkLst>
            <pc:docMk/>
            <pc:sldMk cId="2446118483" sldId="263"/>
            <ac:grpSpMk id="3" creationId="{EB20D60C-9989-4615-AE44-9B4D90F006CD}"/>
          </ac:grpSpMkLst>
        </pc:grpChg>
        <pc:grpChg chg="add mod">
          <ac:chgData name="吉武 和敏" userId="e4825ba96748af9c" providerId="LiveId" clId="{917B18EA-CFD2-4842-A770-C54A8DAF286E}" dt="2020-11-30T05:28:33.021" v="73" actId="571"/>
          <ac:grpSpMkLst>
            <pc:docMk/>
            <pc:sldMk cId="2446118483" sldId="263"/>
            <ac:grpSpMk id="50" creationId="{8213FA1D-CD6D-4738-9DB1-F7F75B8F31A4}"/>
          </ac:grpSpMkLst>
        </pc:grpChg>
        <pc:grpChg chg="add mod">
          <ac:chgData name="吉武 和敏" userId="e4825ba96748af9c" providerId="LiveId" clId="{917B18EA-CFD2-4842-A770-C54A8DAF286E}" dt="2020-11-30T05:28:32.429" v="72" actId="571"/>
          <ac:grpSpMkLst>
            <pc:docMk/>
            <pc:sldMk cId="2446118483" sldId="263"/>
            <ac:grpSpMk id="94" creationId="{548357A0-F8F4-4074-82AA-47334C996F4B}"/>
          </ac:grpSpMkLst>
        </pc:grpChg>
        <pc:grpChg chg="add mod">
          <ac:chgData name="吉武 和敏" userId="e4825ba96748af9c" providerId="LiveId" clId="{917B18EA-CFD2-4842-A770-C54A8DAF286E}" dt="2020-11-30T05:28:31.661" v="71" actId="571"/>
          <ac:grpSpMkLst>
            <pc:docMk/>
            <pc:sldMk cId="2446118483" sldId="263"/>
            <ac:grpSpMk id="138" creationId="{2B4A2BB3-E7D9-4244-9108-4C76DA4F676C}"/>
          </ac:grpSpMkLst>
        </pc:grpChg>
        <pc:grpChg chg="add mod">
          <ac:chgData name="吉武 和敏" userId="e4825ba96748af9c" providerId="LiveId" clId="{917B18EA-CFD2-4842-A770-C54A8DAF286E}" dt="2020-11-30T05:28:31.293" v="70" actId="571"/>
          <ac:grpSpMkLst>
            <pc:docMk/>
            <pc:sldMk cId="2446118483" sldId="263"/>
            <ac:grpSpMk id="182" creationId="{48FF6189-61A2-458A-A6C9-68140FF43336}"/>
          </ac:grpSpMkLst>
        </pc:grpChg>
        <pc:grpChg chg="add mod">
          <ac:chgData name="吉武 和敏" userId="e4825ba96748af9c" providerId="LiveId" clId="{917B18EA-CFD2-4842-A770-C54A8DAF286E}" dt="2020-11-30T05:28:30.988" v="69" actId="571"/>
          <ac:grpSpMkLst>
            <pc:docMk/>
            <pc:sldMk cId="2446118483" sldId="263"/>
            <ac:grpSpMk id="226" creationId="{1E5214A8-3565-4366-A1AD-90C181EE4BCB}"/>
          </ac:grpSpMkLst>
        </pc:grpChg>
        <pc:grpChg chg="add del mod">
          <ac:chgData name="吉武 和敏" userId="e4825ba96748af9c" providerId="LiveId" clId="{917B18EA-CFD2-4842-A770-C54A8DAF286E}" dt="2020-11-30T05:45:25.689" v="436" actId="165"/>
          <ac:grpSpMkLst>
            <pc:docMk/>
            <pc:sldMk cId="2446118483" sldId="263"/>
            <ac:grpSpMk id="297" creationId="{D14BAD8B-AD9A-404D-83FC-0696FEFC176F}"/>
          </ac:grpSpMkLst>
        </pc:grpChg>
        <pc:picChg chg="mod">
          <ac:chgData name="吉武 和敏" userId="e4825ba96748af9c" providerId="LiveId" clId="{917B18EA-CFD2-4842-A770-C54A8DAF286E}" dt="2020-11-18T07:27:26.467" v="7"/>
          <ac:picMkLst>
            <pc:docMk/>
            <pc:sldMk cId="2446118483" sldId="263"/>
            <ac:picMk id="4" creationId="{5EF0D2B7-5668-4E71-AC4C-263D88E2173D}"/>
          </ac:picMkLst>
        </pc:picChg>
        <pc:picChg chg="mod">
          <ac:chgData name="吉武 和敏" userId="e4825ba96748af9c" providerId="LiveId" clId="{917B18EA-CFD2-4842-A770-C54A8DAF286E}" dt="2020-11-18T07:27:26.467" v="7"/>
          <ac:picMkLst>
            <pc:docMk/>
            <pc:sldMk cId="2446118483" sldId="263"/>
            <ac:picMk id="5" creationId="{8D671796-C541-4D0F-8B22-EA47E84BD66B}"/>
          </ac:picMkLst>
        </pc:picChg>
        <pc:picChg chg="mod">
          <ac:chgData name="吉武 和敏" userId="e4825ba96748af9c" providerId="LiveId" clId="{917B18EA-CFD2-4842-A770-C54A8DAF286E}" dt="2020-11-30T05:28:33.021" v="73" actId="571"/>
          <ac:picMkLst>
            <pc:docMk/>
            <pc:sldMk cId="2446118483" sldId="263"/>
            <ac:picMk id="51" creationId="{D0C50CD5-BD10-4BBC-922D-43196F0E6912}"/>
          </ac:picMkLst>
        </pc:picChg>
        <pc:picChg chg="mod">
          <ac:chgData name="吉武 和敏" userId="e4825ba96748af9c" providerId="LiveId" clId="{917B18EA-CFD2-4842-A770-C54A8DAF286E}" dt="2020-11-30T05:28:33.021" v="73" actId="571"/>
          <ac:picMkLst>
            <pc:docMk/>
            <pc:sldMk cId="2446118483" sldId="263"/>
            <ac:picMk id="52" creationId="{2EDE60CE-EDC0-4000-B0A1-9A7DE5CCA720}"/>
          </ac:picMkLst>
        </pc:picChg>
        <pc:picChg chg="mod">
          <ac:chgData name="吉武 和敏" userId="e4825ba96748af9c" providerId="LiveId" clId="{917B18EA-CFD2-4842-A770-C54A8DAF286E}" dt="2020-11-30T05:28:32.429" v="72" actId="571"/>
          <ac:picMkLst>
            <pc:docMk/>
            <pc:sldMk cId="2446118483" sldId="263"/>
            <ac:picMk id="95" creationId="{09304942-FE68-4AC3-8688-766552522D8E}"/>
          </ac:picMkLst>
        </pc:picChg>
        <pc:picChg chg="mod">
          <ac:chgData name="吉武 和敏" userId="e4825ba96748af9c" providerId="LiveId" clId="{917B18EA-CFD2-4842-A770-C54A8DAF286E}" dt="2020-11-30T05:28:32.429" v="72" actId="571"/>
          <ac:picMkLst>
            <pc:docMk/>
            <pc:sldMk cId="2446118483" sldId="263"/>
            <ac:picMk id="96" creationId="{6CD3D940-5B58-4198-85AD-A50C679FDA98}"/>
          </ac:picMkLst>
        </pc:picChg>
        <pc:picChg chg="mod">
          <ac:chgData name="吉武 和敏" userId="e4825ba96748af9c" providerId="LiveId" clId="{917B18EA-CFD2-4842-A770-C54A8DAF286E}" dt="2020-11-30T05:28:31.661" v="71" actId="571"/>
          <ac:picMkLst>
            <pc:docMk/>
            <pc:sldMk cId="2446118483" sldId="263"/>
            <ac:picMk id="139" creationId="{C57B9F2B-17C6-41DC-9D9B-390BA6E34685}"/>
          </ac:picMkLst>
        </pc:picChg>
        <pc:picChg chg="mod">
          <ac:chgData name="吉武 和敏" userId="e4825ba96748af9c" providerId="LiveId" clId="{917B18EA-CFD2-4842-A770-C54A8DAF286E}" dt="2020-11-30T05:28:31.661" v="71" actId="571"/>
          <ac:picMkLst>
            <pc:docMk/>
            <pc:sldMk cId="2446118483" sldId="263"/>
            <ac:picMk id="140" creationId="{FA107FFD-0D84-4A7F-A449-18E8DF8225AE}"/>
          </ac:picMkLst>
        </pc:picChg>
        <pc:picChg chg="mod">
          <ac:chgData name="吉武 和敏" userId="e4825ba96748af9c" providerId="LiveId" clId="{917B18EA-CFD2-4842-A770-C54A8DAF286E}" dt="2020-11-30T05:28:31.293" v="70" actId="571"/>
          <ac:picMkLst>
            <pc:docMk/>
            <pc:sldMk cId="2446118483" sldId="263"/>
            <ac:picMk id="183" creationId="{A3E56B91-4A79-4438-85B5-F04F779E7334}"/>
          </ac:picMkLst>
        </pc:picChg>
        <pc:picChg chg="mod">
          <ac:chgData name="吉武 和敏" userId="e4825ba96748af9c" providerId="LiveId" clId="{917B18EA-CFD2-4842-A770-C54A8DAF286E}" dt="2020-11-30T05:28:31.293" v="70" actId="571"/>
          <ac:picMkLst>
            <pc:docMk/>
            <pc:sldMk cId="2446118483" sldId="263"/>
            <ac:picMk id="184" creationId="{38C2ADC5-F979-41E0-9EF3-278786E253D5}"/>
          </ac:picMkLst>
        </pc:picChg>
        <pc:picChg chg="mod">
          <ac:chgData name="吉武 和敏" userId="e4825ba96748af9c" providerId="LiveId" clId="{917B18EA-CFD2-4842-A770-C54A8DAF286E}" dt="2020-11-30T05:28:30.988" v="69" actId="571"/>
          <ac:picMkLst>
            <pc:docMk/>
            <pc:sldMk cId="2446118483" sldId="263"/>
            <ac:picMk id="227" creationId="{DEA60334-FAA4-42C9-9EA5-AC323450B9D0}"/>
          </ac:picMkLst>
        </pc:picChg>
        <pc:picChg chg="mod">
          <ac:chgData name="吉武 和敏" userId="e4825ba96748af9c" providerId="LiveId" clId="{917B18EA-CFD2-4842-A770-C54A8DAF286E}" dt="2020-11-30T05:28:30.988" v="69" actId="571"/>
          <ac:picMkLst>
            <pc:docMk/>
            <pc:sldMk cId="2446118483" sldId="263"/>
            <ac:picMk id="228" creationId="{F7809EB0-DB4E-41E7-8F4B-0714A28043B1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71" creationId="{C6C912A1-5969-4956-B8F9-B2A7B9824708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73" creationId="{11E1F3EE-3DDE-4ACE-A824-24860CA95A5A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75" creationId="{EA35B741-28CF-487C-9941-781A96C4661C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77" creationId="{488CBC16-6927-4EA8-BCF8-0FE3BB2A019E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79" creationId="{550E3F33-AAA7-4284-B4B7-5C44982FC33E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81" creationId="{67B3B1EB-6FFC-40D4-9B70-BBB0E75D0CD0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83" creationId="{61A0495E-BC27-468B-A23C-703C882599E2}"/>
          </ac:picMkLst>
        </pc:picChg>
        <pc:picChg chg="add del mod">
          <ac:chgData name="吉武 和敏" userId="e4825ba96748af9c" providerId="LiveId" clId="{917B18EA-CFD2-4842-A770-C54A8DAF286E}" dt="2020-11-30T05:35:35.404" v="147" actId="478"/>
          <ac:picMkLst>
            <pc:docMk/>
            <pc:sldMk cId="2446118483" sldId="263"/>
            <ac:picMk id="284" creationId="{0F5B3987-6412-4235-B609-3247E5057D04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85" creationId="{DFC544B7-85F7-4E1E-AB39-01ED7B3C2FFD}"/>
          </ac:picMkLst>
        </pc:picChg>
        <pc:picChg chg="add mod topLvl modCrop">
          <ac:chgData name="吉武 和敏" userId="e4825ba96748af9c" providerId="LiveId" clId="{917B18EA-CFD2-4842-A770-C54A8DAF286E}" dt="2020-11-30T05:55:19.256" v="949" actId="1076"/>
          <ac:picMkLst>
            <pc:docMk/>
            <pc:sldMk cId="2446118483" sldId="263"/>
            <ac:picMk id="286" creationId="{73114AF9-198A-4362-AC23-40FD35AE168E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87" creationId="{0FDC7902-E8EB-4BC4-B918-F872FD2CBEC0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88" creationId="{E105CF90-D92F-4DD0-AEE4-A9FC25D35665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89" creationId="{EBDBD3D7-B5AB-4551-A50F-76B98BC19B1C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90" creationId="{3E0E5850-C33F-4816-94E8-374AB34CFBE8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91" creationId="{FD3A107A-987F-43C1-A81B-6A715FB3E352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92" creationId="{4EEF0505-66B6-403D-8C4B-43527D2A419B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93" creationId="{A4B96D12-96C5-4BDD-B29E-6622AF631199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94" creationId="{36F6A5F1-05BD-4261-A68F-36513582688B}"/>
          </ac:picMkLst>
        </pc:picChg>
        <pc:picChg chg="add mod topLvl modCrop">
          <ac:chgData name="吉武 和敏" userId="e4825ba96748af9c" providerId="LiveId" clId="{917B18EA-CFD2-4842-A770-C54A8DAF286E}" dt="2020-11-30T05:55:28.453" v="950" actId="1076"/>
          <ac:picMkLst>
            <pc:docMk/>
            <pc:sldMk cId="2446118483" sldId="263"/>
            <ac:picMk id="295" creationId="{8B0B9D83-B3E8-4111-870B-01E23E38657F}"/>
          </ac:picMkLst>
        </pc:picChg>
        <pc:picChg chg="add mod">
          <ac:chgData name="吉武 和敏" userId="e4825ba96748af9c" providerId="LiveId" clId="{917B18EA-CFD2-4842-A770-C54A8DAF286E}" dt="2020-11-30T05:48:08.473" v="467" actId="571"/>
          <ac:picMkLst>
            <pc:docMk/>
            <pc:sldMk cId="2446118483" sldId="263"/>
            <ac:picMk id="298" creationId="{3104BFB9-C6A0-4846-884E-5F14D6F2D053}"/>
          </ac:picMkLst>
        </pc:pic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6" creationId="{F636A310-E936-4ECD-8A73-1FE1B0C5D5D0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7" creationId="{65EC0DCC-4FA5-441A-B16E-0A83FA61F273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8" creationId="{A28DEEDE-D5FC-4169-87A3-E212E541EB4E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9" creationId="{F57360CE-2EEF-4C1E-8552-35EB575A4CA2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0" creationId="{451E654D-4202-40B8-B48E-67A0F34A6FF6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1" creationId="{7F0C2D0E-36D3-4CDF-80C6-69D00C7983F2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2" creationId="{9D6873DD-7F25-44B8-A562-A1F9F41DDEB4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3" creationId="{7E93B0F1-FFDD-4A5C-9E7A-02D3D5D58EE3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4" creationId="{C33E3C19-8544-4548-8E83-8081D3C91377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5" creationId="{F83DDD60-6F63-4AE7-A61C-6922C972C5C5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6" creationId="{7ABF2D31-35D1-4B46-8D5F-10536D21A667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7" creationId="{7D17B65A-AA5E-4F19-95E5-B08F93987B3D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8" creationId="{9CDE9B93-66C9-4B34-8716-48D8F998F4AC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19" creationId="{2F64A670-EAB0-4C26-908B-83382737297F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0" creationId="{B0499077-97DB-4F39-A8C2-7133D49BF55B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1" creationId="{75AF2FEF-BC55-4E60-92BA-1DB38E598427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2" creationId="{A9EC19C4-2AEE-499A-AF9C-4353B27EE153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3" creationId="{EA452C54-0A0B-42A9-8BAC-FBFFF2AD4A70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4" creationId="{C569411E-5E9A-4A0E-9022-9834DF9006FB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5" creationId="{7351AC70-2F72-4260-B7D1-BA24A1E812AA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6" creationId="{72755695-2F88-419E-B149-92CF8C68FE9E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7" creationId="{96DFA2BE-3AC4-46C5-A89D-827FB71C77A8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8" creationId="{0420704D-FAAB-4B58-B49B-0A2D2EB30377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29" creationId="{1DB9D6A6-FA5E-4037-8065-811D4ED495BD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0" creationId="{6FCCCE22-65E2-4945-A306-18EB2EA2D96C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1" creationId="{82CD8575-7560-429A-9139-8F7BF4E699AE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2" creationId="{3D829345-092C-4CDD-A821-34D6640F6E73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3" creationId="{15D0B1DE-D38E-4EA3-9E4B-181D8AF2DDC6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4" creationId="{756C3244-FD55-4044-A549-5DD9CE5DD0BD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5" creationId="{7CF912BA-E873-425E-A29A-35C31014008F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6" creationId="{CD467836-077F-4387-962F-08C4E524B0E4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7" creationId="{6E851D5D-DD2D-447A-9955-5530BDD4A432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8" creationId="{0755B6B9-7F56-4A82-8F76-254937AD96D8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39" creationId="{5E00C5C1-BB88-4F65-B54D-5EE62A6BCA69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40" creationId="{545178D9-A397-48B3-9329-ADFFD9D8DDC8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41" creationId="{3497A5D1-AD02-422E-9E73-99C260431304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42" creationId="{1F7855E2-F0D4-450C-8D6C-1A0A50225BC0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43" creationId="{D01F34AC-836C-482D-806B-ABFEB54C07C2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44" creationId="{3EA9C921-B63C-45A2-8BC2-872D7C8BB142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45" creationId="{D225CB5A-4476-454F-9C17-86FC0091B457}"/>
          </ac:cxnSpMkLst>
        </pc:cxnChg>
        <pc:cxnChg chg="mod">
          <ac:chgData name="吉武 和敏" userId="e4825ba96748af9c" providerId="LiveId" clId="{917B18EA-CFD2-4842-A770-C54A8DAF286E}" dt="2020-11-18T07:27:26.467" v="7"/>
          <ac:cxnSpMkLst>
            <pc:docMk/>
            <pc:sldMk cId="2446118483" sldId="263"/>
            <ac:cxnSpMk id="46" creationId="{A7591D1B-5ABC-437D-9D06-BA8E71271A85}"/>
          </ac:cxnSpMkLst>
        </pc:cxnChg>
        <pc:cxnChg chg="add mod ord topLvl">
          <ac:chgData name="吉武 和敏" userId="e4825ba96748af9c" providerId="LiveId" clId="{917B18EA-CFD2-4842-A770-C54A8DAF286E}" dt="2020-11-30T05:55:19.256" v="949" actId="1076"/>
          <ac:cxnSpMkLst>
            <pc:docMk/>
            <pc:sldMk cId="2446118483" sldId="263"/>
            <ac:cxnSpMk id="49" creationId="{A05E925F-A2F1-4684-BEAB-58879AD95EE8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53" creationId="{13ED528F-10DC-44CC-B791-B9BD5C5C1131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54" creationId="{9ED08570-4036-4FCA-8EE5-BA1EB2393C91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55" creationId="{251EC8E9-548B-468D-8AC6-A409BC44C380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56" creationId="{075A21ED-CB53-4174-9365-6266E5B9946E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57" creationId="{8DD58D58-3848-48DC-B8EC-D72AF4EC7E25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58" creationId="{FBF334E9-743D-4F23-9501-C7BC38C6ECF7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59" creationId="{134A2939-9FD1-4DD9-8B1B-82BD7423930B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0" creationId="{0290DA00-B010-4D6D-9D2E-C07AEDE8732A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1" creationId="{C7807024-F69F-4D6B-8931-3F493D3527A3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2" creationId="{271384F6-4A7D-442C-8ED3-186638E37F38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3" creationId="{4C94AE27-DA5E-4D9B-A3D6-D26F9D8CCC90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4" creationId="{7D79A147-961D-4532-8570-D1FB586D7123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5" creationId="{634BE326-9A46-4733-9448-D3D1DBAD770A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6" creationId="{4C97F58A-1516-4461-994F-09E1CCCC9EB1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7" creationId="{8FA6E1D0-9365-49D3-BFDB-2B3BD03D21E2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8" creationId="{76B5CD0E-BEF8-469E-B163-140667BA6A66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69" creationId="{6D958E03-BF01-43AF-A8C6-D053F66F9D62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0" creationId="{D1CD8060-3AC6-42A5-BC4C-7C4213BAF1EF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1" creationId="{1E2720BD-473D-487A-8349-69DD6AC279D2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2" creationId="{94B90AB1-80EC-4310-A876-DA9E29A01BBF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3" creationId="{03A6263A-191E-44D4-B8E3-1AD4A386655C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4" creationId="{EAEA0BA4-F10F-429E-A41A-DD3708CE4EDA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5" creationId="{78F55DF7-A6C6-4D91-977E-1B53ED551DA7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6" creationId="{467EE19C-AF4E-4782-B770-AC11FDD12572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7" creationId="{6C3A4860-8A7E-4D4B-8C73-41F91F6127BA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8" creationId="{F261D575-3070-4A60-A7D1-AC5A82384F65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79" creationId="{5B9240DD-0626-4D86-B9E6-109E593350A6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0" creationId="{952663BF-9678-4B1E-9216-43750E43CAB7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1" creationId="{CFA8B4C6-B2C9-4687-A495-B8E802A8268B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2" creationId="{64B68B4A-5287-44F8-81D2-E8D1A7C3C860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3" creationId="{16CFFA1C-8FBF-4DA7-B598-75773C8987E8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4" creationId="{B3550494-A181-4CF1-B9A6-1A3C8AF2368D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5" creationId="{435F3F16-63FF-476D-9967-D2C65915B8C6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6" creationId="{30EFBEF3-8881-41B5-9D0E-01D512B0AB92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7" creationId="{9CBD4CAA-66B0-4A57-8573-222C857C029E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8" creationId="{A351DBD1-FF65-4B5A-A519-92C14DCC4B93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89" creationId="{B98AF5B1-4EF5-4CED-A7EC-05642AE2CBB4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90" creationId="{8070B1AE-64AC-452E-9309-6863E256D95E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91" creationId="{B1316D64-B711-4E79-9AF6-29B5761DA0DC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92" creationId="{FCBB67AD-DD9D-4D0F-8C40-B88E479E3D95}"/>
          </ac:cxnSpMkLst>
        </pc:cxnChg>
        <pc:cxnChg chg="mod">
          <ac:chgData name="吉武 和敏" userId="e4825ba96748af9c" providerId="LiveId" clId="{917B18EA-CFD2-4842-A770-C54A8DAF286E}" dt="2020-11-30T05:28:33.021" v="73" actId="571"/>
          <ac:cxnSpMkLst>
            <pc:docMk/>
            <pc:sldMk cId="2446118483" sldId="263"/>
            <ac:cxnSpMk id="93" creationId="{E7225D99-3B13-4B31-BDA5-A1A202AEAEAE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97" creationId="{68D1024F-478C-4BA9-82AF-F173D0C07017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98" creationId="{2F93FC5C-33F5-4C38-A37F-233188D8B186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99" creationId="{4EA7B7AD-18C3-4A1B-A30E-D3D603E5CF6F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0" creationId="{97133E71-1561-4322-B5B8-F427079E68F2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1" creationId="{35CF4AF2-CDA3-4BD8-8A32-C4463BECE844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2" creationId="{68707630-0148-4E32-A327-DBA0DECA7CC1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3" creationId="{41E4564B-B6F8-4B21-B258-5D2C64600C92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4" creationId="{EB11BC94-DB56-4DBE-81D3-9BCE203952C6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5" creationId="{86AA8B08-5850-4C10-B0F8-303AA5442921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6" creationId="{B477CA8B-5E36-4728-8A1C-8BED0B1CE62C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7" creationId="{04366BAB-DE9A-4256-A597-B0DC83966A8F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8" creationId="{3DEBCC37-953D-4AE1-B567-AD2E2E795DD2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09" creationId="{FB57C8AC-128B-4E92-AC96-CA338AD96DFB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0" creationId="{29FD4B62-93A4-42A8-82CB-A7B0715BC0E3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1" creationId="{4E3D3568-0546-4F30-91BE-6C18F9A6C3F7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2" creationId="{E3053F6A-949F-4E10-81E1-97FDBE0570BD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3" creationId="{FD974035-C190-450D-8AFC-56A92E0D573B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4" creationId="{E132B7E3-0D25-4D8D-9093-A2FA24F6B294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5" creationId="{113F4BA0-C7F4-4586-9965-80F8200A2174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6" creationId="{223D706A-7D76-43C1-8FDF-AC6391901BE5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7" creationId="{3DE7955B-DA8A-4CB0-B17E-D3B53EAAAE69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8" creationId="{39958DF8-66C8-40C5-AA78-4BD1C19E7CB3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19" creationId="{7013F061-FF2A-4D8C-B741-3AC52622E8FD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0" creationId="{F2DCB02D-1C45-42BD-88A8-243C4C6D26FD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1" creationId="{FD1068D1-4DE9-4A38-906E-4A1EFE098138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2" creationId="{5C42FFDA-DF0A-49D2-824C-8F3632FC60B3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3" creationId="{9D5C3D6A-333E-43F8-A057-545C7A0FB3A3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4" creationId="{3B97E736-8505-4710-B3DC-DAA6AAB30AFB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5" creationId="{33403A87-B6A3-4788-A551-EDA974C8072B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6" creationId="{812101D9-A190-4EF0-B3C5-89333E47C0CD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7" creationId="{97B06EC4-630D-406D-AA03-7D4E39771D49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8" creationId="{D4E374F7-F54D-4685-937C-991E6BC5D3BA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29" creationId="{45F54802-CFB0-4AB0-B0EC-7FBDD04BC46A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30" creationId="{4661DFC3-DD81-47D4-BE5D-A63D20CBBD20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31" creationId="{C1332126-B3D6-493D-895D-31493B500675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32" creationId="{9BBAAABC-D16B-4789-8720-EA110A153B64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33" creationId="{2043865E-BD99-4D43-8F31-0EF1770160F3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34" creationId="{304A7956-53F9-4CFC-B151-93CFB9138F15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35" creationId="{96194851-1358-4C90-9840-EF6F9EEB55B9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36" creationId="{719DC9BC-F13D-44A1-A19B-E6FC208C7087}"/>
          </ac:cxnSpMkLst>
        </pc:cxnChg>
        <pc:cxnChg chg="mod">
          <ac:chgData name="吉武 和敏" userId="e4825ba96748af9c" providerId="LiveId" clId="{917B18EA-CFD2-4842-A770-C54A8DAF286E}" dt="2020-11-30T05:28:32.429" v="72" actId="571"/>
          <ac:cxnSpMkLst>
            <pc:docMk/>
            <pc:sldMk cId="2446118483" sldId="263"/>
            <ac:cxnSpMk id="137" creationId="{9B146C47-5CC6-483F-A4D5-2D3571F27FFC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1" creationId="{DC80DF63-01F4-4BE9-8644-13A4FF938A7C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2" creationId="{BBCD90E9-BF7C-4D5C-9F33-18C86C28CC9A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3" creationId="{E24DBC10-DE21-4EEB-99FB-70D92511D9AA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4" creationId="{E981AD35-A8C1-4C2E-8FD5-0262579135F4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5" creationId="{8DB0B140-63C2-4376-9922-E09ED4129809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6" creationId="{33E16DB3-D162-4C39-9323-CFFD7C6D5D60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7" creationId="{D51E09B8-736C-4647-9386-A693B83E336E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8" creationId="{FA1FE252-DB12-44DC-A5C7-8744D1354EEA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49" creationId="{C127428D-FB18-40AE-9B3F-74A43F295671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0" creationId="{FEB908FB-B91A-44A9-94F8-FECEB91F82C4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1" creationId="{1C32EE44-5692-402A-B9FE-ADC75AC4B361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2" creationId="{C115CFAE-1A27-448C-9E81-6C8AAE1F6C90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3" creationId="{FDF4D306-BB02-498C-8597-26BEAC946E79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4" creationId="{9BF16F6B-03AE-47BA-994B-9EB1CEE15D10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5" creationId="{274C775D-9BBD-429C-9B05-E2C4690570AE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6" creationId="{CA1ADB83-4B0C-47B9-A8E6-A81B36661C77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7" creationId="{A2926E80-9C47-4DCD-AAF5-E5A9B044C4EF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8" creationId="{56E49205-FB9D-485B-BE36-72238EE1D1A6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59" creationId="{4FB4384B-ABD6-4CC0-8D65-53D33A61153F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0" creationId="{9F0E1318-6D8A-4108-95A1-D6455411F0F3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1" creationId="{BD981E1D-A922-4C82-B065-C9ED1D22EE53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2" creationId="{5310CE17-456D-473B-A168-B08968F0CD4A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3" creationId="{6F97A609-C4AE-4BA9-BD6D-F07FC8B9A476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4" creationId="{E9ED3429-795C-4D5C-B7BD-1B54FED5556C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5" creationId="{1259B9E2-A6E3-4C6C-B362-57817F623B50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6" creationId="{9F46E7F8-9598-4BD5-98F1-54ACCF7711BA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7" creationId="{1B3866FD-0FE9-4167-8734-6842B1205E85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8" creationId="{517A43E6-0679-45B8-861B-93DCCB06285D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69" creationId="{2607F5E7-6F4A-43DD-98A4-C52F26630096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0" creationId="{18C4F740-5F2A-43ED-AA94-E27AA1609121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1" creationId="{87F180F2-6376-405E-BE54-3EB0DB954CE9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2" creationId="{097813AE-CFE3-4AE9-B162-5A4FE2E507E9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3" creationId="{EE1D8B40-EFD1-44EE-A0D8-4766BA1D4C47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4" creationId="{0038DA1B-C79A-4C23-AFE7-48A823F364F2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5" creationId="{A3C6986F-49BC-4044-9FB8-B6D850422255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6" creationId="{11E42E0F-6E75-4B22-94A9-3CB229ED9B0A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7" creationId="{A85D0AC4-F396-4841-AE93-01AC54411C17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8" creationId="{9E4A0EA0-39A1-47B3-B63D-3473C05E91F8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79" creationId="{9B71775A-3646-4937-A51A-46386C42674C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80" creationId="{0A738D5A-7582-4331-B49C-7DA111C979D8}"/>
          </ac:cxnSpMkLst>
        </pc:cxnChg>
        <pc:cxnChg chg="mod">
          <ac:chgData name="吉武 和敏" userId="e4825ba96748af9c" providerId="LiveId" clId="{917B18EA-CFD2-4842-A770-C54A8DAF286E}" dt="2020-11-30T05:28:31.661" v="71" actId="571"/>
          <ac:cxnSpMkLst>
            <pc:docMk/>
            <pc:sldMk cId="2446118483" sldId="263"/>
            <ac:cxnSpMk id="181" creationId="{1BAEB7A7-AA84-41DA-8483-9E2FFBBB6D2C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85" creationId="{DCBC8CA6-068B-450F-A8B7-863C7A709F45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86" creationId="{C0789479-77DC-4B5A-834F-E4DA762F8D8B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87" creationId="{7499786C-9E3C-480C-BA98-A5C750A5D984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88" creationId="{307657AC-C703-45B9-92FB-09CDC0D02F42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89" creationId="{4D7564D5-61B9-4571-9A93-6E526A1011E7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0" creationId="{219C1635-69D0-4DB6-8E6D-ED8B307C24B6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1" creationId="{FA37C399-4F04-444F-9FC0-1F6C5041CF61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2" creationId="{77671D05-04EE-46FB-980B-DE3CD1928E6E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3" creationId="{3E3C1E39-F168-4DC5-A5F6-003D257A8D1E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4" creationId="{512CA5C1-A0D7-4447-B15E-67B0539E8169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5" creationId="{7779C734-3353-4C35-A14C-4A8F02B436F8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6" creationId="{B82EBB41-3942-40AD-98D1-9C97872D57CA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7" creationId="{CD389290-B366-4410-A218-86F3C4873A5E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8" creationId="{56C556F2-341D-4B52-AC78-D51D4E7CAC69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199" creationId="{728AE522-F59C-40D9-86FE-60013D728E7E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0" creationId="{5233E32D-F324-4CA7-BDD9-EBA05381DECC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1" creationId="{1C6968F6-99A6-4E77-BEA6-251E9A52AAEA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2" creationId="{D5D2319D-458B-49C0-9C4A-C824308F8C3D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3" creationId="{B771556B-7D3E-4D5A-B79B-A9B7BE6ED4E4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4" creationId="{5E018926-5AB6-4598-B741-06E444983DD6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5" creationId="{EF6125CA-4766-4B59-BEDC-91AABD99EB5C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6" creationId="{BE4E504C-9816-41DD-8A5A-029045CC94E8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7" creationId="{0C24C142-90A8-4C49-BFDE-3380F6AA9C77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8" creationId="{337D7B07-06DE-47D4-A101-59FFC689AB56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09" creationId="{E33E8EFE-1DD0-4475-9AB1-8685856740ED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0" creationId="{A0A23D68-CE87-4A53-B1D9-5C51403D2294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1" creationId="{33F15931-28A8-4409-B1AE-ED0AB9A96C72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2" creationId="{BF6CE429-725E-4416-8252-89A5B11EED8B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3" creationId="{8803E7D6-26E8-4ADF-A9E6-A7202F484724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4" creationId="{EB88DE47-9C5F-422B-AFB3-0C1F16FAC6D9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5" creationId="{6436DA86-115F-42B2-B502-1C1FDB578666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6" creationId="{8B54AF48-9BD2-4BEF-83F6-ABA437D9266B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7" creationId="{95096011-CFD7-4A52-8DB5-394A25B90219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8" creationId="{CB51B0B7-4FF8-4CB3-8F8A-EA7C13443149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19" creationId="{C53DD708-7A7B-4768-AD8D-A1F3AEDAFBEF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20" creationId="{DD0676D8-DCED-4A13-911A-E982A73D810E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21" creationId="{3615686F-B76E-4863-8117-915E4496BE3D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22" creationId="{C9E35980-F019-4183-BFED-D685FC9755A2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23" creationId="{155AC639-CD10-4A78-ACD1-64A531944F48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24" creationId="{23D6714F-04D2-4F03-8BFC-3F5D9C874E9C}"/>
          </ac:cxnSpMkLst>
        </pc:cxnChg>
        <pc:cxnChg chg="mod">
          <ac:chgData name="吉武 和敏" userId="e4825ba96748af9c" providerId="LiveId" clId="{917B18EA-CFD2-4842-A770-C54A8DAF286E}" dt="2020-11-30T05:28:31.293" v="70" actId="571"/>
          <ac:cxnSpMkLst>
            <pc:docMk/>
            <pc:sldMk cId="2446118483" sldId="263"/>
            <ac:cxnSpMk id="225" creationId="{5E775F69-5438-487F-87D8-67BC8EC353B2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29" creationId="{DB0B2FF7-BF68-4436-8E89-4CB0E39D6EBE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0" creationId="{804D1585-0637-4E88-961B-0C7B75F0CEB0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1" creationId="{4879F174-EB63-4C48-A701-5D9C60FAD406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2" creationId="{11832B86-7656-404B-9F2A-8CA8D1C7171A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3" creationId="{9F5093FB-EC56-41C5-BCCC-D5B1B62A167C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4" creationId="{25199D86-9C2A-41EE-A0B7-6A2853F7C498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5" creationId="{84A1240D-CCE4-4671-860B-17C70E562497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6" creationId="{BC01551A-CFD2-41D0-A30E-585087F8CEB5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7" creationId="{15D329D3-5B7B-4CAF-919D-7AE8C71C8109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8" creationId="{AB20C5EE-1053-41B2-A632-738C30C18412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39" creationId="{8C74C654-D0DE-44FA-80CE-B7CD9D7A67F6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0" creationId="{EA3B4593-5D43-4D66-B137-FAF28DF4EC5E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1" creationId="{CE0134DC-01F8-4947-8E67-FBC041F376D8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2" creationId="{26F88C3D-FCF1-4C03-955F-E43F25C186F7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3" creationId="{5442A816-6C9C-4630-BD46-6EDEF118F384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4" creationId="{B1CC0CD9-CC92-47F5-BA01-D6AD3FC9340C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5" creationId="{F190D21B-7829-4C4C-B49F-D50ECD46413E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6" creationId="{7C919596-C9A6-4847-BE3C-EF14ABF75DE5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7" creationId="{21668094-12E0-4C11-9EE6-A4879E6DF28A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8" creationId="{17F562F2-37F7-472E-A077-C08369790F84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49" creationId="{1069D090-221C-4A14-8693-C031F8BE8C2E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0" creationId="{9FE73FAF-362A-43F9-8D03-4353A1E880C7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1" creationId="{AE63ED23-9155-4F31-A7A0-231CF112AF61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2" creationId="{F8924F46-D654-4EC4-A79F-AA414C675ED3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3" creationId="{AA4AFF05-A513-4510-B121-66F0FF375FE1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4" creationId="{61CB4473-7FBE-48E9-A478-B69948785376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5" creationId="{240E95D2-1260-489E-84FA-3C44F4FDBB4E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6" creationId="{825D7C9A-E925-4EFA-ADB8-209EFAAABD99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7" creationId="{46A3C9EE-0D73-4848-9FD0-010A3C6D73E7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8" creationId="{B4E135DF-5DA3-4939-9482-AD7CEDDE4650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59" creationId="{7E9B25BF-7401-429D-AD79-1274AA5F392E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0" creationId="{3DDB9978-1F33-4AD6-A563-3B43C1B5220E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1" creationId="{BF9ECAB5-6FD0-4BA6-951B-C2BCB9AD1C7C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2" creationId="{E945DB03-DCB9-459F-B6FB-8952C62642CD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3" creationId="{8B2C21C3-0F87-4B10-8701-90574CDFA10A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4" creationId="{D1CC50EA-23E1-424C-9465-8BF4C9961166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5" creationId="{0CB3AE52-36DA-4E2D-A3FD-71C5A2695D81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6" creationId="{C679951C-EC03-4179-8505-96B7CFDD1043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7" creationId="{1FE5FD4A-09DD-4DD4-B425-E2C04363A51E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8" creationId="{F8B7485F-C1EC-4A29-8385-1CF933E2BC7A}"/>
          </ac:cxnSpMkLst>
        </pc:cxnChg>
        <pc:cxnChg chg="mod">
          <ac:chgData name="吉武 和敏" userId="e4825ba96748af9c" providerId="LiveId" clId="{917B18EA-CFD2-4842-A770-C54A8DAF286E}" dt="2020-11-30T05:28:30.988" v="69" actId="571"/>
          <ac:cxnSpMkLst>
            <pc:docMk/>
            <pc:sldMk cId="2446118483" sldId="263"/>
            <ac:cxnSpMk id="269" creationId="{3066B6EE-0E9B-4E43-9A27-6939D0CAAC9A}"/>
          </ac:cxnSpMkLst>
        </pc:cxnChg>
      </pc:sldChg>
      <pc:sldChg chg="addSp delSp new mod">
        <pc:chgData name="吉武 和敏" userId="e4825ba96748af9c" providerId="LiveId" clId="{917B18EA-CFD2-4842-A770-C54A8DAF286E}" dt="2020-11-18T07:30:05.966" v="16" actId="22"/>
        <pc:sldMkLst>
          <pc:docMk/>
          <pc:sldMk cId="3224033489" sldId="264"/>
        </pc:sldMkLst>
        <pc:picChg chg="add del">
          <ac:chgData name="吉武 和敏" userId="e4825ba96748af9c" providerId="LiveId" clId="{917B18EA-CFD2-4842-A770-C54A8DAF286E}" dt="2020-11-18T07:30:01.337" v="14" actId="22"/>
          <ac:picMkLst>
            <pc:docMk/>
            <pc:sldMk cId="3224033489" sldId="264"/>
            <ac:picMk id="3" creationId="{50E62D86-2C37-43BE-A532-8B652B7F4733}"/>
          </ac:picMkLst>
        </pc:picChg>
        <pc:picChg chg="add del">
          <ac:chgData name="吉武 和敏" userId="e4825ba96748af9c" providerId="LiveId" clId="{917B18EA-CFD2-4842-A770-C54A8DAF286E}" dt="2020-11-18T07:30:05.966" v="16" actId="22"/>
          <ac:picMkLst>
            <pc:docMk/>
            <pc:sldMk cId="3224033489" sldId="264"/>
            <ac:picMk id="5" creationId="{D87ECABC-CC2B-41DF-B6D5-860AD836D12D}"/>
          </ac:picMkLst>
        </pc:picChg>
      </pc:sldChg>
      <pc:sldChg chg="add">
        <pc:chgData name="吉武 和敏" userId="e4825ba96748af9c" providerId="LiveId" clId="{917B18EA-CFD2-4842-A770-C54A8DAF286E}" dt="2020-11-18T07:29:54.342" v="10"/>
        <pc:sldMkLst>
          <pc:docMk/>
          <pc:sldMk cId="3416928354" sldId="265"/>
        </pc:sldMkLst>
      </pc:sldChg>
      <pc:sldChg chg="add">
        <pc:chgData name="吉武 和敏" userId="e4825ba96748af9c" providerId="LiveId" clId="{917B18EA-CFD2-4842-A770-C54A8DAF286E}" dt="2020-11-18T07:29:54.515" v="11"/>
        <pc:sldMkLst>
          <pc:docMk/>
          <pc:sldMk cId="2939933543" sldId="266"/>
        </pc:sldMkLst>
      </pc:sldChg>
      <pc:sldChg chg="add">
        <pc:chgData name="吉武 和敏" userId="e4825ba96748af9c" providerId="LiveId" clId="{917B18EA-CFD2-4842-A770-C54A8DAF286E}" dt="2020-11-18T07:29:54.658" v="12"/>
        <pc:sldMkLst>
          <pc:docMk/>
          <pc:sldMk cId="1133899879" sldId="267"/>
        </pc:sldMkLst>
      </pc:sldChg>
      <pc:sldChg chg="addSp delSp modSp add mod ord">
        <pc:chgData name="吉武 和敏" userId="e4825ba96748af9c" providerId="LiveId" clId="{917B18EA-CFD2-4842-A770-C54A8DAF286E}" dt="2020-11-30T07:41:26.817" v="1645" actId="20577"/>
        <pc:sldMkLst>
          <pc:docMk/>
          <pc:sldMk cId="1537217434" sldId="268"/>
        </pc:sldMkLst>
        <pc:spChg chg="add mod">
          <ac:chgData name="吉武 和敏" userId="e4825ba96748af9c" providerId="LiveId" clId="{917B18EA-CFD2-4842-A770-C54A8DAF286E}" dt="2020-11-30T07:34:02.634" v="1592" actId="1076"/>
          <ac:spMkLst>
            <pc:docMk/>
            <pc:sldMk cId="1537217434" sldId="268"/>
            <ac:spMk id="6" creationId="{04D12FBF-3231-4338-9052-1CED4ED424EF}"/>
          </ac:spMkLst>
        </pc:spChg>
        <pc:spChg chg="del">
          <ac:chgData name="吉武 和敏" userId="e4825ba96748af9c" providerId="LiveId" clId="{917B18EA-CFD2-4842-A770-C54A8DAF286E}" dt="2020-11-30T05:57:38.661" v="954" actId="478"/>
          <ac:spMkLst>
            <pc:docMk/>
            <pc:sldMk cId="1537217434" sldId="268"/>
            <ac:spMk id="8" creationId="{24D3DC6B-23B4-4B05-8BC8-8D707AA57C08}"/>
          </ac:spMkLst>
        </pc:spChg>
        <pc:spChg chg="add mod">
          <ac:chgData name="吉武 和敏" userId="e4825ba96748af9c" providerId="LiveId" clId="{917B18EA-CFD2-4842-A770-C54A8DAF286E}" dt="2020-11-30T07:34:09.575" v="1594" actId="1076"/>
          <ac:spMkLst>
            <pc:docMk/>
            <pc:sldMk cId="1537217434" sldId="268"/>
            <ac:spMk id="9" creationId="{EBCD9017-A999-42F6-B40E-7B8C2815DB33}"/>
          </ac:spMkLst>
        </pc:spChg>
        <pc:spChg chg="mod">
          <ac:chgData name="吉武 和敏" userId="e4825ba96748af9c" providerId="LiveId" clId="{917B18EA-CFD2-4842-A770-C54A8DAF286E}" dt="2020-11-30T07:33:44.101" v="1590"/>
          <ac:spMkLst>
            <pc:docMk/>
            <pc:sldMk cId="1537217434" sldId="268"/>
            <ac:spMk id="10" creationId="{FAC684E9-FE4D-4F45-9F64-33F4AFA3392D}"/>
          </ac:spMkLst>
        </pc:spChg>
        <pc:spChg chg="mod">
          <ac:chgData name="吉武 和敏" userId="e4825ba96748af9c" providerId="LiveId" clId="{917B18EA-CFD2-4842-A770-C54A8DAF286E}" dt="2020-11-30T06:29:17.655" v="1575" actId="1076"/>
          <ac:spMkLst>
            <pc:docMk/>
            <pc:sldMk cId="1537217434" sldId="268"/>
            <ac:spMk id="11" creationId="{950A1099-10EC-4285-B16C-ED78B1FA0AAD}"/>
          </ac:spMkLst>
        </pc:spChg>
        <pc:spChg chg="add del">
          <ac:chgData name="吉武 和敏" userId="e4825ba96748af9c" providerId="LiveId" clId="{917B18EA-CFD2-4842-A770-C54A8DAF286E}" dt="2020-11-30T05:58:39.095" v="960" actId="478"/>
          <ac:spMkLst>
            <pc:docMk/>
            <pc:sldMk cId="1537217434" sldId="268"/>
            <ac:spMk id="12" creationId="{1FD32007-B143-4FE1-916F-A8686160B670}"/>
          </ac:spMkLst>
        </pc:spChg>
        <pc:spChg chg="del">
          <ac:chgData name="吉武 和敏" userId="e4825ba96748af9c" providerId="LiveId" clId="{917B18EA-CFD2-4842-A770-C54A8DAF286E}" dt="2020-11-30T05:57:38.661" v="954" actId="478"/>
          <ac:spMkLst>
            <pc:docMk/>
            <pc:sldMk cId="1537217434" sldId="268"/>
            <ac:spMk id="15" creationId="{37F9B3F0-0ECF-4FD5-8390-9305D6259B4B}"/>
          </ac:spMkLst>
        </pc:spChg>
        <pc:spChg chg="del">
          <ac:chgData name="吉武 和敏" userId="e4825ba96748af9c" providerId="LiveId" clId="{917B18EA-CFD2-4842-A770-C54A8DAF286E}" dt="2020-11-30T05:57:38.661" v="954" actId="478"/>
          <ac:spMkLst>
            <pc:docMk/>
            <pc:sldMk cId="1537217434" sldId="268"/>
            <ac:spMk id="16" creationId="{D1492770-B590-4F8A-B5F5-20CFEF70EC28}"/>
          </ac:spMkLst>
        </pc:spChg>
        <pc:spChg chg="del">
          <ac:chgData name="吉武 和敏" userId="e4825ba96748af9c" providerId="LiveId" clId="{917B18EA-CFD2-4842-A770-C54A8DAF286E}" dt="2020-11-30T05:57:38.661" v="954" actId="478"/>
          <ac:spMkLst>
            <pc:docMk/>
            <pc:sldMk cId="1537217434" sldId="268"/>
            <ac:spMk id="17" creationId="{E0329267-BF43-42AA-92C2-726B8195E479}"/>
          </ac:spMkLst>
        </pc:spChg>
        <pc:spChg chg="del">
          <ac:chgData name="吉武 和敏" userId="e4825ba96748af9c" providerId="LiveId" clId="{917B18EA-CFD2-4842-A770-C54A8DAF286E}" dt="2020-11-30T05:57:38.661" v="954" actId="478"/>
          <ac:spMkLst>
            <pc:docMk/>
            <pc:sldMk cId="1537217434" sldId="268"/>
            <ac:spMk id="18" creationId="{B9F732B5-F9F0-44EC-A655-C23DA0194009}"/>
          </ac:spMkLst>
        </pc:spChg>
        <pc:spChg chg="del">
          <ac:chgData name="吉武 和敏" userId="e4825ba96748af9c" providerId="LiveId" clId="{917B18EA-CFD2-4842-A770-C54A8DAF286E}" dt="2020-11-30T05:57:38.661" v="954" actId="478"/>
          <ac:spMkLst>
            <pc:docMk/>
            <pc:sldMk cId="1537217434" sldId="268"/>
            <ac:spMk id="19" creationId="{61353122-4388-470E-BB6F-CA4ABD622A48}"/>
          </ac:spMkLst>
        </pc:spChg>
        <pc:spChg chg="add mod">
          <ac:chgData name="吉武 和敏" userId="e4825ba96748af9c" providerId="LiveId" clId="{917B18EA-CFD2-4842-A770-C54A8DAF286E}" dt="2020-11-30T07:37:28.026" v="1596" actId="1076"/>
          <ac:spMkLst>
            <pc:docMk/>
            <pc:sldMk cId="1537217434" sldId="268"/>
            <ac:spMk id="20" creationId="{8DAFAC2D-45A5-4E46-A964-C8D1DA5813EB}"/>
          </ac:spMkLst>
        </pc:spChg>
        <pc:spChg chg="del">
          <ac:chgData name="吉武 和敏" userId="e4825ba96748af9c" providerId="LiveId" clId="{917B18EA-CFD2-4842-A770-C54A8DAF286E}" dt="2020-11-30T05:57:38.661" v="954" actId="478"/>
          <ac:spMkLst>
            <pc:docMk/>
            <pc:sldMk cId="1537217434" sldId="268"/>
            <ac:spMk id="24" creationId="{4DEDBD00-6635-43D0-81FB-FCBA17EE33E4}"/>
          </ac:spMkLst>
        </pc:spChg>
        <pc:spChg chg="add mod">
          <ac:chgData name="吉武 和敏" userId="e4825ba96748af9c" providerId="LiveId" clId="{917B18EA-CFD2-4842-A770-C54A8DAF286E}" dt="2020-11-30T07:33:14.446" v="1585" actId="1076"/>
          <ac:spMkLst>
            <pc:docMk/>
            <pc:sldMk cId="1537217434" sldId="268"/>
            <ac:spMk id="25" creationId="{94B65CDC-AE77-4474-BDE5-C70956C5B226}"/>
          </ac:spMkLst>
        </pc:spChg>
        <pc:spChg chg="del">
          <ac:chgData name="吉武 和敏" userId="e4825ba96748af9c" providerId="LiveId" clId="{917B18EA-CFD2-4842-A770-C54A8DAF286E}" dt="2020-11-30T05:57:38.661" v="954" actId="478"/>
          <ac:spMkLst>
            <pc:docMk/>
            <pc:sldMk cId="1537217434" sldId="268"/>
            <ac:spMk id="32" creationId="{4187E944-B59B-4DDB-ABB5-09A55EC446F2}"/>
          </ac:spMkLst>
        </pc:spChg>
        <pc:spChg chg="add mod">
          <ac:chgData name="吉武 和敏" userId="e4825ba96748af9c" providerId="LiveId" clId="{917B18EA-CFD2-4842-A770-C54A8DAF286E}" dt="2020-11-30T07:37:54.180" v="1598" actId="571"/>
          <ac:spMkLst>
            <pc:docMk/>
            <pc:sldMk cId="1537217434" sldId="268"/>
            <ac:spMk id="34" creationId="{68BC2B7F-CDB1-4D71-B576-EADBF4DCA98A}"/>
          </ac:spMkLst>
        </pc:spChg>
        <pc:spChg chg="add mod">
          <ac:chgData name="吉武 和敏" userId="e4825ba96748af9c" providerId="LiveId" clId="{917B18EA-CFD2-4842-A770-C54A8DAF286E}" dt="2020-11-30T07:40:44.676" v="1630" actId="14100"/>
          <ac:spMkLst>
            <pc:docMk/>
            <pc:sldMk cId="1537217434" sldId="268"/>
            <ac:spMk id="36" creationId="{2F9BA13E-7223-4ECD-9B29-3F6EB6C2FE13}"/>
          </ac:spMkLst>
        </pc:spChg>
        <pc:spChg chg="add mod">
          <ac:chgData name="吉武 和敏" userId="e4825ba96748af9c" providerId="LiveId" clId="{917B18EA-CFD2-4842-A770-C54A8DAF286E}" dt="2020-11-30T07:41:16.785" v="1642" actId="20577"/>
          <ac:spMkLst>
            <pc:docMk/>
            <pc:sldMk cId="1537217434" sldId="268"/>
            <ac:spMk id="42" creationId="{EDE83F1B-858B-44FE-A980-104E84C32A47}"/>
          </ac:spMkLst>
        </pc:spChg>
        <pc:spChg chg="add mod">
          <ac:chgData name="吉武 和敏" userId="e4825ba96748af9c" providerId="LiveId" clId="{917B18EA-CFD2-4842-A770-C54A8DAF286E}" dt="2020-11-30T07:41:26.817" v="1645" actId="20577"/>
          <ac:spMkLst>
            <pc:docMk/>
            <pc:sldMk cId="1537217434" sldId="268"/>
            <ac:spMk id="43" creationId="{9C2A2AD8-D0E6-410D-932A-0B1629E441F1}"/>
          </ac:spMkLst>
        </pc:spChg>
        <pc:picChg chg="add mod">
          <ac:chgData name="吉武 和敏" userId="e4825ba96748af9c" providerId="LiveId" clId="{917B18EA-CFD2-4842-A770-C54A8DAF286E}" dt="2020-11-30T07:40:28.531" v="1628" actId="1076"/>
          <ac:picMkLst>
            <pc:docMk/>
            <pc:sldMk cId="1537217434" sldId="268"/>
            <ac:picMk id="3" creationId="{3C6369F5-6930-4578-8BDF-0040EB2E25CD}"/>
          </ac:picMkLst>
        </pc:picChg>
        <pc:picChg chg="del mod">
          <ac:chgData name="吉武 和敏" userId="e4825ba96748af9c" providerId="LiveId" clId="{917B18EA-CFD2-4842-A770-C54A8DAF286E}" dt="2020-11-30T07:32:37.298" v="1582" actId="478"/>
          <ac:picMkLst>
            <pc:docMk/>
            <pc:sldMk cId="1537217434" sldId="268"/>
            <ac:picMk id="4" creationId="{2A88FF09-8A13-4C8E-BEC9-A21F80EEF58D}"/>
          </ac:picMkLst>
        </pc:picChg>
        <pc:picChg chg="del">
          <ac:chgData name="吉武 和敏" userId="e4825ba96748af9c" providerId="LiveId" clId="{917B18EA-CFD2-4842-A770-C54A8DAF286E}" dt="2020-11-30T05:57:40.853" v="955" actId="478"/>
          <ac:picMkLst>
            <pc:docMk/>
            <pc:sldMk cId="1537217434" sldId="268"/>
            <ac:picMk id="7" creationId="{40C1C8CF-DEAA-4772-A146-80E39EA01A7B}"/>
          </ac:picMkLst>
        </pc:picChg>
        <pc:picChg chg="add mod">
          <ac:chgData name="吉武 和敏" userId="e4825ba96748af9c" providerId="LiveId" clId="{917B18EA-CFD2-4842-A770-C54A8DAF286E}" dt="2020-11-30T07:37:54.180" v="1598" actId="571"/>
          <ac:picMkLst>
            <pc:docMk/>
            <pc:sldMk cId="1537217434" sldId="268"/>
            <ac:picMk id="33" creationId="{E54D2929-C719-497E-A9EB-DF82969DE9A6}"/>
          </ac:picMkLst>
        </pc:picChg>
        <pc:picChg chg="add mod modCrop">
          <ac:chgData name="吉武 和敏" userId="e4825ba96748af9c" providerId="LiveId" clId="{917B18EA-CFD2-4842-A770-C54A8DAF286E}" dt="2020-11-30T07:41:01.207" v="1635" actId="208"/>
          <ac:picMkLst>
            <pc:docMk/>
            <pc:sldMk cId="1537217434" sldId="268"/>
            <ac:picMk id="35" creationId="{78A1C322-5D4E-4BAA-BF26-F707E4387723}"/>
          </ac:picMkLst>
        </pc:picChg>
        <pc:picChg chg="add del mod">
          <ac:chgData name="吉武 和敏" userId="e4825ba96748af9c" providerId="LiveId" clId="{917B18EA-CFD2-4842-A770-C54A8DAF286E}" dt="2020-11-30T07:40:22.337" v="1626" actId="478"/>
          <ac:picMkLst>
            <pc:docMk/>
            <pc:sldMk cId="1537217434" sldId="268"/>
            <ac:picMk id="39" creationId="{49777363-8908-4A71-B6A9-1BD4047D1699}"/>
          </ac:picMkLst>
        </pc:picChg>
        <pc:cxnChg chg="del">
          <ac:chgData name="吉武 和敏" userId="e4825ba96748af9c" providerId="LiveId" clId="{917B18EA-CFD2-4842-A770-C54A8DAF286E}" dt="2020-11-30T05:57:38.661" v="954" actId="478"/>
          <ac:cxnSpMkLst>
            <pc:docMk/>
            <pc:sldMk cId="1537217434" sldId="268"/>
            <ac:cxnSpMk id="21" creationId="{D8C2FD0B-94F3-4F8F-B410-572F72DB4505}"/>
          </ac:cxnSpMkLst>
        </pc:cxnChg>
        <pc:cxnChg chg="del">
          <ac:chgData name="吉武 和敏" userId="e4825ba96748af9c" providerId="LiveId" clId="{917B18EA-CFD2-4842-A770-C54A8DAF286E}" dt="2020-11-30T05:57:38.661" v="954" actId="478"/>
          <ac:cxnSpMkLst>
            <pc:docMk/>
            <pc:sldMk cId="1537217434" sldId="268"/>
            <ac:cxnSpMk id="22" creationId="{082AACFA-585F-4CEF-AB26-157720DB7F73}"/>
          </ac:cxnSpMkLst>
        </pc:cxnChg>
        <pc:cxnChg chg="del">
          <ac:chgData name="吉武 和敏" userId="e4825ba96748af9c" providerId="LiveId" clId="{917B18EA-CFD2-4842-A770-C54A8DAF286E}" dt="2020-11-30T05:57:38.661" v="954" actId="478"/>
          <ac:cxnSpMkLst>
            <pc:docMk/>
            <pc:sldMk cId="1537217434" sldId="268"/>
            <ac:cxnSpMk id="31" creationId="{173F0CDB-DC90-42CF-B7F7-B670371D3FB8}"/>
          </ac:cxnSpMkLst>
        </pc:cxnChg>
        <pc:cxnChg chg="add mod">
          <ac:chgData name="吉武 和敏" userId="e4825ba96748af9c" providerId="LiveId" clId="{917B18EA-CFD2-4842-A770-C54A8DAF286E}" dt="2020-11-30T07:40:57.455" v="1634" actId="14100"/>
          <ac:cxnSpMkLst>
            <pc:docMk/>
            <pc:sldMk cId="1537217434" sldId="268"/>
            <ac:cxnSpMk id="37" creationId="{24B3AE51-9F08-480E-BBE0-B706248DF4D6}"/>
          </ac:cxnSpMkLst>
        </pc:cxnChg>
        <pc:cxnChg chg="add mod">
          <ac:chgData name="吉武 和敏" userId="e4825ba96748af9c" providerId="LiveId" clId="{917B18EA-CFD2-4842-A770-C54A8DAF286E}" dt="2020-11-30T07:40:54" v="1633" actId="14100"/>
          <ac:cxnSpMkLst>
            <pc:docMk/>
            <pc:sldMk cId="1537217434" sldId="268"/>
            <ac:cxnSpMk id="38" creationId="{4BFAD1CA-8167-4FC1-9A79-37D65FDBD7D4}"/>
          </ac:cxnSpMkLst>
        </pc:cxnChg>
      </pc:sldChg>
      <pc:sldChg chg="addSp modSp add mod">
        <pc:chgData name="吉武 和敏" userId="e4825ba96748af9c" providerId="LiveId" clId="{917B18EA-CFD2-4842-A770-C54A8DAF286E}" dt="2020-11-30T07:59:16.817" v="1931" actId="1076"/>
        <pc:sldMkLst>
          <pc:docMk/>
          <pc:sldMk cId="1077170640" sldId="269"/>
        </pc:sldMkLst>
        <pc:spChg chg="mod">
          <ac:chgData name="吉武 和敏" userId="e4825ba96748af9c" providerId="LiveId" clId="{917B18EA-CFD2-4842-A770-C54A8DAF286E}" dt="2020-11-30T07:58:41.344" v="1924" actId="1076"/>
          <ac:spMkLst>
            <pc:docMk/>
            <pc:sldMk cId="1077170640" sldId="269"/>
            <ac:spMk id="6" creationId="{2E7E78A3-CF86-4247-B49A-DFA18002B40C}"/>
          </ac:spMkLst>
        </pc:spChg>
        <pc:spChg chg="add mod">
          <ac:chgData name="吉武 和敏" userId="e4825ba96748af9c" providerId="LiveId" clId="{917B18EA-CFD2-4842-A770-C54A8DAF286E}" dt="2020-11-30T07:59:01.489" v="1927" actId="1076"/>
          <ac:spMkLst>
            <pc:docMk/>
            <pc:sldMk cId="1077170640" sldId="269"/>
            <ac:spMk id="7" creationId="{7A9CF69F-7920-4293-B1F1-B9F763D8E8D5}"/>
          </ac:spMkLst>
        </pc:spChg>
        <pc:spChg chg="add mod">
          <ac:chgData name="吉武 和敏" userId="e4825ba96748af9c" providerId="LiveId" clId="{917B18EA-CFD2-4842-A770-C54A8DAF286E}" dt="2020-11-30T07:59:16.817" v="1931" actId="1076"/>
          <ac:spMkLst>
            <pc:docMk/>
            <pc:sldMk cId="1077170640" sldId="269"/>
            <ac:spMk id="8" creationId="{6034EC90-5E40-4740-886C-76CE8B8AC83A}"/>
          </ac:spMkLst>
        </pc:spChg>
        <pc:picChg chg="mod modCrop">
          <ac:chgData name="吉武 和敏" userId="e4825ba96748af9c" providerId="LiveId" clId="{917B18EA-CFD2-4842-A770-C54A8DAF286E}" dt="2020-11-30T07:58:56.555" v="1926" actId="732"/>
          <ac:picMkLst>
            <pc:docMk/>
            <pc:sldMk cId="1077170640" sldId="269"/>
            <ac:picMk id="3" creationId="{58562A30-9D25-4B54-9DC2-3BBFD6448F8C}"/>
          </ac:picMkLst>
        </pc:picChg>
      </pc:sldChg>
      <pc:sldChg chg="addSp delSp modSp add mod ord">
        <pc:chgData name="吉武 和敏" userId="e4825ba96748af9c" providerId="LiveId" clId="{917B18EA-CFD2-4842-A770-C54A8DAF286E}" dt="2020-11-30T07:50:53.391" v="1784" actId="20577"/>
        <pc:sldMkLst>
          <pc:docMk/>
          <pc:sldMk cId="2690405455" sldId="270"/>
        </pc:sldMkLst>
        <pc:spChg chg="add mod">
          <ac:chgData name="吉武 和敏" userId="e4825ba96748af9c" providerId="LiveId" clId="{917B18EA-CFD2-4842-A770-C54A8DAF286E}" dt="2020-11-30T06:21:58.946" v="1117" actId="20577"/>
          <ac:spMkLst>
            <pc:docMk/>
            <pc:sldMk cId="2690405455" sldId="270"/>
            <ac:spMk id="2" creationId="{997382DA-BEFA-49BC-862C-708E462F4366}"/>
          </ac:spMkLst>
        </pc:spChg>
        <pc:spChg chg="add mod">
          <ac:chgData name="吉武 和敏" userId="e4825ba96748af9c" providerId="LiveId" clId="{917B18EA-CFD2-4842-A770-C54A8DAF286E}" dt="2020-11-30T06:24:46.929" v="1563" actId="20577"/>
          <ac:spMkLst>
            <pc:docMk/>
            <pc:sldMk cId="2690405455" sldId="270"/>
            <ac:spMk id="6" creationId="{2935A97F-A62D-4C66-A797-7D2E90E05D1E}"/>
          </ac:spMkLst>
        </pc:spChg>
        <pc:spChg chg="add mod">
          <ac:chgData name="吉武 和敏" userId="e4825ba96748af9c" providerId="LiveId" clId="{917B18EA-CFD2-4842-A770-C54A8DAF286E}" dt="2020-11-30T07:49:48.725" v="1772" actId="1076"/>
          <ac:spMkLst>
            <pc:docMk/>
            <pc:sldMk cId="2690405455" sldId="270"/>
            <ac:spMk id="8" creationId="{4D6365E5-2E48-429D-A9D8-939862B6DD0A}"/>
          </ac:spMkLst>
        </pc:spChg>
        <pc:spChg chg="mod">
          <ac:chgData name="吉武 和敏" userId="e4825ba96748af9c" providerId="LiveId" clId="{917B18EA-CFD2-4842-A770-C54A8DAF286E}" dt="2020-11-30T06:20:58.262" v="1093" actId="1076"/>
          <ac:spMkLst>
            <pc:docMk/>
            <pc:sldMk cId="2690405455" sldId="270"/>
            <ac:spMk id="12" creationId="{A125914F-BADF-4BCC-9951-363DD5B2A8FA}"/>
          </ac:spMkLst>
        </pc:spChg>
        <pc:spChg chg="mod">
          <ac:chgData name="吉武 和敏" userId="e4825ba96748af9c" providerId="LiveId" clId="{917B18EA-CFD2-4842-A770-C54A8DAF286E}" dt="2020-11-30T06:20:58.262" v="1093" actId="1076"/>
          <ac:spMkLst>
            <pc:docMk/>
            <pc:sldMk cId="2690405455" sldId="270"/>
            <ac:spMk id="13" creationId="{1449545F-DC19-44BB-8B06-51820AB4A5CC}"/>
          </ac:spMkLst>
        </pc:spChg>
        <pc:spChg chg="mod">
          <ac:chgData name="吉武 和敏" userId="e4825ba96748af9c" providerId="LiveId" clId="{917B18EA-CFD2-4842-A770-C54A8DAF286E}" dt="2020-11-30T06:27:10.658" v="1569" actId="20577"/>
          <ac:spMkLst>
            <pc:docMk/>
            <pc:sldMk cId="2690405455" sldId="270"/>
            <ac:spMk id="15" creationId="{CE3A3C06-C21E-4447-A8BC-14477C93FBF4}"/>
          </ac:spMkLst>
        </pc:spChg>
        <pc:spChg chg="del mod">
          <ac:chgData name="吉武 和敏" userId="e4825ba96748af9c" providerId="LiveId" clId="{917B18EA-CFD2-4842-A770-C54A8DAF286E}" dt="2020-11-30T06:24:53.536" v="1564" actId="478"/>
          <ac:spMkLst>
            <pc:docMk/>
            <pc:sldMk cId="2690405455" sldId="270"/>
            <ac:spMk id="16" creationId="{EB63DD6D-564A-4CE8-B8B1-7BE8953DEB6F}"/>
          </ac:spMkLst>
        </pc:spChg>
        <pc:spChg chg="del mod">
          <ac:chgData name="吉武 和敏" userId="e4825ba96748af9c" providerId="LiveId" clId="{917B18EA-CFD2-4842-A770-C54A8DAF286E}" dt="2020-11-30T06:24:53.536" v="1564" actId="478"/>
          <ac:spMkLst>
            <pc:docMk/>
            <pc:sldMk cId="2690405455" sldId="270"/>
            <ac:spMk id="17" creationId="{431B62DA-C344-49EA-8D76-DF122B9CB0B2}"/>
          </ac:spMkLst>
        </pc:spChg>
        <pc:spChg chg="del mod">
          <ac:chgData name="吉武 和敏" userId="e4825ba96748af9c" providerId="LiveId" clId="{917B18EA-CFD2-4842-A770-C54A8DAF286E}" dt="2020-11-30T06:24:53.536" v="1564" actId="478"/>
          <ac:spMkLst>
            <pc:docMk/>
            <pc:sldMk cId="2690405455" sldId="270"/>
            <ac:spMk id="18" creationId="{9957B502-8493-4E09-88CA-597D91665684}"/>
          </ac:spMkLst>
        </pc:spChg>
        <pc:spChg chg="del mod">
          <ac:chgData name="吉武 和敏" userId="e4825ba96748af9c" providerId="LiveId" clId="{917B18EA-CFD2-4842-A770-C54A8DAF286E}" dt="2020-11-30T06:24:53.536" v="1564" actId="478"/>
          <ac:spMkLst>
            <pc:docMk/>
            <pc:sldMk cId="2690405455" sldId="270"/>
            <ac:spMk id="19" creationId="{D3D9DC99-10FD-4C47-B383-A346A51AC384}"/>
          </ac:spMkLst>
        </pc:spChg>
        <pc:spChg chg="add mod">
          <ac:chgData name="吉武 和敏" userId="e4825ba96748af9c" providerId="LiveId" clId="{917B18EA-CFD2-4842-A770-C54A8DAF286E}" dt="2020-11-30T06:22:01.538" v="1119" actId="20577"/>
          <ac:spMkLst>
            <pc:docMk/>
            <pc:sldMk cId="2690405455" sldId="270"/>
            <ac:spMk id="26" creationId="{51D5B7DC-C8E7-4860-87B0-B80727A196AC}"/>
          </ac:spMkLst>
        </pc:spChg>
        <pc:spChg chg="add mod">
          <ac:chgData name="吉武 和敏" userId="e4825ba96748af9c" providerId="LiveId" clId="{917B18EA-CFD2-4842-A770-C54A8DAF286E}" dt="2020-11-30T06:22:04.130" v="1121" actId="20577"/>
          <ac:spMkLst>
            <pc:docMk/>
            <pc:sldMk cId="2690405455" sldId="270"/>
            <ac:spMk id="27" creationId="{01DA66D1-FC5D-422B-879C-A75D3BAAE579}"/>
          </ac:spMkLst>
        </pc:spChg>
        <pc:spChg chg="add mod">
          <ac:chgData name="吉武 和敏" userId="e4825ba96748af9c" providerId="LiveId" clId="{917B18EA-CFD2-4842-A770-C54A8DAF286E}" dt="2020-11-30T06:22:06.433" v="1123" actId="20577"/>
          <ac:spMkLst>
            <pc:docMk/>
            <pc:sldMk cId="2690405455" sldId="270"/>
            <ac:spMk id="29" creationId="{81BE36F9-E530-4D7D-9EB2-6F3B9BB03F85}"/>
          </ac:spMkLst>
        </pc:spChg>
        <pc:spChg chg="mod">
          <ac:chgData name="吉武 和敏" userId="e4825ba96748af9c" providerId="LiveId" clId="{917B18EA-CFD2-4842-A770-C54A8DAF286E}" dt="2020-11-30T06:20:58.262" v="1093" actId="1076"/>
          <ac:spMkLst>
            <pc:docMk/>
            <pc:sldMk cId="2690405455" sldId="270"/>
            <ac:spMk id="30" creationId="{ACC4152A-AA60-4F32-BD09-E5971A939F13}"/>
          </ac:spMkLst>
        </pc:spChg>
        <pc:spChg chg="add mod">
          <ac:chgData name="吉武 和敏" userId="e4825ba96748af9c" providerId="LiveId" clId="{917B18EA-CFD2-4842-A770-C54A8DAF286E}" dt="2020-11-30T06:22:10.593" v="1125" actId="20577"/>
          <ac:spMkLst>
            <pc:docMk/>
            <pc:sldMk cId="2690405455" sldId="270"/>
            <ac:spMk id="31" creationId="{2538EFC4-E97A-4619-B494-FF432ED840E6}"/>
          </ac:spMkLst>
        </pc:spChg>
        <pc:spChg chg="add mod">
          <ac:chgData name="吉武 和敏" userId="e4825ba96748af9c" providerId="LiveId" clId="{917B18EA-CFD2-4842-A770-C54A8DAF286E}" dt="2020-11-30T07:50:16.863" v="1780" actId="20577"/>
          <ac:spMkLst>
            <pc:docMk/>
            <pc:sldMk cId="2690405455" sldId="270"/>
            <ac:spMk id="34" creationId="{FAD5B322-C7A1-4C16-8500-6484BF68BD2D}"/>
          </ac:spMkLst>
        </pc:spChg>
        <pc:spChg chg="mod">
          <ac:chgData name="吉武 和敏" userId="e4825ba96748af9c" providerId="LiveId" clId="{917B18EA-CFD2-4842-A770-C54A8DAF286E}" dt="2020-11-30T06:27:21.529" v="1571" actId="14100"/>
          <ac:spMkLst>
            <pc:docMk/>
            <pc:sldMk cId="2690405455" sldId="270"/>
            <ac:spMk id="35" creationId="{337FF8C5-FA50-42B5-B420-7E4C4D890FD8}"/>
          </ac:spMkLst>
        </pc:spChg>
        <pc:spChg chg="add mod">
          <ac:chgData name="吉武 和敏" userId="e4825ba96748af9c" providerId="LiveId" clId="{917B18EA-CFD2-4842-A770-C54A8DAF286E}" dt="2020-11-30T07:50:53.391" v="1784" actId="20577"/>
          <ac:spMkLst>
            <pc:docMk/>
            <pc:sldMk cId="2690405455" sldId="270"/>
            <ac:spMk id="36" creationId="{C78593A8-B6EE-48EC-B493-77029EC9DF39}"/>
          </ac:spMkLst>
        </pc:spChg>
        <pc:spChg chg="mod">
          <ac:chgData name="吉武 和敏" userId="e4825ba96748af9c" providerId="LiveId" clId="{917B18EA-CFD2-4842-A770-C54A8DAF286E}" dt="2020-11-30T06:20:58.262" v="1093" actId="1076"/>
          <ac:spMkLst>
            <pc:docMk/>
            <pc:sldMk cId="2690405455" sldId="270"/>
            <ac:spMk id="37" creationId="{7DC9BED5-2113-4D10-9482-E37FB108FA0F}"/>
          </ac:spMkLst>
        </pc:spChg>
        <pc:spChg chg="mod">
          <ac:chgData name="吉武 和敏" userId="e4825ba96748af9c" providerId="LiveId" clId="{917B18EA-CFD2-4842-A770-C54A8DAF286E}" dt="2020-11-30T06:20:58.262" v="1093" actId="1076"/>
          <ac:spMkLst>
            <pc:docMk/>
            <pc:sldMk cId="2690405455" sldId="270"/>
            <ac:spMk id="45" creationId="{54FE58BB-D83F-4DEE-B04D-559C752A0DF7}"/>
          </ac:spMkLst>
        </pc:spChg>
        <pc:graphicFrameChg chg="add del">
          <ac:chgData name="吉武 和敏" userId="e4825ba96748af9c" providerId="LiveId" clId="{917B18EA-CFD2-4842-A770-C54A8DAF286E}" dt="2020-11-30T06:26:53.457" v="1565" actId="478"/>
          <ac:graphicFrameMkLst>
            <pc:docMk/>
            <pc:sldMk cId="2690405455" sldId="270"/>
            <ac:graphicFrameMk id="4" creationId="{5D1376B5-ECE6-4CF8-91F0-573DED635684}"/>
          </ac:graphicFrameMkLst>
        </pc:graphicFrameChg>
        <pc:picChg chg="mod">
          <ac:chgData name="吉武 和敏" userId="e4825ba96748af9c" providerId="LiveId" clId="{917B18EA-CFD2-4842-A770-C54A8DAF286E}" dt="2020-11-30T06:20:58.262" v="1093" actId="1076"/>
          <ac:picMkLst>
            <pc:docMk/>
            <pc:sldMk cId="2690405455" sldId="270"/>
            <ac:picMk id="3" creationId="{9CDD7990-9029-40A7-92C0-D3C0FC2EA9B1}"/>
          </ac:picMkLst>
        </pc:picChg>
        <pc:picChg chg="mod">
          <ac:chgData name="吉武 和敏" userId="e4825ba96748af9c" providerId="LiveId" clId="{917B18EA-CFD2-4842-A770-C54A8DAF286E}" dt="2020-11-30T06:20:58.262" v="1093" actId="1076"/>
          <ac:picMkLst>
            <pc:docMk/>
            <pc:sldMk cId="2690405455" sldId="270"/>
            <ac:picMk id="5" creationId="{4AB88DE6-FC6A-478B-89E2-3BB643B6766A}"/>
          </ac:picMkLst>
        </pc:picChg>
        <pc:picChg chg="mod">
          <ac:chgData name="吉武 和敏" userId="e4825ba96748af9c" providerId="LiveId" clId="{917B18EA-CFD2-4842-A770-C54A8DAF286E}" dt="2020-11-30T06:20:58.262" v="1093" actId="1076"/>
          <ac:picMkLst>
            <pc:docMk/>
            <pc:sldMk cId="2690405455" sldId="270"/>
            <ac:picMk id="7" creationId="{AE4C5715-0D7B-4CE0-A852-8CC8988A295F}"/>
          </ac:picMkLst>
        </pc:picChg>
        <pc:picChg chg="mod">
          <ac:chgData name="吉武 和敏" userId="e4825ba96748af9c" providerId="LiveId" clId="{917B18EA-CFD2-4842-A770-C54A8DAF286E}" dt="2020-11-30T06:20:58.262" v="1093" actId="1076"/>
          <ac:picMkLst>
            <pc:docMk/>
            <pc:sldMk cId="2690405455" sldId="270"/>
            <ac:picMk id="9" creationId="{5EFE40CB-93E6-4B2D-B29D-27D67402B450}"/>
          </ac:picMkLst>
        </pc:picChg>
        <pc:picChg chg="mod">
          <ac:chgData name="吉武 和敏" userId="e4825ba96748af9c" providerId="LiveId" clId="{917B18EA-CFD2-4842-A770-C54A8DAF286E}" dt="2020-11-30T06:20:58.262" v="1093" actId="1076"/>
          <ac:picMkLst>
            <pc:docMk/>
            <pc:sldMk cId="2690405455" sldId="270"/>
            <ac:picMk id="11" creationId="{CA299895-95DC-4086-A929-D318C45B5298}"/>
          </ac:picMkLst>
        </pc:picChg>
        <pc:cxnChg chg="mod">
          <ac:chgData name="吉武 和敏" userId="e4825ba96748af9c" providerId="LiveId" clId="{917B18EA-CFD2-4842-A770-C54A8DAF286E}" dt="2020-11-30T06:20:58.262" v="1093" actId="1076"/>
          <ac:cxnSpMkLst>
            <pc:docMk/>
            <pc:sldMk cId="2690405455" sldId="270"/>
            <ac:cxnSpMk id="24" creationId="{2457528F-AB27-4EBA-BCF7-9887D6A27DD7}"/>
          </ac:cxnSpMkLst>
        </pc:cxnChg>
        <pc:cxnChg chg="mod">
          <ac:chgData name="吉武 和敏" userId="e4825ba96748af9c" providerId="LiveId" clId="{917B18EA-CFD2-4842-A770-C54A8DAF286E}" dt="2020-11-30T06:20:58.262" v="1093" actId="1076"/>
          <ac:cxnSpMkLst>
            <pc:docMk/>
            <pc:sldMk cId="2690405455" sldId="270"/>
            <ac:cxnSpMk id="25" creationId="{CD0F3525-64E0-4014-89FA-4F2EA7D2BE5C}"/>
          </ac:cxnSpMkLst>
        </pc:cxnChg>
        <pc:cxnChg chg="mod">
          <ac:chgData name="吉武 和敏" userId="e4825ba96748af9c" providerId="LiveId" clId="{917B18EA-CFD2-4842-A770-C54A8DAF286E}" dt="2020-11-30T06:20:58.262" v="1093" actId="1076"/>
          <ac:cxnSpMkLst>
            <pc:docMk/>
            <pc:sldMk cId="2690405455" sldId="270"/>
            <ac:cxnSpMk id="28" creationId="{2B25EA7C-0372-414A-9C41-CE0DAB3DD0C5}"/>
          </ac:cxnSpMkLst>
        </pc:cxnChg>
        <pc:cxnChg chg="mod">
          <ac:chgData name="吉武 和敏" userId="e4825ba96748af9c" providerId="LiveId" clId="{917B18EA-CFD2-4842-A770-C54A8DAF286E}" dt="2020-11-30T06:20:58.262" v="1093" actId="1076"/>
          <ac:cxnSpMkLst>
            <pc:docMk/>
            <pc:sldMk cId="2690405455" sldId="270"/>
            <ac:cxnSpMk id="33" creationId="{BC5AF099-046D-41D8-80D6-60886A61FC8E}"/>
          </ac:cxnSpMkLst>
        </pc:cxnChg>
        <pc:cxnChg chg="mod">
          <ac:chgData name="吉武 和敏" userId="e4825ba96748af9c" providerId="LiveId" clId="{917B18EA-CFD2-4842-A770-C54A8DAF286E}" dt="2020-11-30T06:20:58.262" v="1093" actId="1076"/>
          <ac:cxnSpMkLst>
            <pc:docMk/>
            <pc:sldMk cId="2690405455" sldId="270"/>
            <ac:cxnSpMk id="42" creationId="{D90C575C-B45D-4764-AFF0-8F7315E12937}"/>
          </ac:cxnSpMkLst>
        </pc:cxnChg>
        <pc:cxnChg chg="mod">
          <ac:chgData name="吉武 和敏" userId="e4825ba96748af9c" providerId="LiveId" clId="{917B18EA-CFD2-4842-A770-C54A8DAF286E}" dt="2020-11-30T06:20:58.262" v="1093" actId="1076"/>
          <ac:cxnSpMkLst>
            <pc:docMk/>
            <pc:sldMk cId="2690405455" sldId="270"/>
            <ac:cxnSpMk id="44" creationId="{D75A9A5E-5189-4DA8-A13F-59496FB1E4FB}"/>
          </ac:cxnSpMkLst>
        </pc:cxnChg>
      </pc:sldChg>
      <pc:sldChg chg="add">
        <pc:chgData name="吉武 和敏" userId="e4825ba96748af9c" providerId="LiveId" clId="{917B18EA-CFD2-4842-A770-C54A8DAF286E}" dt="2020-11-18T08:20:58.056" v="53"/>
        <pc:sldMkLst>
          <pc:docMk/>
          <pc:sldMk cId="1279299448" sldId="271"/>
        </pc:sldMkLst>
      </pc:sldChg>
      <pc:sldChg chg="delSp modSp add mod">
        <pc:chgData name="吉武 和敏" userId="e4825ba96748af9c" providerId="LiveId" clId="{917B18EA-CFD2-4842-A770-C54A8DAF286E}" dt="2020-11-30T06:19:15.938" v="1091" actId="20577"/>
        <pc:sldMkLst>
          <pc:docMk/>
          <pc:sldMk cId="4140638350" sldId="272"/>
        </pc:sldMkLst>
        <pc:spChg chg="mod">
          <ac:chgData name="吉武 和敏" userId="e4825ba96748af9c" providerId="LiveId" clId="{917B18EA-CFD2-4842-A770-C54A8DAF286E}" dt="2020-11-30T06:16:57.185" v="1080" actId="20577"/>
          <ac:spMkLst>
            <pc:docMk/>
            <pc:sldMk cId="4140638350" sldId="272"/>
            <ac:spMk id="18" creationId="{7D772A93-3FFE-41ED-B35D-1B08FEC8CE32}"/>
          </ac:spMkLst>
        </pc:spChg>
        <pc:spChg chg="mod">
          <ac:chgData name="吉武 和敏" userId="e4825ba96748af9c" providerId="LiveId" clId="{917B18EA-CFD2-4842-A770-C54A8DAF286E}" dt="2020-11-30T06:19:15.938" v="1091" actId="20577"/>
          <ac:spMkLst>
            <pc:docMk/>
            <pc:sldMk cId="4140638350" sldId="272"/>
            <ac:spMk id="19" creationId="{45DD41CD-2A3F-4E41-BC71-A33E17EA20E3}"/>
          </ac:spMkLst>
        </pc:spChg>
        <pc:spChg chg="del mod">
          <ac:chgData name="吉武 和敏" userId="e4825ba96748af9c" providerId="LiveId" clId="{917B18EA-CFD2-4842-A770-C54A8DAF286E}" dt="2020-11-30T06:15:21.522" v="1041" actId="478"/>
          <ac:spMkLst>
            <pc:docMk/>
            <pc:sldMk cId="4140638350" sldId="272"/>
            <ac:spMk id="24" creationId="{8E5FACB2-0B62-4426-A7A9-1DF16A135FE1}"/>
          </ac:spMkLst>
        </pc:spChg>
        <pc:spChg chg="mod">
          <ac:chgData name="吉武 和敏" userId="e4825ba96748af9c" providerId="LiveId" clId="{917B18EA-CFD2-4842-A770-C54A8DAF286E}" dt="2020-11-30T06:15:29.042" v="1049" actId="20577"/>
          <ac:spMkLst>
            <pc:docMk/>
            <pc:sldMk cId="4140638350" sldId="272"/>
            <ac:spMk id="25" creationId="{DD16C646-1650-4E81-A2E2-F6A830B6248A}"/>
          </ac:spMkLst>
        </pc:spChg>
        <pc:graphicFrameChg chg="modGraphic">
          <ac:chgData name="吉武 和敏" userId="e4825ba96748af9c" providerId="LiveId" clId="{917B18EA-CFD2-4842-A770-C54A8DAF286E}" dt="2020-11-30T06:15:16.520" v="1040" actId="207"/>
          <ac:graphicFrameMkLst>
            <pc:docMk/>
            <pc:sldMk cId="4140638350" sldId="272"/>
            <ac:graphicFrameMk id="16" creationId="{344BCB9C-0D1A-4B2C-8B74-0AEC10061B1D}"/>
          </ac:graphicFrameMkLst>
        </pc:graphicFrameChg>
      </pc:sldChg>
      <pc:sldChg chg="addSp modSp add mod">
        <pc:chgData name="吉武 和敏" userId="e4825ba96748af9c" providerId="LiveId" clId="{917B18EA-CFD2-4842-A770-C54A8DAF286E}" dt="2020-11-30T06:16:14.263" v="1062" actId="207"/>
        <pc:sldMkLst>
          <pc:docMk/>
          <pc:sldMk cId="4258909056" sldId="273"/>
        </pc:sldMkLst>
        <pc:spChg chg="mod">
          <ac:chgData name="吉武 和敏" userId="e4825ba96748af9c" providerId="LiveId" clId="{917B18EA-CFD2-4842-A770-C54A8DAF286E}" dt="2020-11-30T06:01:41.208" v="978" actId="1076"/>
          <ac:spMkLst>
            <pc:docMk/>
            <pc:sldMk cId="4258909056" sldId="273"/>
            <ac:spMk id="24" creationId="{8E5FACB2-0B62-4426-A7A9-1DF16A135FE1}"/>
          </ac:spMkLst>
        </pc:spChg>
        <pc:spChg chg="mod">
          <ac:chgData name="吉武 和敏" userId="e4825ba96748af9c" providerId="LiveId" clId="{917B18EA-CFD2-4842-A770-C54A8DAF286E}" dt="2020-11-30T06:01:41.208" v="978" actId="1076"/>
          <ac:spMkLst>
            <pc:docMk/>
            <pc:sldMk cId="4258909056" sldId="273"/>
            <ac:spMk id="25" creationId="{DD16C646-1650-4E81-A2E2-F6A830B6248A}"/>
          </ac:spMkLst>
        </pc:spChg>
        <pc:spChg chg="add mod">
          <ac:chgData name="吉武 和敏" userId="e4825ba96748af9c" providerId="LiveId" clId="{917B18EA-CFD2-4842-A770-C54A8DAF286E}" dt="2020-11-30T05:58:37.639" v="958" actId="571"/>
          <ac:spMkLst>
            <pc:docMk/>
            <pc:sldMk cId="4258909056" sldId="273"/>
            <ac:spMk id="33" creationId="{D5CEE574-109A-4D5A-ACF7-323A135579AC}"/>
          </ac:spMkLst>
        </pc:spChg>
        <pc:spChg chg="mod">
          <ac:chgData name="吉武 和敏" userId="e4825ba96748af9c" providerId="LiveId" clId="{917B18EA-CFD2-4842-A770-C54A8DAF286E}" dt="2020-11-30T06:00:44.785" v="974" actId="14100"/>
          <ac:spMkLst>
            <pc:docMk/>
            <pc:sldMk cId="4258909056" sldId="273"/>
            <ac:spMk id="34" creationId="{7E719F3C-37A0-448B-917C-ECDFD686966B}"/>
          </ac:spMkLst>
        </pc:spChg>
        <pc:spChg chg="mod">
          <ac:chgData name="吉武 和敏" userId="e4825ba96748af9c" providerId="LiveId" clId="{917B18EA-CFD2-4842-A770-C54A8DAF286E}" dt="2020-11-30T06:01:11.536" v="977" actId="1076"/>
          <ac:spMkLst>
            <pc:docMk/>
            <pc:sldMk cId="4258909056" sldId="273"/>
            <ac:spMk id="35" creationId="{5D51BC05-D195-4CF6-A5EE-588F0A74E522}"/>
          </ac:spMkLst>
        </pc:spChg>
        <pc:spChg chg="mod">
          <ac:chgData name="吉武 和敏" userId="e4825ba96748af9c" providerId="LiveId" clId="{917B18EA-CFD2-4842-A770-C54A8DAF286E}" dt="2020-11-30T06:00:44.785" v="974" actId="14100"/>
          <ac:spMkLst>
            <pc:docMk/>
            <pc:sldMk cId="4258909056" sldId="273"/>
            <ac:spMk id="37" creationId="{131FC941-AB62-4176-9CAF-82206774208E}"/>
          </ac:spMkLst>
        </pc:spChg>
        <pc:spChg chg="mod">
          <ac:chgData name="吉武 和敏" userId="e4825ba96748af9c" providerId="LiveId" clId="{917B18EA-CFD2-4842-A770-C54A8DAF286E}" dt="2020-11-30T06:00:44.785" v="974" actId="14100"/>
          <ac:spMkLst>
            <pc:docMk/>
            <pc:sldMk cId="4258909056" sldId="273"/>
            <ac:spMk id="39" creationId="{D6D68DA3-361C-4CD7-A36D-3507DCE7FB0E}"/>
          </ac:spMkLst>
        </pc:spChg>
        <pc:spChg chg="mod">
          <ac:chgData name="吉武 和敏" userId="e4825ba96748af9c" providerId="LiveId" clId="{917B18EA-CFD2-4842-A770-C54A8DAF286E}" dt="2020-11-30T06:01:43.619" v="979" actId="1076"/>
          <ac:spMkLst>
            <pc:docMk/>
            <pc:sldMk cId="4258909056" sldId="273"/>
            <ac:spMk id="40" creationId="{52861F76-F7F6-4156-AA3C-99F513B6587E}"/>
          </ac:spMkLst>
        </pc:spChg>
        <pc:spChg chg="mod">
          <ac:chgData name="吉武 和敏" userId="e4825ba96748af9c" providerId="LiveId" clId="{917B18EA-CFD2-4842-A770-C54A8DAF286E}" dt="2020-11-30T06:00:28.036" v="973" actId="14100"/>
          <ac:spMkLst>
            <pc:docMk/>
            <pc:sldMk cId="4258909056" sldId="273"/>
            <ac:spMk id="47" creationId="{93C73894-E25C-4FAF-96D5-3EFAC550B680}"/>
          </ac:spMkLst>
        </pc:spChg>
        <pc:spChg chg="mod">
          <ac:chgData name="吉武 和敏" userId="e4825ba96748af9c" providerId="LiveId" clId="{917B18EA-CFD2-4842-A770-C54A8DAF286E}" dt="2020-11-30T06:00:07.593" v="968" actId="14100"/>
          <ac:spMkLst>
            <pc:docMk/>
            <pc:sldMk cId="4258909056" sldId="273"/>
            <ac:spMk id="48" creationId="{9B3684F1-3A65-4AD0-8721-BC8401482464}"/>
          </ac:spMkLst>
        </pc:spChg>
        <pc:spChg chg="mod">
          <ac:chgData name="吉武 和敏" userId="e4825ba96748af9c" providerId="LiveId" clId="{917B18EA-CFD2-4842-A770-C54A8DAF286E}" dt="2020-11-30T06:00:07.593" v="968" actId="14100"/>
          <ac:spMkLst>
            <pc:docMk/>
            <pc:sldMk cId="4258909056" sldId="273"/>
            <ac:spMk id="49" creationId="{1674AA2A-6039-40D8-A015-AE3EA47A6C11}"/>
          </ac:spMkLst>
        </pc:spChg>
        <pc:spChg chg="mod">
          <ac:chgData name="吉武 和敏" userId="e4825ba96748af9c" providerId="LiveId" clId="{917B18EA-CFD2-4842-A770-C54A8DAF286E}" dt="2020-11-30T06:00:44.785" v="974" actId="14100"/>
          <ac:spMkLst>
            <pc:docMk/>
            <pc:sldMk cId="4258909056" sldId="273"/>
            <ac:spMk id="51" creationId="{8659FA3A-CE12-4861-8407-43C8F4CAA190}"/>
          </ac:spMkLst>
        </pc:spChg>
        <pc:spChg chg="mod">
          <ac:chgData name="吉武 和敏" userId="e4825ba96748af9c" providerId="LiveId" clId="{917B18EA-CFD2-4842-A770-C54A8DAF286E}" dt="2020-11-30T06:00:44.785" v="974" actId="14100"/>
          <ac:spMkLst>
            <pc:docMk/>
            <pc:sldMk cId="4258909056" sldId="273"/>
            <ac:spMk id="52" creationId="{4A1766CE-536E-458F-AA9F-758A051F6012}"/>
          </ac:spMkLst>
        </pc:spChg>
        <pc:spChg chg="mod">
          <ac:chgData name="吉武 和敏" userId="e4825ba96748af9c" providerId="LiveId" clId="{917B18EA-CFD2-4842-A770-C54A8DAF286E}" dt="2020-11-30T06:00:44.785" v="974" actId="14100"/>
          <ac:spMkLst>
            <pc:docMk/>
            <pc:sldMk cId="4258909056" sldId="273"/>
            <ac:spMk id="53" creationId="{12144BEE-C7BB-405F-B6E4-38844B1F87EF}"/>
          </ac:spMkLst>
        </pc:spChg>
        <pc:graphicFrameChg chg="modGraphic">
          <ac:chgData name="吉武 和敏" userId="e4825ba96748af9c" providerId="LiveId" clId="{917B18EA-CFD2-4842-A770-C54A8DAF286E}" dt="2020-11-30T06:16:14.263" v="1062" actId="207"/>
          <ac:graphicFrameMkLst>
            <pc:docMk/>
            <pc:sldMk cId="4258909056" sldId="273"/>
            <ac:graphicFrameMk id="26" creationId="{84B46B27-8B9C-42BD-8C55-80201C51B369}"/>
          </ac:graphicFrameMkLst>
        </pc:graphicFrameChg>
        <pc:graphicFrameChg chg="modGraphic">
          <ac:chgData name="吉武 和敏" userId="e4825ba96748af9c" providerId="LiveId" clId="{917B18EA-CFD2-4842-A770-C54A8DAF286E}" dt="2020-11-30T05:59:48.029" v="967" actId="14100"/>
          <ac:graphicFrameMkLst>
            <pc:docMk/>
            <pc:sldMk cId="4258909056" sldId="273"/>
            <ac:graphicFrameMk id="27" creationId="{AD6E767D-92D6-4EDB-90B5-96632AA35D78}"/>
          </ac:graphicFrameMkLst>
        </pc:graphicFrameChg>
        <pc:graphicFrameChg chg="mod">
          <ac:chgData name="吉武 和敏" userId="e4825ba96748af9c" providerId="LiveId" clId="{917B18EA-CFD2-4842-A770-C54A8DAF286E}" dt="2020-11-30T06:00:20.167" v="971" actId="1076"/>
          <ac:graphicFrameMkLst>
            <pc:docMk/>
            <pc:sldMk cId="4258909056" sldId="273"/>
            <ac:graphicFrameMk id="43" creationId="{BDFECD5B-B995-4216-9EC2-B66636875BA1}"/>
          </ac:graphicFrameMkLst>
        </pc:graphicFrameChg>
        <pc:graphicFrameChg chg="add mod">
          <ac:chgData name="吉武 和敏" userId="e4825ba96748af9c" providerId="LiveId" clId="{917B18EA-CFD2-4842-A770-C54A8DAF286E}" dt="2020-11-30T05:58:37.639" v="958" actId="571"/>
          <ac:graphicFrameMkLst>
            <pc:docMk/>
            <pc:sldMk cId="4258909056" sldId="273"/>
            <ac:graphicFrameMk id="50" creationId="{522607B4-A5AD-4FF1-AC2D-A99F0A605A46}"/>
          </ac:graphicFrameMkLst>
        </pc:graphicFrameChg>
        <pc:cxnChg chg="mod">
          <ac:chgData name="吉武 和敏" userId="e4825ba96748af9c" providerId="LiveId" clId="{917B18EA-CFD2-4842-A770-C54A8DAF286E}" dt="2020-11-30T06:00:54.154" v="975" actId="1076"/>
          <ac:cxnSpMkLst>
            <pc:docMk/>
            <pc:sldMk cId="4258909056" sldId="273"/>
            <ac:cxnSpMk id="36" creationId="{8B220AEE-A33E-4996-B38B-0476D3BB12BA}"/>
          </ac:cxnSpMkLst>
        </pc:cxnChg>
        <pc:cxnChg chg="mod">
          <ac:chgData name="吉武 和敏" userId="e4825ba96748af9c" providerId="LiveId" clId="{917B18EA-CFD2-4842-A770-C54A8DAF286E}" dt="2020-11-30T06:00:54.154" v="975" actId="1076"/>
          <ac:cxnSpMkLst>
            <pc:docMk/>
            <pc:sldMk cId="4258909056" sldId="273"/>
            <ac:cxnSpMk id="38" creationId="{C56B2F61-4493-4744-9F51-518A85FD179F}"/>
          </ac:cxnSpMkLst>
        </pc:cxnChg>
        <pc:cxnChg chg="mod">
          <ac:chgData name="吉武 和敏" userId="e4825ba96748af9c" providerId="LiveId" clId="{917B18EA-CFD2-4842-A770-C54A8DAF286E}" dt="2020-11-30T06:00:44.785" v="974" actId="14100"/>
          <ac:cxnSpMkLst>
            <pc:docMk/>
            <pc:sldMk cId="4258909056" sldId="273"/>
            <ac:cxnSpMk id="41" creationId="{7B8E4FD5-4C6A-446E-9622-3F2B6B06644F}"/>
          </ac:cxnSpMkLst>
        </pc:cxnChg>
        <pc:cxnChg chg="mod">
          <ac:chgData name="吉武 和敏" userId="e4825ba96748af9c" providerId="LiveId" clId="{917B18EA-CFD2-4842-A770-C54A8DAF286E}" dt="2020-11-30T06:00:12.740" v="969" actId="1076"/>
          <ac:cxnSpMkLst>
            <pc:docMk/>
            <pc:sldMk cId="4258909056" sldId="273"/>
            <ac:cxnSpMk id="46" creationId="{A52E26BD-DAF0-4CFC-811B-80745188B103}"/>
          </ac:cxnSpMkLst>
        </pc:cxnChg>
        <pc:cxnChg chg="mod">
          <ac:chgData name="吉武 和敏" userId="e4825ba96748af9c" providerId="LiveId" clId="{917B18EA-CFD2-4842-A770-C54A8DAF286E}" dt="2020-11-30T06:00:54.154" v="975" actId="1076"/>
          <ac:cxnSpMkLst>
            <pc:docMk/>
            <pc:sldMk cId="4258909056" sldId="273"/>
            <ac:cxnSpMk id="54" creationId="{E9242011-99BB-4C76-9B0A-CF4FBF309A90}"/>
          </ac:cxnSpMkLst>
        </pc:cxnChg>
      </pc:sldChg>
    </pc:docChg>
  </pc:docChgLst>
  <pc:docChgLst>
    <pc:chgData name="吉武 和敏" userId="e4825ba96748af9c" providerId="LiveId" clId="{1389A8F3-FAC1-5541-B449-D04816974178}"/>
    <pc:docChg chg="addSld modSld sldOrd">
      <pc:chgData name="吉武 和敏" userId="e4825ba96748af9c" providerId="LiveId" clId="{1389A8F3-FAC1-5541-B449-D04816974178}" dt="2022-01-25T13:55:11.730" v="94" actId="14100"/>
      <pc:docMkLst>
        <pc:docMk/>
      </pc:docMkLst>
      <pc:sldChg chg="modSp mod">
        <pc:chgData name="吉武 和敏" userId="e4825ba96748af9c" providerId="LiveId" clId="{1389A8F3-FAC1-5541-B449-D04816974178}" dt="2022-01-25T13:41:11.601" v="11" actId="20577"/>
        <pc:sldMkLst>
          <pc:docMk/>
          <pc:sldMk cId="789342450" sldId="256"/>
        </pc:sldMkLst>
        <pc:spChg chg="mod">
          <ac:chgData name="吉武 和敏" userId="e4825ba96748af9c" providerId="LiveId" clId="{1389A8F3-FAC1-5541-B449-D04816974178}" dt="2022-01-25T13:41:11.601" v="11" actId="20577"/>
          <ac:spMkLst>
            <pc:docMk/>
            <pc:sldMk cId="789342450" sldId="256"/>
            <ac:spMk id="107" creationId="{F9953033-7996-49BF-99C7-781199D3B854}"/>
          </ac:spMkLst>
        </pc:spChg>
      </pc:sldChg>
      <pc:sldChg chg="modSp mod">
        <pc:chgData name="吉武 和敏" userId="e4825ba96748af9c" providerId="LiveId" clId="{1389A8F3-FAC1-5541-B449-D04816974178}" dt="2022-01-25T13:41:08.331" v="9" actId="20577"/>
        <pc:sldMkLst>
          <pc:docMk/>
          <pc:sldMk cId="363600399" sldId="260"/>
        </pc:sldMkLst>
        <pc:spChg chg="mod">
          <ac:chgData name="吉武 和敏" userId="e4825ba96748af9c" providerId="LiveId" clId="{1389A8F3-FAC1-5541-B449-D04816974178}" dt="2022-01-25T13:41:08.331" v="9" actId="20577"/>
          <ac:spMkLst>
            <pc:docMk/>
            <pc:sldMk cId="363600399" sldId="260"/>
            <ac:spMk id="123" creationId="{C1963826-252C-4558-8BED-ABAB4DFC4E53}"/>
          </ac:spMkLst>
        </pc:spChg>
      </pc:sldChg>
      <pc:sldChg chg="modSp mod">
        <pc:chgData name="吉武 和敏" userId="e4825ba96748af9c" providerId="LiveId" clId="{1389A8F3-FAC1-5541-B449-D04816974178}" dt="2022-01-25T13:41:15.051" v="13" actId="20577"/>
        <pc:sldMkLst>
          <pc:docMk/>
          <pc:sldMk cId="1325269219" sldId="261"/>
        </pc:sldMkLst>
        <pc:spChg chg="mod">
          <ac:chgData name="吉武 和敏" userId="e4825ba96748af9c" providerId="LiveId" clId="{1389A8F3-FAC1-5541-B449-D04816974178}" dt="2022-01-25T13:41:15.051" v="13" actId="20577"/>
          <ac:spMkLst>
            <pc:docMk/>
            <pc:sldMk cId="1325269219" sldId="261"/>
            <ac:spMk id="5" creationId="{4E929D03-F61C-4BE2-8D6E-1383100473F1}"/>
          </ac:spMkLst>
        </pc:spChg>
      </pc:sldChg>
      <pc:sldChg chg="modSp mod">
        <pc:chgData name="吉武 和敏" userId="e4825ba96748af9c" providerId="LiveId" clId="{1389A8F3-FAC1-5541-B449-D04816974178}" dt="2022-01-25T13:41:18.786" v="15" actId="20577"/>
        <pc:sldMkLst>
          <pc:docMk/>
          <pc:sldMk cId="3154137531" sldId="262"/>
        </pc:sldMkLst>
        <pc:spChg chg="mod">
          <ac:chgData name="吉武 和敏" userId="e4825ba96748af9c" providerId="LiveId" clId="{1389A8F3-FAC1-5541-B449-D04816974178}" dt="2022-01-25T13:41:18.786" v="15" actId="20577"/>
          <ac:spMkLst>
            <pc:docMk/>
            <pc:sldMk cId="3154137531" sldId="262"/>
            <ac:spMk id="5" creationId="{14FFFE7E-BF1D-4F31-A560-01C53E89999D}"/>
          </ac:spMkLst>
        </pc:spChg>
      </pc:sldChg>
      <pc:sldChg chg="addSp modSp new mod ord">
        <pc:chgData name="吉武 和敏" userId="e4825ba96748af9c" providerId="LiveId" clId="{1389A8F3-FAC1-5541-B449-D04816974178}" dt="2022-01-25T13:55:11.730" v="94" actId="14100"/>
        <pc:sldMkLst>
          <pc:docMk/>
          <pc:sldMk cId="2341227745" sldId="264"/>
        </pc:sldMkLst>
        <pc:spChg chg="add mod">
          <ac:chgData name="吉武 和敏" userId="e4825ba96748af9c" providerId="LiveId" clId="{1389A8F3-FAC1-5541-B449-D04816974178}" dt="2022-01-25T13:55:09.199" v="93" actId="1076"/>
          <ac:spMkLst>
            <pc:docMk/>
            <pc:sldMk cId="2341227745" sldId="264"/>
            <ac:spMk id="4" creationId="{4CD95059-A079-6843-8516-3BCD3155570C}"/>
          </ac:spMkLst>
        </pc:spChg>
        <pc:picChg chg="add mod">
          <ac:chgData name="吉武 和敏" userId="e4825ba96748af9c" providerId="LiveId" clId="{1389A8F3-FAC1-5541-B449-D04816974178}" dt="2022-01-25T13:55:11.730" v="94" actId="14100"/>
          <ac:picMkLst>
            <pc:docMk/>
            <pc:sldMk cId="2341227745" sldId="264"/>
            <ac:picMk id="3" creationId="{99D4E84A-3734-D049-9D1A-9AC94ABD877A}"/>
          </ac:picMkLst>
        </pc:picChg>
      </pc:sldChg>
    </pc:docChg>
  </pc:docChgLst>
  <pc:docChgLst>
    <pc:chgData name="吉武 和敏" userId="e4825ba96748af9c" providerId="LiveId" clId="{CB4E927D-DF0B-4E7B-91FB-610C7F69B9A3}"/>
    <pc:docChg chg="modSld">
      <pc:chgData name="吉武 和敏" userId="e4825ba96748af9c" providerId="LiveId" clId="{CB4E927D-DF0B-4E7B-91FB-610C7F69B9A3}" dt="2021-11-18T10:15:33.687" v="13" actId="20577"/>
      <pc:docMkLst>
        <pc:docMk/>
      </pc:docMkLst>
      <pc:sldChg chg="modSp mod">
        <pc:chgData name="吉武 和敏" userId="e4825ba96748af9c" providerId="LiveId" clId="{CB4E927D-DF0B-4E7B-91FB-610C7F69B9A3}" dt="2021-11-18T10:15:26.566" v="9" actId="20577"/>
        <pc:sldMkLst>
          <pc:docMk/>
          <pc:sldMk cId="789342450" sldId="256"/>
        </pc:sldMkLst>
        <pc:spChg chg="mod">
          <ac:chgData name="吉武 和敏" userId="e4825ba96748af9c" providerId="LiveId" clId="{CB4E927D-DF0B-4E7B-91FB-610C7F69B9A3}" dt="2021-11-18T10:15:26.566" v="9" actId="20577"/>
          <ac:spMkLst>
            <pc:docMk/>
            <pc:sldMk cId="789342450" sldId="256"/>
            <ac:spMk id="107" creationId="{F9953033-7996-49BF-99C7-781199D3B854}"/>
          </ac:spMkLst>
        </pc:spChg>
      </pc:sldChg>
      <pc:sldChg chg="modSp mod">
        <pc:chgData name="吉武 和敏" userId="e4825ba96748af9c" providerId="LiveId" clId="{CB4E927D-DF0B-4E7B-91FB-610C7F69B9A3}" dt="2021-11-18T10:15:21.622" v="7" actId="20577"/>
        <pc:sldMkLst>
          <pc:docMk/>
          <pc:sldMk cId="363600399" sldId="260"/>
        </pc:sldMkLst>
        <pc:spChg chg="mod">
          <ac:chgData name="吉武 和敏" userId="e4825ba96748af9c" providerId="LiveId" clId="{CB4E927D-DF0B-4E7B-91FB-610C7F69B9A3}" dt="2021-11-18T10:15:21.622" v="7" actId="20577"/>
          <ac:spMkLst>
            <pc:docMk/>
            <pc:sldMk cId="363600399" sldId="260"/>
            <ac:spMk id="123" creationId="{C1963826-252C-4558-8BED-ABAB4DFC4E53}"/>
          </ac:spMkLst>
        </pc:spChg>
      </pc:sldChg>
      <pc:sldChg chg="modSp mod">
        <pc:chgData name="吉武 和敏" userId="e4825ba96748af9c" providerId="LiveId" clId="{CB4E927D-DF0B-4E7B-91FB-610C7F69B9A3}" dt="2021-11-18T10:15:30.294" v="11" actId="20577"/>
        <pc:sldMkLst>
          <pc:docMk/>
          <pc:sldMk cId="1325269219" sldId="261"/>
        </pc:sldMkLst>
        <pc:spChg chg="mod">
          <ac:chgData name="吉武 和敏" userId="e4825ba96748af9c" providerId="LiveId" clId="{CB4E927D-DF0B-4E7B-91FB-610C7F69B9A3}" dt="2021-11-18T10:15:30.294" v="11" actId="20577"/>
          <ac:spMkLst>
            <pc:docMk/>
            <pc:sldMk cId="1325269219" sldId="261"/>
            <ac:spMk id="5" creationId="{4E929D03-F61C-4BE2-8D6E-1383100473F1}"/>
          </ac:spMkLst>
        </pc:spChg>
      </pc:sldChg>
      <pc:sldChg chg="modSp mod">
        <pc:chgData name="吉武 和敏" userId="e4825ba96748af9c" providerId="LiveId" clId="{CB4E927D-DF0B-4E7B-91FB-610C7F69B9A3}" dt="2021-11-18T10:15:33.687" v="13" actId="20577"/>
        <pc:sldMkLst>
          <pc:docMk/>
          <pc:sldMk cId="3154137531" sldId="262"/>
        </pc:sldMkLst>
        <pc:spChg chg="mod">
          <ac:chgData name="吉武 和敏" userId="e4825ba96748af9c" providerId="LiveId" clId="{CB4E927D-DF0B-4E7B-91FB-610C7F69B9A3}" dt="2021-11-18T10:15:33.687" v="13" actId="20577"/>
          <ac:spMkLst>
            <pc:docMk/>
            <pc:sldMk cId="3154137531" sldId="262"/>
            <ac:spMk id="5" creationId="{14FFFE7E-BF1D-4F31-A560-01C53E89999D}"/>
          </ac:spMkLst>
        </pc:spChg>
      </pc:sldChg>
      <pc:sldChg chg="modSp mod">
        <pc:chgData name="吉武 和敏" userId="e4825ba96748af9c" providerId="LiveId" clId="{CB4E927D-DF0B-4E7B-91FB-610C7F69B9A3}" dt="2021-11-18T10:15:17.775" v="6" actId="1076"/>
        <pc:sldMkLst>
          <pc:docMk/>
          <pc:sldMk cId="2799955008" sldId="263"/>
        </pc:sldMkLst>
        <pc:spChg chg="mod">
          <ac:chgData name="吉武 和敏" userId="e4825ba96748af9c" providerId="LiveId" clId="{CB4E927D-DF0B-4E7B-91FB-610C7F69B9A3}" dt="2021-11-18T10:15:17.775" v="6" actId="1076"/>
          <ac:spMkLst>
            <pc:docMk/>
            <pc:sldMk cId="2799955008" sldId="263"/>
            <ac:spMk id="102" creationId="{20ACB979-61BC-4E66-ADB7-B41FEE5DDB6A}"/>
          </ac:spMkLst>
        </pc:spChg>
      </pc:sldChg>
    </pc:docChg>
  </pc:docChgLst>
  <pc:docChgLst>
    <pc:chgData name="吉武 和敏" userId="e4825ba96748af9c" providerId="LiveId" clId="{6B9200B1-37C2-4B74-9267-E1261847D757}"/>
    <pc:docChg chg="addSld modSld">
      <pc:chgData name="吉武 和敏" userId="e4825ba96748af9c" providerId="LiveId" clId="{6B9200B1-37C2-4B74-9267-E1261847D757}" dt="2021-11-15T08:31:44.648" v="0"/>
      <pc:docMkLst>
        <pc:docMk/>
      </pc:docMkLst>
      <pc:sldChg chg="add">
        <pc:chgData name="吉武 和敏" userId="e4825ba96748af9c" providerId="LiveId" clId="{6B9200B1-37C2-4B74-9267-E1261847D757}" dt="2021-11-15T08:31:44.648" v="0"/>
        <pc:sldMkLst>
          <pc:docMk/>
          <pc:sldMk cId="2799955008" sldId="263"/>
        </pc:sldMkLst>
      </pc:sldChg>
    </pc:docChg>
  </pc:docChgLst>
  <pc:docChgLst>
    <pc:chgData name="吉武 和敏" userId="e4825ba96748af9c" providerId="LiveId" clId="{FF564006-9E3C-48B0-A532-47AB0D2A5111}"/>
    <pc:docChg chg="undo custSel delSld modSld sldOrd">
      <pc:chgData name="吉武 和敏" userId="e4825ba96748af9c" providerId="LiveId" clId="{FF564006-9E3C-48B0-A532-47AB0D2A5111}" dt="2021-07-06T08:42:21.392" v="477" actId="47"/>
      <pc:docMkLst>
        <pc:docMk/>
      </pc:docMkLst>
      <pc:sldChg chg="addSp delSp modSp mod">
        <pc:chgData name="吉武 和敏" userId="e4825ba96748af9c" providerId="LiveId" clId="{FF564006-9E3C-48B0-A532-47AB0D2A5111}" dt="2021-07-06T08:41:04.271" v="476" actId="1076"/>
        <pc:sldMkLst>
          <pc:docMk/>
          <pc:sldMk cId="3224033489" sldId="264"/>
        </pc:sldMkLst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24" creationId="{E145D784-8ABC-4D9E-A207-9880020AB837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25" creationId="{6B3E17FF-A916-47D6-9DED-1A01C6837000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26" creationId="{AC86285D-28A8-4EE1-8066-F6CD373BAF12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27" creationId="{4F70FB24-5A05-494B-A06A-DE56A177A6E1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28" creationId="{FC633360-5069-46D9-8938-E9DF1CC5459B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30" creationId="{0350AAD5-720A-4558-9708-7C5FFEC80D1C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31" creationId="{C68BE3C8-155F-4BCE-AEF9-1D20915D7F2A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32" creationId="{6D16144D-010C-443E-ADAA-98373E4A6201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33" creationId="{584FDDB3-A153-4A03-8D21-E0E23E4D5CB2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34" creationId="{474E42A4-CCB2-4A65-9A00-24287EDC71A6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35" creationId="{93E1A1C0-4B00-4813-9788-4EAE74182289}"/>
          </ac:spMkLst>
        </pc:spChg>
        <pc:spChg chg="add mod">
          <ac:chgData name="吉武 和敏" userId="e4825ba96748af9c" providerId="LiveId" clId="{FF564006-9E3C-48B0-A532-47AB0D2A5111}" dt="2021-07-06T08:33:21.260" v="414" actId="1076"/>
          <ac:spMkLst>
            <pc:docMk/>
            <pc:sldMk cId="3224033489" sldId="264"/>
            <ac:spMk id="36" creationId="{5F3BEBC3-E8A9-453A-851D-0F3C0FB762CC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37" creationId="{7AF9C3F6-DDC4-4662-ACE0-28CB4AF1225A}"/>
          </ac:spMkLst>
        </pc:spChg>
        <pc:spChg chg="add mod">
          <ac:chgData name="吉武 和敏" userId="e4825ba96748af9c" providerId="LiveId" clId="{FF564006-9E3C-48B0-A532-47AB0D2A5111}" dt="2021-07-06T08:33:26.922" v="415" actId="20577"/>
          <ac:spMkLst>
            <pc:docMk/>
            <pc:sldMk cId="3224033489" sldId="264"/>
            <ac:spMk id="38" creationId="{779DD3FD-9522-42E4-A2A9-FA67C494B1A2}"/>
          </ac:spMkLst>
        </pc:spChg>
        <pc:spChg chg="add mod">
          <ac:chgData name="吉武 和敏" userId="e4825ba96748af9c" providerId="LiveId" clId="{FF564006-9E3C-48B0-A532-47AB0D2A5111}" dt="2021-07-06T08:33:18.034" v="413" actId="1076"/>
          <ac:spMkLst>
            <pc:docMk/>
            <pc:sldMk cId="3224033489" sldId="264"/>
            <ac:spMk id="39" creationId="{F3A85535-0CD4-4429-B7B0-70FB868EA4FF}"/>
          </ac:spMkLst>
        </pc:spChg>
        <pc:spChg chg="add mod">
          <ac:chgData name="吉武 和敏" userId="e4825ba96748af9c" providerId="LiveId" clId="{FF564006-9E3C-48B0-A532-47AB0D2A5111}" dt="2021-07-06T08:35:42.502" v="435" actId="14100"/>
          <ac:spMkLst>
            <pc:docMk/>
            <pc:sldMk cId="3224033489" sldId="264"/>
            <ac:spMk id="40" creationId="{6B56196B-0B95-40C3-9A3E-8CEFDFEBAE6E}"/>
          </ac:spMkLst>
        </pc:spChg>
        <pc:spChg chg="add mod">
          <ac:chgData name="吉武 和敏" userId="e4825ba96748af9c" providerId="LiveId" clId="{FF564006-9E3C-48B0-A532-47AB0D2A5111}" dt="2021-07-06T08:33:57.207" v="417" actId="14100"/>
          <ac:spMkLst>
            <pc:docMk/>
            <pc:sldMk cId="3224033489" sldId="264"/>
            <ac:spMk id="41" creationId="{F706F8D3-2B6E-4D98-9480-BF4CC3DE9AAF}"/>
          </ac:spMkLst>
        </pc:spChg>
        <pc:spChg chg="add del mod">
          <ac:chgData name="吉武 和敏" userId="e4825ba96748af9c" providerId="LiveId" clId="{FF564006-9E3C-48B0-A532-47AB0D2A5111}" dt="2021-07-06T08:33:03.179" v="410" actId="478"/>
          <ac:spMkLst>
            <pc:docMk/>
            <pc:sldMk cId="3224033489" sldId="264"/>
            <ac:spMk id="42" creationId="{572E5836-833B-4D43-88DE-0FFDEAA904BB}"/>
          </ac:spMkLst>
        </pc:spChg>
        <pc:spChg chg="add del mod">
          <ac:chgData name="吉武 和敏" userId="e4825ba96748af9c" providerId="LiveId" clId="{FF564006-9E3C-48B0-A532-47AB0D2A5111}" dt="2021-07-06T08:35:50.058" v="436" actId="478"/>
          <ac:spMkLst>
            <pc:docMk/>
            <pc:sldMk cId="3224033489" sldId="264"/>
            <ac:spMk id="43" creationId="{E40AD398-35E2-4887-915E-6CE9923C837E}"/>
          </ac:spMkLst>
        </pc:spChg>
        <pc:spChg chg="add mod">
          <ac:chgData name="吉武 和敏" userId="e4825ba96748af9c" providerId="LiveId" clId="{FF564006-9E3C-48B0-A532-47AB0D2A5111}" dt="2021-07-06T08:34:43.307" v="418" actId="571"/>
          <ac:spMkLst>
            <pc:docMk/>
            <pc:sldMk cId="3224033489" sldId="264"/>
            <ac:spMk id="44" creationId="{79AE0FCE-5C04-4EA6-9154-7BD8D4EA1BA6}"/>
          </ac:spMkLst>
        </pc:spChg>
        <pc:spChg chg="add mod">
          <ac:chgData name="吉武 和敏" userId="e4825ba96748af9c" providerId="LiveId" clId="{FF564006-9E3C-48B0-A532-47AB0D2A5111}" dt="2021-07-06T08:35:11.062" v="422" actId="14100"/>
          <ac:spMkLst>
            <pc:docMk/>
            <pc:sldMk cId="3224033489" sldId="264"/>
            <ac:spMk id="45" creationId="{E5584DE1-23C2-4F07-ABC3-F3AF6A12618A}"/>
          </ac:spMkLst>
        </pc:spChg>
        <pc:spChg chg="add mod">
          <ac:chgData name="吉武 和敏" userId="e4825ba96748af9c" providerId="LiveId" clId="{FF564006-9E3C-48B0-A532-47AB0D2A5111}" dt="2021-07-06T08:34:43.307" v="418" actId="571"/>
          <ac:spMkLst>
            <pc:docMk/>
            <pc:sldMk cId="3224033489" sldId="264"/>
            <ac:spMk id="46" creationId="{6BCA01D6-6DF9-452A-A715-9608DB6021F8}"/>
          </ac:spMkLst>
        </pc:spChg>
        <pc:spChg chg="add mod">
          <ac:chgData name="吉武 和敏" userId="e4825ba96748af9c" providerId="LiveId" clId="{FF564006-9E3C-48B0-A532-47AB0D2A5111}" dt="2021-07-06T08:35:08.391" v="421" actId="14100"/>
          <ac:spMkLst>
            <pc:docMk/>
            <pc:sldMk cId="3224033489" sldId="264"/>
            <ac:spMk id="47" creationId="{24DBB554-D048-4E8A-A769-ED957F0835CA}"/>
          </ac:spMkLst>
        </pc:spChg>
        <pc:spChg chg="add del mod">
          <ac:chgData name="吉武 和敏" userId="e4825ba96748af9c" providerId="LiveId" clId="{FF564006-9E3C-48B0-A532-47AB0D2A5111}" dt="2021-07-06T08:35:50.058" v="436" actId="478"/>
          <ac:spMkLst>
            <pc:docMk/>
            <pc:sldMk cId="3224033489" sldId="264"/>
            <ac:spMk id="48" creationId="{97DED0BD-EA99-4386-8746-E615B3CE97B6}"/>
          </ac:spMkLst>
        </pc:spChg>
        <pc:spChg chg="add mod">
          <ac:chgData name="吉武 和敏" userId="e4825ba96748af9c" providerId="LiveId" clId="{FF564006-9E3C-48B0-A532-47AB0D2A5111}" dt="2021-07-06T08:34:57.173" v="419" actId="14100"/>
          <ac:spMkLst>
            <pc:docMk/>
            <pc:sldMk cId="3224033489" sldId="264"/>
            <ac:spMk id="49" creationId="{156C603D-99D4-45E6-98BD-93EBAB9ABAF7}"/>
          </ac:spMkLst>
        </pc:spChg>
        <pc:spChg chg="add del mod">
          <ac:chgData name="吉武 和敏" userId="e4825ba96748af9c" providerId="LiveId" clId="{FF564006-9E3C-48B0-A532-47AB0D2A5111}" dt="2021-07-06T08:35:50.058" v="436" actId="478"/>
          <ac:spMkLst>
            <pc:docMk/>
            <pc:sldMk cId="3224033489" sldId="264"/>
            <ac:spMk id="50" creationId="{81464658-A17E-4322-BEEC-1C38A0A8DD5D}"/>
          </ac:spMkLst>
        </pc:spChg>
        <pc:spChg chg="add mod">
          <ac:chgData name="吉武 和敏" userId="e4825ba96748af9c" providerId="LiveId" clId="{FF564006-9E3C-48B0-A532-47AB0D2A5111}" dt="2021-07-06T08:35:54.901" v="437" actId="571"/>
          <ac:spMkLst>
            <pc:docMk/>
            <pc:sldMk cId="3224033489" sldId="264"/>
            <ac:spMk id="51" creationId="{F0E29B9C-6C80-44EE-A2EE-6557A85093E2}"/>
          </ac:spMkLst>
        </pc:spChg>
        <pc:spChg chg="add mod">
          <ac:chgData name="吉武 和敏" userId="e4825ba96748af9c" providerId="LiveId" clId="{FF564006-9E3C-48B0-A532-47AB0D2A5111}" dt="2021-07-06T08:35:57.455" v="438" actId="571"/>
          <ac:spMkLst>
            <pc:docMk/>
            <pc:sldMk cId="3224033489" sldId="264"/>
            <ac:spMk id="52" creationId="{B0869283-8CBB-452C-A1F7-0ACE475D338D}"/>
          </ac:spMkLst>
        </pc:spChg>
        <pc:spChg chg="add mod">
          <ac:chgData name="吉武 和敏" userId="e4825ba96748af9c" providerId="LiveId" clId="{FF564006-9E3C-48B0-A532-47AB0D2A5111}" dt="2021-07-06T08:35:59.781" v="439" actId="571"/>
          <ac:spMkLst>
            <pc:docMk/>
            <pc:sldMk cId="3224033489" sldId="264"/>
            <ac:spMk id="53" creationId="{76AEDE97-2E91-461E-8731-3E307C8612FD}"/>
          </ac:spMkLst>
        </pc:spChg>
        <pc:spChg chg="add mod">
          <ac:chgData name="吉武 和敏" userId="e4825ba96748af9c" providerId="LiveId" clId="{FF564006-9E3C-48B0-A532-47AB0D2A5111}" dt="2021-07-06T08:40:56.309" v="473" actId="1076"/>
          <ac:spMkLst>
            <pc:docMk/>
            <pc:sldMk cId="3224033489" sldId="264"/>
            <ac:spMk id="54" creationId="{C08F20CC-5894-4BB3-8F65-6A6877F73453}"/>
          </ac:spMkLst>
        </pc:spChg>
        <pc:spChg chg="add mod">
          <ac:chgData name="吉武 和敏" userId="e4825ba96748af9c" providerId="LiveId" clId="{FF564006-9E3C-48B0-A532-47AB0D2A5111}" dt="2021-07-06T08:41:04.271" v="476" actId="1076"/>
          <ac:spMkLst>
            <pc:docMk/>
            <pc:sldMk cId="3224033489" sldId="264"/>
            <ac:spMk id="55" creationId="{19E89654-2188-4A4C-B040-7332F9204432}"/>
          </ac:spMkLst>
        </pc:spChg>
        <pc:graphicFrameChg chg="add mod">
          <ac:chgData name="吉武 和敏" userId="e4825ba96748af9c" providerId="LiveId" clId="{FF564006-9E3C-48B0-A532-47AB0D2A5111}" dt="2021-07-06T08:40:12.528" v="454" actId="403"/>
          <ac:graphicFrameMkLst>
            <pc:docMk/>
            <pc:sldMk cId="3224033489" sldId="264"/>
            <ac:graphicFrameMk id="29" creationId="{E76714DF-90E0-49C7-A905-CAB7E23899D0}"/>
          </ac:graphicFrameMkLst>
        </pc:graphicFrameChg>
        <pc:picChg chg="add del mod modCrop">
          <ac:chgData name="吉武 和敏" userId="e4825ba96748af9c" providerId="LiveId" clId="{FF564006-9E3C-48B0-A532-47AB0D2A5111}" dt="2021-07-06T08:09:37.409" v="217" actId="478"/>
          <ac:picMkLst>
            <pc:docMk/>
            <pc:sldMk cId="3224033489" sldId="264"/>
            <ac:picMk id="3" creationId="{BE656435-FBEB-43C6-8F40-8E627A840DEC}"/>
          </ac:picMkLst>
        </pc:picChg>
        <pc:picChg chg="add del mod modCrop">
          <ac:chgData name="吉武 和敏" userId="e4825ba96748af9c" providerId="LiveId" clId="{FF564006-9E3C-48B0-A532-47AB0D2A5111}" dt="2021-07-06T08:09:37.409" v="217" actId="478"/>
          <ac:picMkLst>
            <pc:docMk/>
            <pc:sldMk cId="3224033489" sldId="264"/>
            <ac:picMk id="5" creationId="{2F194EA0-EF4C-41D8-8767-610A9A9B179B}"/>
          </ac:picMkLst>
        </pc:picChg>
        <pc:picChg chg="add del mod modCrop">
          <ac:chgData name="吉武 和敏" userId="e4825ba96748af9c" providerId="LiveId" clId="{FF564006-9E3C-48B0-A532-47AB0D2A5111}" dt="2021-07-06T08:09:37.409" v="217" actId="478"/>
          <ac:picMkLst>
            <pc:docMk/>
            <pc:sldMk cId="3224033489" sldId="264"/>
            <ac:picMk id="7" creationId="{F6A2D71E-66BF-49DA-8E64-73395179E2B5}"/>
          </ac:picMkLst>
        </pc:picChg>
        <pc:picChg chg="add del mod modCrop">
          <ac:chgData name="吉武 和敏" userId="e4825ba96748af9c" providerId="LiveId" clId="{FF564006-9E3C-48B0-A532-47AB0D2A5111}" dt="2021-07-06T08:09:37.409" v="217" actId="478"/>
          <ac:picMkLst>
            <pc:docMk/>
            <pc:sldMk cId="3224033489" sldId="264"/>
            <ac:picMk id="9" creationId="{92630D69-C2FC-4978-A5A8-6E7125C63F76}"/>
          </ac:picMkLst>
        </pc:picChg>
        <pc:picChg chg="add del mod modCrop">
          <ac:chgData name="吉武 和敏" userId="e4825ba96748af9c" providerId="LiveId" clId="{FF564006-9E3C-48B0-A532-47AB0D2A5111}" dt="2021-07-06T08:09:37.409" v="217" actId="478"/>
          <ac:picMkLst>
            <pc:docMk/>
            <pc:sldMk cId="3224033489" sldId="264"/>
            <ac:picMk id="11" creationId="{79A556B6-BBC9-418A-9F80-6AA6ABC70507}"/>
          </ac:picMkLst>
        </pc:picChg>
        <pc:picChg chg="add del mod">
          <ac:chgData name="吉武 和敏" userId="e4825ba96748af9c" providerId="LiveId" clId="{FF564006-9E3C-48B0-A532-47AB0D2A5111}" dt="2021-07-06T08:09:36.017" v="216" actId="478"/>
          <ac:picMkLst>
            <pc:docMk/>
            <pc:sldMk cId="3224033489" sldId="264"/>
            <ac:picMk id="13" creationId="{F9113EF6-4EC7-4577-918E-55BC49B2F0F4}"/>
          </ac:picMkLst>
        </pc:picChg>
        <pc:picChg chg="add mod modCrop">
          <ac:chgData name="吉武 和敏" userId="e4825ba96748af9c" providerId="LiveId" clId="{FF564006-9E3C-48B0-A532-47AB0D2A5111}" dt="2021-07-06T08:33:18.034" v="413" actId="1076"/>
          <ac:picMkLst>
            <pc:docMk/>
            <pc:sldMk cId="3224033489" sldId="264"/>
            <ac:picMk id="15" creationId="{624FFF3F-B645-4C3F-BF79-D40950772903}"/>
          </ac:picMkLst>
        </pc:picChg>
        <pc:picChg chg="add mod modCrop">
          <ac:chgData name="吉武 和敏" userId="e4825ba96748af9c" providerId="LiveId" clId="{FF564006-9E3C-48B0-A532-47AB0D2A5111}" dt="2021-07-06T08:33:18.034" v="413" actId="1076"/>
          <ac:picMkLst>
            <pc:docMk/>
            <pc:sldMk cId="3224033489" sldId="264"/>
            <ac:picMk id="17" creationId="{6CEB347F-26C5-4917-8A5F-A54E7B7E3E1C}"/>
          </ac:picMkLst>
        </pc:picChg>
        <pc:picChg chg="add mod modCrop">
          <ac:chgData name="吉武 和敏" userId="e4825ba96748af9c" providerId="LiveId" clId="{FF564006-9E3C-48B0-A532-47AB0D2A5111}" dt="2021-07-06T08:33:18.034" v="413" actId="1076"/>
          <ac:picMkLst>
            <pc:docMk/>
            <pc:sldMk cId="3224033489" sldId="264"/>
            <ac:picMk id="19" creationId="{0FF0336F-CE80-4F30-B6C2-5E1351D257E6}"/>
          </ac:picMkLst>
        </pc:picChg>
        <pc:picChg chg="add mod modCrop">
          <ac:chgData name="吉武 和敏" userId="e4825ba96748af9c" providerId="LiveId" clId="{FF564006-9E3C-48B0-A532-47AB0D2A5111}" dt="2021-07-06T08:33:18.034" v="413" actId="1076"/>
          <ac:picMkLst>
            <pc:docMk/>
            <pc:sldMk cId="3224033489" sldId="264"/>
            <ac:picMk id="21" creationId="{B411F340-242B-43F8-AFDF-DF550EA271AF}"/>
          </ac:picMkLst>
        </pc:picChg>
        <pc:picChg chg="add mod modCrop">
          <ac:chgData name="吉武 和敏" userId="e4825ba96748af9c" providerId="LiveId" clId="{FF564006-9E3C-48B0-A532-47AB0D2A5111}" dt="2021-07-06T08:33:18.034" v="413" actId="1076"/>
          <ac:picMkLst>
            <pc:docMk/>
            <pc:sldMk cId="3224033489" sldId="264"/>
            <ac:picMk id="23" creationId="{C8ABEAEB-F052-4923-932A-B290576455EF}"/>
          </ac:picMkLst>
        </pc:picChg>
      </pc:sldChg>
      <pc:sldChg chg="del">
        <pc:chgData name="吉武 和敏" userId="e4825ba96748af9c" providerId="LiveId" clId="{FF564006-9E3C-48B0-A532-47AB0D2A5111}" dt="2021-07-06T08:42:21.392" v="477" actId="47"/>
        <pc:sldMkLst>
          <pc:docMk/>
          <pc:sldMk cId="3416928354" sldId="265"/>
        </pc:sldMkLst>
      </pc:sldChg>
      <pc:sldChg chg="del">
        <pc:chgData name="吉武 和敏" userId="e4825ba96748af9c" providerId="LiveId" clId="{FF564006-9E3C-48B0-A532-47AB0D2A5111}" dt="2021-07-06T08:42:21.392" v="477" actId="47"/>
        <pc:sldMkLst>
          <pc:docMk/>
          <pc:sldMk cId="2939933543" sldId="266"/>
        </pc:sldMkLst>
      </pc:sldChg>
      <pc:sldChg chg="del">
        <pc:chgData name="吉武 和敏" userId="e4825ba96748af9c" providerId="LiveId" clId="{FF564006-9E3C-48B0-A532-47AB0D2A5111}" dt="2021-07-06T08:42:21.392" v="477" actId="47"/>
        <pc:sldMkLst>
          <pc:docMk/>
          <pc:sldMk cId="1133899879" sldId="267"/>
        </pc:sldMkLst>
      </pc:sldChg>
      <pc:sldChg chg="addSp delSp modSp mod">
        <pc:chgData name="吉武 和敏" userId="e4825ba96748af9c" providerId="LiveId" clId="{FF564006-9E3C-48B0-A532-47AB0D2A5111}" dt="2021-07-06T05:45:12.683" v="143"/>
        <pc:sldMkLst>
          <pc:docMk/>
          <pc:sldMk cId="1537217434" sldId="268"/>
        </pc:sldMkLst>
        <pc:spChg chg="mod topLvl">
          <ac:chgData name="吉武 和敏" userId="e4825ba96748af9c" providerId="LiveId" clId="{FF564006-9E3C-48B0-A532-47AB0D2A5111}" dt="2021-07-06T05:45:01.124" v="140" actId="165"/>
          <ac:spMkLst>
            <pc:docMk/>
            <pc:sldMk cId="1537217434" sldId="268"/>
            <ac:spMk id="6" creationId="{04D12FBF-3231-4338-9052-1CED4ED424EF}"/>
          </ac:spMkLst>
        </pc:spChg>
        <pc:spChg chg="mod topLvl">
          <ac:chgData name="吉武 和敏" userId="e4825ba96748af9c" providerId="LiveId" clId="{FF564006-9E3C-48B0-A532-47AB0D2A5111}" dt="2021-07-06T05:45:01.124" v="140" actId="165"/>
          <ac:spMkLst>
            <pc:docMk/>
            <pc:sldMk cId="1537217434" sldId="268"/>
            <ac:spMk id="9" creationId="{EBCD9017-A999-42F6-B40E-7B8C2815DB33}"/>
          </ac:spMkLst>
        </pc:spChg>
        <pc:spChg chg="mod topLvl">
          <ac:chgData name="吉武 和敏" userId="e4825ba96748af9c" providerId="LiveId" clId="{FF564006-9E3C-48B0-A532-47AB0D2A5111}" dt="2021-07-06T05:45:01.124" v="140" actId="165"/>
          <ac:spMkLst>
            <pc:docMk/>
            <pc:sldMk cId="1537217434" sldId="268"/>
            <ac:spMk id="10" creationId="{FAC684E9-FE4D-4F45-9F64-33F4AFA3392D}"/>
          </ac:spMkLst>
        </pc:spChg>
        <pc:spChg chg="del">
          <ac:chgData name="吉武 和敏" userId="e4825ba96748af9c" providerId="LiveId" clId="{FF564006-9E3C-48B0-A532-47AB0D2A5111}" dt="2021-07-05T09:24:01.262" v="4" actId="478"/>
          <ac:spMkLst>
            <pc:docMk/>
            <pc:sldMk cId="1537217434" sldId="268"/>
            <ac:spMk id="11" creationId="{950A1099-10EC-4285-B16C-ED78B1FA0AAD}"/>
          </ac:spMkLst>
        </pc:spChg>
        <pc:spChg chg="del">
          <ac:chgData name="吉武 和敏" userId="e4825ba96748af9c" providerId="LiveId" clId="{FF564006-9E3C-48B0-A532-47AB0D2A5111}" dt="2021-07-05T09:23:35.648" v="0" actId="478"/>
          <ac:spMkLst>
            <pc:docMk/>
            <pc:sldMk cId="1537217434" sldId="268"/>
            <ac:spMk id="13" creationId="{BC806B60-0C85-44D6-8103-61AD709823FC}"/>
          </ac:spMkLst>
        </pc:spChg>
        <pc:spChg chg="mod topLvl">
          <ac:chgData name="吉武 和敏" userId="e4825ba96748af9c" providerId="LiveId" clId="{FF564006-9E3C-48B0-A532-47AB0D2A5111}" dt="2021-07-06T05:45:01.124" v="140" actId="165"/>
          <ac:spMkLst>
            <pc:docMk/>
            <pc:sldMk cId="1537217434" sldId="268"/>
            <ac:spMk id="20" creationId="{8DAFAC2D-45A5-4E46-A964-C8D1DA5813EB}"/>
          </ac:spMkLst>
        </pc:spChg>
        <pc:spChg chg="mod ord topLvl">
          <ac:chgData name="吉武 和敏" userId="e4825ba96748af9c" providerId="LiveId" clId="{FF564006-9E3C-48B0-A532-47AB0D2A5111}" dt="2021-07-06T05:45:12.683" v="143"/>
          <ac:spMkLst>
            <pc:docMk/>
            <pc:sldMk cId="1537217434" sldId="268"/>
            <ac:spMk id="25" creationId="{94B65CDC-AE77-4474-BDE5-C70956C5B226}"/>
          </ac:spMkLst>
        </pc:spChg>
        <pc:spChg chg="del">
          <ac:chgData name="吉武 和敏" userId="e4825ba96748af9c" providerId="LiveId" clId="{FF564006-9E3C-48B0-A532-47AB0D2A5111}" dt="2021-07-05T09:23:36.782" v="1" actId="478"/>
          <ac:spMkLst>
            <pc:docMk/>
            <pc:sldMk cId="1537217434" sldId="268"/>
            <ac:spMk id="30" creationId="{A277B64C-5625-4958-9955-D1E21525E82A}"/>
          </ac:spMkLst>
        </pc:spChg>
        <pc:spChg chg="mod topLvl">
          <ac:chgData name="吉武 和敏" userId="e4825ba96748af9c" providerId="LiveId" clId="{FF564006-9E3C-48B0-A532-47AB0D2A5111}" dt="2021-07-06T05:45:01.124" v="140" actId="165"/>
          <ac:spMkLst>
            <pc:docMk/>
            <pc:sldMk cId="1537217434" sldId="268"/>
            <ac:spMk id="36" creationId="{2F9BA13E-7223-4ECD-9B29-3F6EB6C2FE13}"/>
          </ac:spMkLst>
        </pc:spChg>
        <pc:spChg chg="mod topLvl">
          <ac:chgData name="吉武 和敏" userId="e4825ba96748af9c" providerId="LiveId" clId="{FF564006-9E3C-48B0-A532-47AB0D2A5111}" dt="2021-07-06T05:45:01.124" v="140" actId="165"/>
          <ac:spMkLst>
            <pc:docMk/>
            <pc:sldMk cId="1537217434" sldId="268"/>
            <ac:spMk id="42" creationId="{EDE83F1B-858B-44FE-A980-104E84C32A47}"/>
          </ac:spMkLst>
        </pc:spChg>
        <pc:spChg chg="mod topLvl">
          <ac:chgData name="吉武 和敏" userId="e4825ba96748af9c" providerId="LiveId" clId="{FF564006-9E3C-48B0-A532-47AB0D2A5111}" dt="2021-07-06T05:45:01.124" v="140" actId="165"/>
          <ac:spMkLst>
            <pc:docMk/>
            <pc:sldMk cId="1537217434" sldId="268"/>
            <ac:spMk id="43" creationId="{9C2A2AD8-D0E6-410D-932A-0B1629E441F1}"/>
          </ac:spMkLst>
        </pc:spChg>
        <pc:grpChg chg="add del mod">
          <ac:chgData name="吉武 和敏" userId="e4825ba96748af9c" providerId="LiveId" clId="{FF564006-9E3C-48B0-A532-47AB0D2A5111}" dt="2021-07-06T05:45:01.124" v="140" actId="165"/>
          <ac:grpSpMkLst>
            <pc:docMk/>
            <pc:sldMk cId="1537217434" sldId="268"/>
            <ac:grpSpMk id="2" creationId="{9F19415A-EE45-4E2E-BA89-8503D402F5E2}"/>
          </ac:grpSpMkLst>
        </pc:grpChg>
        <pc:picChg chg="mod topLvl">
          <ac:chgData name="吉武 和敏" userId="e4825ba96748af9c" providerId="LiveId" clId="{FF564006-9E3C-48B0-A532-47AB0D2A5111}" dt="2021-07-06T05:45:01.124" v="140" actId="165"/>
          <ac:picMkLst>
            <pc:docMk/>
            <pc:sldMk cId="1537217434" sldId="268"/>
            <ac:picMk id="3" creationId="{3C6369F5-6930-4578-8BDF-0040EB2E25CD}"/>
          </ac:picMkLst>
        </pc:picChg>
        <pc:picChg chg="mod topLvl">
          <ac:chgData name="吉武 和敏" userId="e4825ba96748af9c" providerId="LiveId" clId="{FF564006-9E3C-48B0-A532-47AB0D2A5111}" dt="2021-07-06T05:45:01.124" v="140" actId="165"/>
          <ac:picMkLst>
            <pc:docMk/>
            <pc:sldMk cId="1537217434" sldId="268"/>
            <ac:picMk id="35" creationId="{78A1C322-5D4E-4BAA-BF26-F707E4387723}"/>
          </ac:picMkLst>
        </pc:picChg>
        <pc:cxnChg chg="del">
          <ac:chgData name="吉武 和敏" userId="e4825ba96748af9c" providerId="LiveId" clId="{FF564006-9E3C-48B0-A532-47AB0D2A5111}" dt="2021-07-05T09:23:41.502" v="2" actId="478"/>
          <ac:cxnSpMkLst>
            <pc:docMk/>
            <pc:sldMk cId="1537217434" sldId="268"/>
            <ac:cxnSpMk id="14" creationId="{335A9AAC-9C70-4DDC-BD76-5C42EF4D59D5}"/>
          </ac:cxnSpMkLst>
        </pc:cxnChg>
        <pc:cxnChg chg="mod topLvl">
          <ac:chgData name="吉武 和敏" userId="e4825ba96748af9c" providerId="LiveId" clId="{FF564006-9E3C-48B0-A532-47AB0D2A5111}" dt="2021-07-06T05:45:01.124" v="140" actId="165"/>
          <ac:cxnSpMkLst>
            <pc:docMk/>
            <pc:sldMk cId="1537217434" sldId="268"/>
            <ac:cxnSpMk id="37" creationId="{24B3AE51-9F08-480E-BBE0-B706248DF4D6}"/>
          </ac:cxnSpMkLst>
        </pc:cxnChg>
        <pc:cxnChg chg="mod topLvl">
          <ac:chgData name="吉武 和敏" userId="e4825ba96748af9c" providerId="LiveId" clId="{FF564006-9E3C-48B0-A532-47AB0D2A5111}" dt="2021-07-06T05:45:01.124" v="140" actId="165"/>
          <ac:cxnSpMkLst>
            <pc:docMk/>
            <pc:sldMk cId="1537217434" sldId="268"/>
            <ac:cxnSpMk id="38" creationId="{4BFAD1CA-8167-4FC1-9A79-37D65FDBD7D4}"/>
          </ac:cxnSpMkLst>
        </pc:cxnChg>
      </pc:sldChg>
      <pc:sldChg chg="delSp modSp del mod ord">
        <pc:chgData name="吉武 和敏" userId="e4825ba96748af9c" providerId="LiveId" clId="{FF564006-9E3C-48B0-A532-47AB0D2A5111}" dt="2021-07-06T08:36:27.356" v="440" actId="47"/>
        <pc:sldMkLst>
          <pc:docMk/>
          <pc:sldMk cId="1077170640" sldId="269"/>
        </pc:sldMkLst>
        <pc:spChg chg="del mod">
          <ac:chgData name="吉武 和敏" userId="e4825ba96748af9c" providerId="LiveId" clId="{FF564006-9E3C-48B0-A532-47AB0D2A5111}" dt="2021-07-05T09:29:59.328" v="119"/>
          <ac:spMkLst>
            <pc:docMk/>
            <pc:sldMk cId="1077170640" sldId="269"/>
            <ac:spMk id="4" creationId="{042E00E0-A931-4C88-A744-693765335ACD}"/>
          </ac:spMkLst>
        </pc:spChg>
        <pc:spChg chg="mod">
          <ac:chgData name="吉武 和敏" userId="e4825ba96748af9c" providerId="LiveId" clId="{FF564006-9E3C-48B0-A532-47AB0D2A5111}" dt="2021-07-05T09:30:57.741" v="130" actId="20577"/>
          <ac:spMkLst>
            <pc:docMk/>
            <pc:sldMk cId="1077170640" sldId="269"/>
            <ac:spMk id="5" creationId="{CA02D7E8-D0E8-452D-A558-7C2B46F4AFB9}"/>
          </ac:spMkLst>
        </pc:spChg>
        <pc:spChg chg="mod">
          <ac:chgData name="吉武 和敏" userId="e4825ba96748af9c" providerId="LiveId" clId="{FF564006-9E3C-48B0-A532-47AB0D2A5111}" dt="2021-07-05T09:30:06.901" v="121" actId="1076"/>
          <ac:spMkLst>
            <pc:docMk/>
            <pc:sldMk cId="1077170640" sldId="269"/>
            <ac:spMk id="6" creationId="{2E7E78A3-CF86-4247-B49A-DFA18002B40C}"/>
          </ac:spMkLst>
        </pc:spChg>
        <pc:spChg chg="mod">
          <ac:chgData name="吉武 和敏" userId="e4825ba96748af9c" providerId="LiveId" clId="{FF564006-9E3C-48B0-A532-47AB0D2A5111}" dt="2021-07-05T09:30:06.901" v="121" actId="1076"/>
          <ac:spMkLst>
            <pc:docMk/>
            <pc:sldMk cId="1077170640" sldId="269"/>
            <ac:spMk id="7" creationId="{7A9CF69F-7920-4293-B1F1-B9F763D8E8D5}"/>
          </ac:spMkLst>
        </pc:spChg>
        <pc:spChg chg="mod">
          <ac:chgData name="吉武 和敏" userId="e4825ba96748af9c" providerId="LiveId" clId="{FF564006-9E3C-48B0-A532-47AB0D2A5111}" dt="2021-07-05T09:30:06.901" v="121" actId="1076"/>
          <ac:spMkLst>
            <pc:docMk/>
            <pc:sldMk cId="1077170640" sldId="269"/>
            <ac:spMk id="8" creationId="{6034EC90-5E40-4740-886C-76CE8B8AC83A}"/>
          </ac:spMkLst>
        </pc:spChg>
        <pc:spChg chg="mod">
          <ac:chgData name="吉武 和敏" userId="e4825ba96748af9c" providerId="LiveId" clId="{FF564006-9E3C-48B0-A532-47AB0D2A5111}" dt="2021-07-05T09:30:06.901" v="121" actId="1076"/>
          <ac:spMkLst>
            <pc:docMk/>
            <pc:sldMk cId="1077170640" sldId="269"/>
            <ac:spMk id="9" creationId="{CDD63B90-BACD-4092-BE69-5F52071A0859}"/>
          </ac:spMkLst>
        </pc:spChg>
        <pc:picChg chg="mod">
          <ac:chgData name="吉武 和敏" userId="e4825ba96748af9c" providerId="LiveId" clId="{FF564006-9E3C-48B0-A532-47AB0D2A5111}" dt="2021-07-05T09:30:06.901" v="121" actId="1076"/>
          <ac:picMkLst>
            <pc:docMk/>
            <pc:sldMk cId="1077170640" sldId="269"/>
            <ac:picMk id="3" creationId="{58562A30-9D25-4B54-9DC2-3BBFD6448F8C}"/>
          </ac:picMkLst>
        </pc:picChg>
      </pc:sldChg>
      <pc:sldChg chg="addSp delSp modSp del mod">
        <pc:chgData name="吉武 和敏" userId="e4825ba96748af9c" providerId="LiveId" clId="{FF564006-9E3C-48B0-A532-47AB0D2A5111}" dt="2021-07-06T08:36:27.356" v="440" actId="47"/>
        <pc:sldMkLst>
          <pc:docMk/>
          <pc:sldMk cId="2690405455" sldId="270"/>
        </pc:sldMkLst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2" creationId="{997382DA-BEFA-49BC-862C-708E462F4366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6" creationId="{2935A97F-A62D-4C66-A797-7D2E90E05D1E}"/>
          </ac:spMkLst>
        </pc:spChg>
        <pc:spChg chg="mod topLvl">
          <ac:chgData name="吉武 和敏" userId="e4825ba96748af9c" providerId="LiveId" clId="{FF564006-9E3C-48B0-A532-47AB0D2A5111}" dt="2021-07-05T09:31:52.413" v="138" actId="164"/>
          <ac:spMkLst>
            <pc:docMk/>
            <pc:sldMk cId="2690405455" sldId="270"/>
            <ac:spMk id="8" creationId="{4D6365E5-2E48-429D-A9D8-939862B6DD0A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12" creationId="{A125914F-BADF-4BCC-9951-363DD5B2A8FA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13" creationId="{1449545F-DC19-44BB-8B06-51820AB4A5CC}"/>
          </ac:spMkLst>
        </pc:spChg>
        <pc:spChg chg="mod">
          <ac:chgData name="吉武 和敏" userId="e4825ba96748af9c" providerId="LiveId" clId="{FF564006-9E3C-48B0-A532-47AB0D2A5111}" dt="2021-07-05T09:31:43.012" v="136" actId="1076"/>
          <ac:spMkLst>
            <pc:docMk/>
            <pc:sldMk cId="2690405455" sldId="270"/>
            <ac:spMk id="14" creationId="{46CD69A5-684A-4086-A30B-C8A6B5B808E5}"/>
          </ac:spMkLst>
        </pc:spChg>
        <pc:spChg chg="mod">
          <ac:chgData name="吉武 和敏" userId="e4825ba96748af9c" providerId="LiveId" clId="{FF564006-9E3C-48B0-A532-47AB0D2A5111}" dt="2021-07-05T09:31:19.168" v="133" actId="1076"/>
          <ac:spMkLst>
            <pc:docMk/>
            <pc:sldMk cId="2690405455" sldId="270"/>
            <ac:spMk id="15" creationId="{CE3A3C06-C21E-4447-A8BC-14477C93FBF4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26" creationId="{51D5B7DC-C8E7-4860-87B0-B80727A196AC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27" creationId="{01DA66D1-FC5D-422B-879C-A75D3BAAE579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29" creationId="{81BE36F9-E530-4D7D-9EB2-6F3B9BB03F85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30" creationId="{ACC4152A-AA60-4F32-BD09-E5971A939F13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31" creationId="{2538EFC4-E97A-4619-B494-FF432ED840E6}"/>
          </ac:spMkLst>
        </pc:spChg>
        <pc:spChg chg="mod topLvl">
          <ac:chgData name="吉武 和敏" userId="e4825ba96748af9c" providerId="LiveId" clId="{FF564006-9E3C-48B0-A532-47AB0D2A5111}" dt="2021-07-05T09:31:52.413" v="138" actId="164"/>
          <ac:spMkLst>
            <pc:docMk/>
            <pc:sldMk cId="2690405455" sldId="270"/>
            <ac:spMk id="34" creationId="{FAD5B322-C7A1-4C16-8500-6484BF68BD2D}"/>
          </ac:spMkLst>
        </pc:spChg>
        <pc:spChg chg="del">
          <ac:chgData name="吉武 和敏" userId="e4825ba96748af9c" providerId="LiveId" clId="{FF564006-9E3C-48B0-A532-47AB0D2A5111}" dt="2021-07-05T09:26:04.398" v="12" actId="478"/>
          <ac:spMkLst>
            <pc:docMk/>
            <pc:sldMk cId="2690405455" sldId="270"/>
            <ac:spMk id="35" creationId="{337FF8C5-FA50-42B5-B420-7E4C4D890FD8}"/>
          </ac:spMkLst>
        </pc:spChg>
        <pc:spChg chg="mod topLvl">
          <ac:chgData name="吉武 和敏" userId="e4825ba96748af9c" providerId="LiveId" clId="{FF564006-9E3C-48B0-A532-47AB0D2A5111}" dt="2021-07-05T09:31:52.413" v="138" actId="164"/>
          <ac:spMkLst>
            <pc:docMk/>
            <pc:sldMk cId="2690405455" sldId="270"/>
            <ac:spMk id="36" creationId="{C78593A8-B6EE-48EC-B493-77029EC9DF39}"/>
          </ac:spMkLst>
        </pc:spChg>
        <pc:spChg chg="mod topLvl">
          <ac:chgData name="吉武 和敏" userId="e4825ba96748af9c" providerId="LiveId" clId="{FF564006-9E3C-48B0-A532-47AB0D2A5111}" dt="2021-07-05T09:31:45.999" v="137" actId="165"/>
          <ac:spMkLst>
            <pc:docMk/>
            <pc:sldMk cId="2690405455" sldId="270"/>
            <ac:spMk id="37" creationId="{7DC9BED5-2113-4D10-9482-E37FB108FA0F}"/>
          </ac:spMkLst>
        </pc:spChg>
        <pc:spChg chg="del">
          <ac:chgData name="吉武 和敏" userId="e4825ba96748af9c" providerId="LiveId" clId="{FF564006-9E3C-48B0-A532-47AB0D2A5111}" dt="2021-07-05T09:31:11.633" v="131" actId="478"/>
          <ac:spMkLst>
            <pc:docMk/>
            <pc:sldMk cId="2690405455" sldId="270"/>
            <ac:spMk id="45" creationId="{54FE58BB-D83F-4DEE-B04D-559C752A0DF7}"/>
          </ac:spMkLst>
        </pc:spChg>
        <pc:grpChg chg="add del mod">
          <ac:chgData name="吉武 和敏" userId="e4825ba96748af9c" providerId="LiveId" clId="{FF564006-9E3C-48B0-A532-47AB0D2A5111}" dt="2021-07-05T09:31:45.999" v="137" actId="165"/>
          <ac:grpSpMkLst>
            <pc:docMk/>
            <pc:sldMk cId="2690405455" sldId="270"/>
            <ac:grpSpMk id="4" creationId="{36C5B25F-B626-46A9-9D42-CFFE5DC5C2D9}"/>
          </ac:grpSpMkLst>
        </pc:grpChg>
        <pc:grpChg chg="add mod">
          <ac:chgData name="吉武 和敏" userId="e4825ba96748af9c" providerId="LiveId" clId="{FF564006-9E3C-48B0-A532-47AB0D2A5111}" dt="2021-07-05T09:32:01.226" v="139" actId="1076"/>
          <ac:grpSpMkLst>
            <pc:docMk/>
            <pc:sldMk cId="2690405455" sldId="270"/>
            <ac:grpSpMk id="10" creationId="{86C52E9D-B438-4A6F-A205-36404B991C6F}"/>
          </ac:grpSpMkLst>
        </pc:grpChg>
        <pc:picChg chg="mod topLvl">
          <ac:chgData name="吉武 和敏" userId="e4825ba96748af9c" providerId="LiveId" clId="{FF564006-9E3C-48B0-A532-47AB0D2A5111}" dt="2021-07-05T09:31:45.999" v="137" actId="165"/>
          <ac:picMkLst>
            <pc:docMk/>
            <pc:sldMk cId="2690405455" sldId="270"/>
            <ac:picMk id="3" creationId="{9CDD7990-9029-40A7-92C0-D3C0FC2EA9B1}"/>
          </ac:picMkLst>
        </pc:picChg>
        <pc:picChg chg="mod topLvl">
          <ac:chgData name="吉武 和敏" userId="e4825ba96748af9c" providerId="LiveId" clId="{FF564006-9E3C-48B0-A532-47AB0D2A5111}" dt="2021-07-05T09:31:45.999" v="137" actId="165"/>
          <ac:picMkLst>
            <pc:docMk/>
            <pc:sldMk cId="2690405455" sldId="270"/>
            <ac:picMk id="5" creationId="{4AB88DE6-FC6A-478B-89E2-3BB643B6766A}"/>
          </ac:picMkLst>
        </pc:picChg>
        <pc:picChg chg="mod topLvl">
          <ac:chgData name="吉武 和敏" userId="e4825ba96748af9c" providerId="LiveId" clId="{FF564006-9E3C-48B0-A532-47AB0D2A5111}" dt="2021-07-05T09:31:45.999" v="137" actId="165"/>
          <ac:picMkLst>
            <pc:docMk/>
            <pc:sldMk cId="2690405455" sldId="270"/>
            <ac:picMk id="7" creationId="{AE4C5715-0D7B-4CE0-A852-8CC8988A295F}"/>
          </ac:picMkLst>
        </pc:picChg>
        <pc:picChg chg="mod topLvl">
          <ac:chgData name="吉武 和敏" userId="e4825ba96748af9c" providerId="LiveId" clId="{FF564006-9E3C-48B0-A532-47AB0D2A5111}" dt="2021-07-05T09:31:45.999" v="137" actId="165"/>
          <ac:picMkLst>
            <pc:docMk/>
            <pc:sldMk cId="2690405455" sldId="270"/>
            <ac:picMk id="9" creationId="{5EFE40CB-93E6-4B2D-B29D-27D67402B450}"/>
          </ac:picMkLst>
        </pc:picChg>
        <pc:picChg chg="mod topLvl">
          <ac:chgData name="吉武 和敏" userId="e4825ba96748af9c" providerId="LiveId" clId="{FF564006-9E3C-48B0-A532-47AB0D2A5111}" dt="2021-07-05T09:31:45.999" v="137" actId="165"/>
          <ac:picMkLst>
            <pc:docMk/>
            <pc:sldMk cId="2690405455" sldId="270"/>
            <ac:picMk id="11" creationId="{CA299895-95DC-4086-A929-D318C45B5298}"/>
          </ac:picMkLst>
        </pc:picChg>
        <pc:cxnChg chg="mod topLvl">
          <ac:chgData name="吉武 和敏" userId="e4825ba96748af9c" providerId="LiveId" clId="{FF564006-9E3C-48B0-A532-47AB0D2A5111}" dt="2021-07-05T09:31:45.999" v="137" actId="165"/>
          <ac:cxnSpMkLst>
            <pc:docMk/>
            <pc:sldMk cId="2690405455" sldId="270"/>
            <ac:cxnSpMk id="24" creationId="{2457528F-AB27-4EBA-BCF7-9887D6A27DD7}"/>
          </ac:cxnSpMkLst>
        </pc:cxnChg>
        <pc:cxnChg chg="mod topLvl">
          <ac:chgData name="吉武 和敏" userId="e4825ba96748af9c" providerId="LiveId" clId="{FF564006-9E3C-48B0-A532-47AB0D2A5111}" dt="2021-07-05T09:31:45.999" v="137" actId="165"/>
          <ac:cxnSpMkLst>
            <pc:docMk/>
            <pc:sldMk cId="2690405455" sldId="270"/>
            <ac:cxnSpMk id="25" creationId="{CD0F3525-64E0-4014-89FA-4F2EA7D2BE5C}"/>
          </ac:cxnSpMkLst>
        </pc:cxnChg>
        <pc:cxnChg chg="mod topLvl">
          <ac:chgData name="吉武 和敏" userId="e4825ba96748af9c" providerId="LiveId" clId="{FF564006-9E3C-48B0-A532-47AB0D2A5111}" dt="2021-07-05T09:31:45.999" v="137" actId="165"/>
          <ac:cxnSpMkLst>
            <pc:docMk/>
            <pc:sldMk cId="2690405455" sldId="270"/>
            <ac:cxnSpMk id="28" creationId="{2B25EA7C-0372-414A-9C41-CE0DAB3DD0C5}"/>
          </ac:cxnSpMkLst>
        </pc:cxnChg>
        <pc:cxnChg chg="mod topLvl">
          <ac:chgData name="吉武 和敏" userId="e4825ba96748af9c" providerId="LiveId" clId="{FF564006-9E3C-48B0-A532-47AB0D2A5111}" dt="2021-07-05T09:31:45.999" v="137" actId="165"/>
          <ac:cxnSpMkLst>
            <pc:docMk/>
            <pc:sldMk cId="2690405455" sldId="270"/>
            <ac:cxnSpMk id="33" creationId="{BC5AF099-046D-41D8-80D6-60886A61FC8E}"/>
          </ac:cxnSpMkLst>
        </pc:cxnChg>
        <pc:cxnChg chg="del">
          <ac:chgData name="吉武 和敏" userId="e4825ba96748af9c" providerId="LiveId" clId="{FF564006-9E3C-48B0-A532-47AB0D2A5111}" dt="2021-07-05T09:31:11.633" v="131" actId="478"/>
          <ac:cxnSpMkLst>
            <pc:docMk/>
            <pc:sldMk cId="2690405455" sldId="270"/>
            <ac:cxnSpMk id="42" creationId="{D90C575C-B45D-4764-AFF0-8F7315E12937}"/>
          </ac:cxnSpMkLst>
        </pc:cxnChg>
        <pc:cxnChg chg="del">
          <ac:chgData name="吉武 和敏" userId="e4825ba96748af9c" providerId="LiveId" clId="{FF564006-9E3C-48B0-A532-47AB0D2A5111}" dt="2021-07-05T09:31:11.633" v="131" actId="478"/>
          <ac:cxnSpMkLst>
            <pc:docMk/>
            <pc:sldMk cId="2690405455" sldId="270"/>
            <ac:cxnSpMk id="44" creationId="{D75A9A5E-5189-4DA8-A13F-59496FB1E4FB}"/>
          </ac:cxnSpMkLst>
        </pc:cxnChg>
      </pc:sldChg>
      <pc:sldChg chg="del">
        <pc:chgData name="吉武 和敏" userId="e4825ba96748af9c" providerId="LiveId" clId="{FF564006-9E3C-48B0-A532-47AB0D2A5111}" dt="2021-07-06T08:42:21.392" v="477" actId="47"/>
        <pc:sldMkLst>
          <pc:docMk/>
          <pc:sldMk cId="1279299448" sldId="271"/>
        </pc:sldMkLst>
      </pc:sldChg>
      <pc:sldChg chg="del">
        <pc:chgData name="吉武 和敏" userId="e4825ba96748af9c" providerId="LiveId" clId="{FF564006-9E3C-48B0-A532-47AB0D2A5111}" dt="2021-07-06T08:42:21.392" v="477" actId="47"/>
        <pc:sldMkLst>
          <pc:docMk/>
          <pc:sldMk cId="4140638350" sldId="272"/>
        </pc:sldMkLst>
      </pc:sldChg>
      <pc:sldChg chg="del">
        <pc:chgData name="吉武 和敏" userId="e4825ba96748af9c" providerId="LiveId" clId="{FF564006-9E3C-48B0-A532-47AB0D2A5111}" dt="2021-07-06T08:42:21.392" v="477" actId="47"/>
        <pc:sldMkLst>
          <pc:docMk/>
          <pc:sldMk cId="4258909056" sldId="273"/>
        </pc:sldMkLst>
      </pc:sldChg>
    </pc:docChg>
  </pc:docChgLst>
  <pc:docChgLst>
    <pc:chgData name="吉武 和敏" userId="e4825ba96748af9c" providerId="LiveId" clId="{40AF2306-0ABB-4F0D-BF94-724DC25A3773}"/>
    <pc:docChg chg="modSld">
      <pc:chgData name="吉武 和敏" userId="e4825ba96748af9c" providerId="LiveId" clId="{40AF2306-0ABB-4F0D-BF94-724DC25A3773}" dt="2021-08-04T03:21:12.436" v="4" actId="207"/>
      <pc:docMkLst>
        <pc:docMk/>
      </pc:docMkLst>
      <pc:sldChg chg="modSp mod">
        <pc:chgData name="吉武 和敏" userId="e4825ba96748af9c" providerId="LiveId" clId="{40AF2306-0ABB-4F0D-BF94-724DC25A3773}" dt="2021-08-04T03:21:03.339" v="1" actId="207"/>
        <pc:sldMkLst>
          <pc:docMk/>
          <pc:sldMk cId="789342450" sldId="256"/>
        </pc:sldMkLst>
        <pc:spChg chg="mod">
          <ac:chgData name="吉武 和敏" userId="e4825ba96748af9c" providerId="LiveId" clId="{40AF2306-0ABB-4F0D-BF94-724DC25A3773}" dt="2021-08-04T03:21:03.339" v="1" actId="207"/>
          <ac:spMkLst>
            <pc:docMk/>
            <pc:sldMk cId="789342450" sldId="256"/>
            <ac:spMk id="107" creationId="{F9953033-7996-49BF-99C7-781199D3B854}"/>
          </ac:spMkLst>
        </pc:spChg>
      </pc:sldChg>
      <pc:sldChg chg="modSp mod">
        <pc:chgData name="吉武 和敏" userId="e4825ba96748af9c" providerId="LiveId" clId="{40AF2306-0ABB-4F0D-BF94-724DC25A3773}" dt="2021-08-04T03:20:57.014" v="0" actId="207"/>
        <pc:sldMkLst>
          <pc:docMk/>
          <pc:sldMk cId="363600399" sldId="260"/>
        </pc:sldMkLst>
        <pc:spChg chg="mod">
          <ac:chgData name="吉武 和敏" userId="e4825ba96748af9c" providerId="LiveId" clId="{40AF2306-0ABB-4F0D-BF94-724DC25A3773}" dt="2021-08-04T03:20:57.014" v="0" actId="207"/>
          <ac:spMkLst>
            <pc:docMk/>
            <pc:sldMk cId="363600399" sldId="260"/>
            <ac:spMk id="123" creationId="{C1963826-252C-4558-8BED-ABAB4DFC4E53}"/>
          </ac:spMkLst>
        </pc:spChg>
      </pc:sldChg>
      <pc:sldChg chg="modSp mod">
        <pc:chgData name="吉武 和敏" userId="e4825ba96748af9c" providerId="LiveId" clId="{40AF2306-0ABB-4F0D-BF94-724DC25A3773}" dt="2021-08-04T03:21:08.980" v="3" actId="207"/>
        <pc:sldMkLst>
          <pc:docMk/>
          <pc:sldMk cId="1325269219" sldId="261"/>
        </pc:sldMkLst>
        <pc:spChg chg="mod">
          <ac:chgData name="吉武 和敏" userId="e4825ba96748af9c" providerId="LiveId" clId="{40AF2306-0ABB-4F0D-BF94-724DC25A3773}" dt="2021-08-04T03:21:08.980" v="3" actId="207"/>
          <ac:spMkLst>
            <pc:docMk/>
            <pc:sldMk cId="1325269219" sldId="261"/>
            <ac:spMk id="5" creationId="{4E929D03-F61C-4BE2-8D6E-1383100473F1}"/>
          </ac:spMkLst>
        </pc:spChg>
      </pc:sldChg>
      <pc:sldChg chg="modSp mod">
        <pc:chgData name="吉武 和敏" userId="e4825ba96748af9c" providerId="LiveId" clId="{40AF2306-0ABB-4F0D-BF94-724DC25A3773}" dt="2021-08-04T03:21:12.436" v="4" actId="207"/>
        <pc:sldMkLst>
          <pc:docMk/>
          <pc:sldMk cId="3154137531" sldId="262"/>
        </pc:sldMkLst>
        <pc:spChg chg="mod">
          <ac:chgData name="吉武 和敏" userId="e4825ba96748af9c" providerId="LiveId" clId="{40AF2306-0ABB-4F0D-BF94-724DC25A3773}" dt="2021-08-04T03:21:12.436" v="4" actId="207"/>
          <ac:spMkLst>
            <pc:docMk/>
            <pc:sldMk cId="3154137531" sldId="262"/>
            <ac:spMk id="5" creationId="{14FFFE7E-BF1D-4F31-A560-01C53E89999D}"/>
          </ac:spMkLst>
        </pc:spChg>
      </pc:sldChg>
    </pc:docChg>
  </pc:docChgLst>
  <pc:docChgLst>
    <pc:chgData name="吉武 和敏" userId="e4825ba96748af9c" providerId="LiveId" clId="{600C7EB4-1348-4339-AB82-A3EE5B116484}"/>
    <pc:docChg chg="undo custSel addSld delSld modSld">
      <pc:chgData name="吉武 和敏" userId="e4825ba96748af9c" providerId="LiveId" clId="{600C7EB4-1348-4339-AB82-A3EE5B116484}" dt="2021-07-06T08:55:50.900" v="167" actId="20577"/>
      <pc:docMkLst>
        <pc:docMk/>
      </pc:docMkLst>
      <pc:sldChg chg="addSp delSp modSp add del mod">
        <pc:chgData name="吉武 和敏" userId="e4825ba96748af9c" providerId="LiveId" clId="{600C7EB4-1348-4339-AB82-A3EE5B116484}" dt="2021-07-06T08:55:27.829" v="155" actId="20577"/>
        <pc:sldMkLst>
          <pc:docMk/>
          <pc:sldMk cId="789342450" sldId="256"/>
        </pc:sldMkLst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32" creationId="{674045DB-91FF-41DD-8A94-49EED595D297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33" creationId="{294B0865-DA05-4956-82A4-3DF155642C8D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34" creationId="{466377CC-8C68-4552-AB31-02AA76A4A8D4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36" creationId="{F48C57FB-4D10-48F3-97F2-4C4CF293B4A3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37" creationId="{97BE2363-34C3-4E24-8D96-8BE315918EA2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43" creationId="{6A8ADA73-0EC4-4DA1-AB4C-8C1CA8C77747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45" creationId="{E718756D-C31A-4A9D-97B7-48F89C1D157F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46" creationId="{1C20AF24-F880-419B-BEEA-C3A27EDF0739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47" creationId="{03064DA6-BF73-4C57-9CA9-A6A9FC7189F5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48" creationId="{755A2B58-E26D-4504-AC2E-01D57788F540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49" creationId="{34EDDAC1-F790-413E-A4B5-E5822A641E65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0" creationId="{6865AE58-043B-4FB0-A308-D5EA342F7C84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1" creationId="{40CDC0EA-58D9-45E0-AD79-E7361616239F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2" creationId="{ABBDF4C2-3F79-4E02-B08D-367DB905DCDD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3" creationId="{DDE45D2E-F64B-45B5-A3D1-DE0D6F67B56E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4" creationId="{BAC1E332-A0C7-411D-A386-4CB61BA36425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5" creationId="{D466E468-4131-4762-A72A-080F645E7F6F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6" creationId="{E686E6D2-A406-4557-A203-9AC0B2ED5F15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7" creationId="{B1C25B1D-C0F8-41CA-98EE-CE50F06770E5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58" creationId="{BCAC1D8B-5F0B-4F3D-AF65-54387BE8B140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74" creationId="{2D2D307C-4DA8-46F1-BA68-DAA7E44FE619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75" creationId="{AE49BC0D-7455-4B72-9351-6267AB96E9F7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76" creationId="{3A4D24C6-E9AD-4DF5-9A4F-183C89012D54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77" creationId="{E20C8133-CF3F-4021-8EC1-48134B394DED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78" creationId="{BE8535DA-5847-4D40-A5D7-77A64E6E3F5F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79" creationId="{4866212D-A393-4782-9276-65BF45F0A7CE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80" creationId="{0E8DF553-31AD-4654-99C4-722F58DAD9BB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81" creationId="{C41A417D-822D-4278-BCA0-12A91CCD4F04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82" creationId="{8F6AC48B-1EB8-4EFB-A8E4-ED9ECD25C26E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83" creationId="{2548D013-D9AC-44C4-A1BD-0E186939685B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84" creationId="{013D0B63-6060-4AAA-BADA-067828938C40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85" creationId="{B8BB362F-149C-4FD9-A857-FFC70AF032F5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86" creationId="{EBD4F420-11C4-44A0-8C8C-8601BC3BF69B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87" creationId="{241B4FCB-A560-442A-AFD5-A61D83D37EE2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102" creationId="{20ACB979-61BC-4E66-ADB7-B41FEE5DDB6A}"/>
          </ac:spMkLst>
        </pc:spChg>
        <pc:spChg chg="add del mod">
          <ac:chgData name="吉武 和敏" userId="e4825ba96748af9c" providerId="LiveId" clId="{600C7EB4-1348-4339-AB82-A3EE5B116484}" dt="2021-07-06T08:55:21.429" v="151" actId="478"/>
          <ac:spMkLst>
            <pc:docMk/>
            <pc:sldMk cId="789342450" sldId="256"/>
            <ac:spMk id="103" creationId="{B98C54F0-D13D-40BF-BD81-673EEB3D7A00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104" creationId="{2FE4DAE1-9FD5-4D79-8F09-FA9815AC287E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105" creationId="{F6C790EF-5A90-4001-83E3-9D4492823C80}"/>
          </ac:spMkLst>
        </pc:spChg>
        <pc:spChg chg="del">
          <ac:chgData name="吉武 和敏" userId="e4825ba96748af9c" providerId="LiveId" clId="{600C7EB4-1348-4339-AB82-A3EE5B116484}" dt="2021-07-06T08:44:23.849" v="5" actId="478"/>
          <ac:spMkLst>
            <pc:docMk/>
            <pc:sldMk cId="789342450" sldId="256"/>
            <ac:spMk id="106" creationId="{75351C89-C52E-4038-8F84-F591C7CC9672}"/>
          </ac:spMkLst>
        </pc:spChg>
        <pc:spChg chg="add mod">
          <ac:chgData name="吉武 和敏" userId="e4825ba96748af9c" providerId="LiveId" clId="{600C7EB4-1348-4339-AB82-A3EE5B116484}" dt="2021-07-06T08:55:27.829" v="155" actId="20577"/>
          <ac:spMkLst>
            <pc:docMk/>
            <pc:sldMk cId="789342450" sldId="256"/>
            <ac:spMk id="107" creationId="{F9953033-7996-49BF-99C7-781199D3B854}"/>
          </ac:spMkLst>
        </pc:spChg>
        <pc:picChg chg="add mod">
          <ac:chgData name="吉武 和敏" userId="e4825ba96748af9c" providerId="LiveId" clId="{600C7EB4-1348-4339-AB82-A3EE5B116484}" dt="2021-07-06T08:44:43.248" v="13" actId="27614"/>
          <ac:picMkLst>
            <pc:docMk/>
            <pc:sldMk cId="789342450" sldId="256"/>
            <ac:picMk id="3" creationId="{512A46F9-DFAD-465D-A2E6-BB600816A35D}"/>
          </ac:picMkLst>
        </pc:picChg>
        <pc:picChg chg="del">
          <ac:chgData name="吉武 和敏" userId="e4825ba96748af9c" providerId="LiveId" clId="{600C7EB4-1348-4339-AB82-A3EE5B116484}" dt="2021-07-06T08:44:23.849" v="5" actId="478"/>
          <ac:picMkLst>
            <pc:docMk/>
            <pc:sldMk cId="789342450" sldId="256"/>
            <ac:picMk id="38" creationId="{89FD6679-1BA9-4A7F-927E-C62B5AAEADA8}"/>
          </ac:picMkLst>
        </pc:picChg>
        <pc:picChg chg="del">
          <ac:chgData name="吉武 和敏" userId="e4825ba96748af9c" providerId="LiveId" clId="{600C7EB4-1348-4339-AB82-A3EE5B116484}" dt="2021-07-06T08:44:23.849" v="5" actId="478"/>
          <ac:picMkLst>
            <pc:docMk/>
            <pc:sldMk cId="789342450" sldId="256"/>
            <ac:picMk id="39" creationId="{82F5437E-102B-4B05-BBC1-DD4EFB8FDD3A}"/>
          </ac:picMkLst>
        </pc:picChg>
        <pc:picChg chg="del">
          <ac:chgData name="吉武 和敏" userId="e4825ba96748af9c" providerId="LiveId" clId="{600C7EB4-1348-4339-AB82-A3EE5B116484}" dt="2021-07-06T08:44:23.849" v="5" actId="478"/>
          <ac:picMkLst>
            <pc:docMk/>
            <pc:sldMk cId="789342450" sldId="256"/>
            <ac:picMk id="1028" creationId="{78075D98-7B99-4468-8015-0F1CFDDC0719}"/>
          </ac:picMkLst>
        </pc:pic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40" creationId="{ED62F230-FE59-4B4C-891C-7C2C3C5996C0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42" creationId="{247A3164-8A41-45F6-8C49-682AC87FC4A0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44" creationId="{5EA16070-61E7-45C3-B4EC-C319A9E2F1DF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1" creationId="{D68EBDFC-8D89-4DCB-BD41-0EC755F5C7C3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2" creationId="{87E5C0CF-E737-4426-914A-854672BF4F6B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3" creationId="{61FD9E21-A9ED-4407-9C3F-B1FEEBDCE63B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4" creationId="{325F202B-5BAB-4CCA-A735-A0490645B9C2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5" creationId="{A21B6008-04CC-4C0B-843D-711F7956D4D2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6" creationId="{1B28EF0C-C48E-41B9-B423-696A89E69FBF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7" creationId="{7D457C31-150B-42EC-A260-1F86AE02C9F7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8" creationId="{433145C6-858F-4238-9B8F-7CBC980BF9D1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69" creationId="{414C62F1-D68E-4E73-B6F0-95989AAD7668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70" creationId="{8B643327-79F8-4CAA-BF62-F30862E5205B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71" creationId="{445DDD2B-C804-42D8-B772-6C50DA7AD57F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72" creationId="{68615E2C-5A2D-4A91-88CF-FA023C56A548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73" creationId="{89BD50E0-5298-49AC-88F4-CBF2FF734E43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88" creationId="{09B36567-BDCD-4DD1-860D-912893751CAF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89" creationId="{4CCADDBC-E348-4C12-BCF4-F4AD93709FDE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0" creationId="{8184A1F3-6BF4-487E-853E-21C62217D3B1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1" creationId="{4258BDDE-35D0-4A9C-8F2E-B349CD5AC35D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2" creationId="{9F8B7F7A-B70E-40B4-AC00-0B7FBF9FA214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3" creationId="{BDFA3CA4-D042-4456-B711-49D0976F646C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4" creationId="{B1A0913F-34D5-4E40-9E41-6B6F3B8BA923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5" creationId="{90B26F0A-463A-41F0-834E-A445B4E00F6E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6" creationId="{A6222213-E606-4B17-9D8B-53D34E21EADE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7" creationId="{E1B03511-D861-4953-AEA2-940438BC3658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8" creationId="{1BED2E11-5B2D-4CFC-B888-9D39FA83C466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99" creationId="{1333D759-2CFB-4109-A2FA-216FAE07FF4D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100" creationId="{48E8F83C-CF9C-4047-940A-3DD15C7B6003}"/>
          </ac:cxnSpMkLst>
        </pc:cxnChg>
        <pc:cxnChg chg="del">
          <ac:chgData name="吉武 和敏" userId="e4825ba96748af9c" providerId="LiveId" clId="{600C7EB4-1348-4339-AB82-A3EE5B116484}" dt="2021-07-06T08:44:23.849" v="5" actId="478"/>
          <ac:cxnSpMkLst>
            <pc:docMk/>
            <pc:sldMk cId="789342450" sldId="256"/>
            <ac:cxnSpMk id="101" creationId="{327DF156-6DE9-4667-B943-7CDA47D5B0C3}"/>
          </ac:cxnSpMkLst>
        </pc:cxnChg>
      </pc:sldChg>
      <pc:sldChg chg="add del">
        <pc:chgData name="吉武 和敏" userId="e4825ba96748af9c" providerId="LiveId" clId="{600C7EB4-1348-4339-AB82-A3EE5B116484}" dt="2021-07-06T08:44:30.753" v="6" actId="47"/>
        <pc:sldMkLst>
          <pc:docMk/>
          <pc:sldMk cId="3007290250" sldId="257"/>
        </pc:sldMkLst>
      </pc:sldChg>
      <pc:sldChg chg="addSp delSp modSp add del mod">
        <pc:chgData name="吉武 和敏" userId="e4825ba96748af9c" providerId="LiveId" clId="{600C7EB4-1348-4339-AB82-A3EE5B116484}" dt="2021-07-06T08:55:14.356" v="150" actId="404"/>
        <pc:sldMkLst>
          <pc:docMk/>
          <pc:sldMk cId="363600399" sldId="260"/>
        </pc:sldMkLst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" creationId="{AC23B9C4-159D-4EF0-BDCB-2F71D15456B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" creationId="{83FF8330-9C2D-4FC6-BC52-20C77FBEFEC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8" creationId="{E96E697A-8711-4CD9-9C69-D448BE396BDB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9" creationId="{91F6F885-DA9F-41E5-898D-1478B90A9EA8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0" creationId="{C8AE1663-BD09-4539-94A9-D1C01FF6B1E6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7" creationId="{E1A8D41D-31B9-4FE8-8A26-B0B4FBB4340E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8" creationId="{82E6BB19-91B7-4A6D-A318-E6C9BAC81A24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1" creationId="{15FBDDC2-4832-4BE3-B183-E10EAD0B965C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2" creationId="{A75E6D2E-CFBE-4091-8DAC-1FFC2CA8C30C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3" creationId="{2F5E8075-C142-41E7-A409-5C58FF46949A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4" creationId="{CB4FCE7F-F748-44C5-8CD9-68BE600BFCFF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5" creationId="{97E57B48-7CCB-47FF-B5CB-E015A89DAD26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6" creationId="{0FD20D89-5712-49FF-87EB-286EF6AE54EE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7" creationId="{277BE7AC-F8C1-4581-A964-562E4B878E12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8" creationId="{C1FC7718-939E-4B3E-9243-F125EA98BFC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29" creationId="{0121D446-0AB7-46A2-B7E5-34E93A87C220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0" creationId="{E26923D2-F53A-470F-A139-8DCFC24105D4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1" creationId="{B2F2B78B-0973-4F9C-97AE-8087592C5B9D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2" creationId="{3B8651EB-9E39-4521-8BD2-EDFB79CF3A59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3" creationId="{33AB1BAB-5981-4CF5-B8DE-213CEC34A7A6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4" creationId="{29CEAEA5-287A-4977-88F8-4A3A72A7C932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5" creationId="{EA10521D-5F2B-415E-A900-ACC8A4D54813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6" creationId="{A26D7660-E91D-4470-97BF-841F73379A64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7" creationId="{10CFC7F4-74C3-4221-B2DB-1E02DCE8F33F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8" creationId="{13853BF4-DFCB-4264-A160-BD6C290C2A3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39" creationId="{E21E5619-DD79-4236-8DB5-1D32AF5CD883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0" creationId="{0307FE17-043E-4D98-AA6B-0D7F87F52638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1" creationId="{943F33B4-7F90-4A8A-9190-C8C221CC56D3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2" creationId="{5A3940BA-4743-4053-9FC2-4A203ABBF879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3" creationId="{27AFD2E7-AFD2-4E35-AC60-61C2F20CCD1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4" creationId="{5B379EE0-5BEC-4C0E-A3A5-28AB1851A99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5" creationId="{190B97FA-768F-43F1-B0CB-F870134D299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6" creationId="{2EF34C9F-3B40-4FDC-A5E8-955678AC8E1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7" creationId="{52995F51-0760-4E2C-A87B-68D56046131A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8" creationId="{6F0E7238-DD5A-4E69-A9CB-D26921F71E01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49" creationId="{6E762634-F0BE-410D-BA2E-303E7AB6D46A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0" creationId="{931F825B-4D86-4762-BD30-85E4EDCDB39F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2" creationId="{BBCE7F4C-269B-4D88-9B04-0F8181F216B1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3" creationId="{00D33CC2-96B2-49F7-951D-9A7FC04D55A2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4" creationId="{8B3F05A8-5FBC-4F0E-B4B5-9520CCCE15D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5" creationId="{7242D7E9-E7EC-4239-BF61-C16651142CB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6" creationId="{C1BECBEA-92F0-4283-B810-824DC0E0516B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7" creationId="{FB97823A-E096-4C05-BCBD-EDC0CE03B6AA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8" creationId="{52B6C4C5-A94D-43ED-9A46-DE61BC1DD77D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59" creationId="{D74F6D1D-E0B3-48CB-9D3A-C7322AC3A72E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0" creationId="{4C8A45D2-48B3-4B96-9D5F-6ED7316CC5B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1" creationId="{ADB8607C-585A-44BA-B304-F97D802682C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2" creationId="{99A4A710-8636-4029-BB38-2CAE82AE9188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3" creationId="{9C6D6679-2931-47DB-A65D-9EA14525D75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4" creationId="{75005943-8B41-4C57-A62E-10848D941D11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5" creationId="{778AC9E0-2549-4E1A-AB1E-A65DDAD6E47C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6" creationId="{0BA2CD51-FE58-4D4E-A046-C7904EC5A109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7" creationId="{D2824F25-D7A0-4A86-B07C-20826D6EC5C3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8" creationId="{2C29F8ED-1FDF-4D4F-879F-B36661D13654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69" creationId="{AC251B68-F15B-4385-A8F8-39C0A5443F33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0" creationId="{ECC32675-8F34-4B34-B0C6-76E0FBD40A25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1" creationId="{C0210E72-D4E7-4204-96E4-96FDE76DE3A1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2" creationId="{4E1D9A42-20E0-406A-91DE-E006C61744A9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3" creationId="{099EFF42-0E73-4838-BA70-EAFF132E4B1F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4" creationId="{D36E8E7E-9027-4774-B064-CB01F94C04DD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5" creationId="{0BD3D9D6-0840-4669-953D-047708701CE8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6" creationId="{83B59C65-9378-4151-B9E7-1ED7807BA78D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7" creationId="{A6328AD4-05A8-47C1-9741-8006D2C23E7E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8" creationId="{6D128536-9059-497D-A311-835A97F55F5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79" creationId="{C5CBB7B5-D47F-4042-A313-81AE55BA3231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80" creationId="{6177F5FB-ABA1-4E2E-B376-F0549B12CAE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81" creationId="{EABCBC56-D4D1-4EEB-8533-A892EF7749DC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82" creationId="{B43FCE05-3E26-4FED-80F6-571FAC7F68B2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83" creationId="{A943BA00-0C9C-4D81-879A-67D373155A0E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86" creationId="{C828F037-9B53-4F2C-924A-DE91CF328323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87" creationId="{B9263E70-BD11-49D6-93B2-1714F367B60F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90" creationId="{0865DD03-4701-4A00-B30B-44C17CC2568F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91" creationId="{40B776B5-3F28-4AA9-9A41-5A51F04DD03A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94" creationId="{281547C5-375A-46E0-A956-F7E3DAF1979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95" creationId="{EEF79B31-EC25-4C0E-A5A9-8255193DBB5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98" creationId="{818D4976-4559-4253-91C1-5434B3B3CCB1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99" creationId="{EA6545BD-4D1A-46E1-BC9D-844A84B09864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00" creationId="{CFDB46F7-9334-4E2A-932C-89BA0749575F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15" creationId="{9B28E3AB-0526-42CB-AE5A-01241CA9C787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16" creationId="{D2AF5EFF-1FF5-432C-855B-8399B048124D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17" creationId="{09EE06E6-A6D6-4054-8D62-3826A629362C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18" creationId="{D2CDE60A-6C71-449A-B561-3D3DD02C9C5A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20" creationId="{D8312B35-B9C7-49BD-B87B-FD3721A8A25C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21" creationId="{9DDD2572-F25B-42C7-B8B8-E683012D5872}"/>
          </ac:spMkLst>
        </pc:spChg>
        <pc:spChg chg="del">
          <ac:chgData name="吉武 和敏" userId="e4825ba96748af9c" providerId="LiveId" clId="{600C7EB4-1348-4339-AB82-A3EE5B116484}" dt="2021-07-06T08:44:15.866" v="2" actId="478"/>
          <ac:spMkLst>
            <pc:docMk/>
            <pc:sldMk cId="363600399" sldId="260"/>
            <ac:spMk id="122" creationId="{555A5A52-D374-4BFF-A49A-C900CFDCB0F4}"/>
          </ac:spMkLst>
        </pc:spChg>
        <pc:spChg chg="add mod">
          <ac:chgData name="吉武 和敏" userId="e4825ba96748af9c" providerId="LiveId" clId="{600C7EB4-1348-4339-AB82-A3EE5B116484}" dt="2021-07-06T08:55:14.356" v="150" actId="404"/>
          <ac:spMkLst>
            <pc:docMk/>
            <pc:sldMk cId="363600399" sldId="260"/>
            <ac:spMk id="123" creationId="{C1963826-252C-4558-8BED-ABAB4DFC4E53}"/>
          </ac:spMkLst>
        </pc:spChg>
        <pc:grpChg chg="del">
          <ac:chgData name="吉武 和敏" userId="e4825ba96748af9c" providerId="LiveId" clId="{600C7EB4-1348-4339-AB82-A3EE5B116484}" dt="2021-07-06T08:44:15.866" v="2" actId="478"/>
          <ac:grpSpMkLst>
            <pc:docMk/>
            <pc:sldMk cId="363600399" sldId="260"/>
            <ac:grpSpMk id="11" creationId="{F687D0BA-55B6-43EF-B588-1D14626798DC}"/>
          </ac:grpSpMkLst>
        </pc:grpChg>
        <pc:grpChg chg="del">
          <ac:chgData name="吉武 和敏" userId="e4825ba96748af9c" providerId="LiveId" clId="{600C7EB4-1348-4339-AB82-A3EE5B116484}" dt="2021-07-06T08:44:15.866" v="2" actId="478"/>
          <ac:grpSpMkLst>
            <pc:docMk/>
            <pc:sldMk cId="363600399" sldId="260"/>
            <ac:grpSpMk id="14" creationId="{5F685E7C-8A21-42A4-849B-74F7881E3084}"/>
          </ac:grpSpMkLst>
        </pc:grpChg>
        <pc:grpChg chg="del">
          <ac:chgData name="吉武 和敏" userId="e4825ba96748af9c" providerId="LiveId" clId="{600C7EB4-1348-4339-AB82-A3EE5B116484}" dt="2021-07-06T08:44:15.866" v="2" actId="478"/>
          <ac:grpSpMkLst>
            <pc:docMk/>
            <pc:sldMk cId="363600399" sldId="260"/>
            <ac:grpSpMk id="109" creationId="{9BC8ED82-0E22-47A7-860B-010FE9480A95}"/>
          </ac:grpSpMkLst>
        </pc:grpChg>
        <pc:grpChg chg="del">
          <ac:chgData name="吉武 和敏" userId="e4825ba96748af9c" providerId="LiveId" clId="{600C7EB4-1348-4339-AB82-A3EE5B116484}" dt="2021-07-06T08:44:15.866" v="2" actId="478"/>
          <ac:grpSpMkLst>
            <pc:docMk/>
            <pc:sldMk cId="363600399" sldId="260"/>
            <ac:grpSpMk id="112" creationId="{EA33CC1A-EEA0-4B32-8226-68D33DF01AD9}"/>
          </ac:grpSpMkLst>
        </pc:grp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3" creationId="{29769575-6310-4B09-A125-3FA8BD77A308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4" creationId="{969B6955-61A4-4880-A7A8-9A108212F8E9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5" creationId="{A980531C-283E-4527-9902-0FA5315A1532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6" creationId="{7A075FDD-0519-4953-884E-7F843499F762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9" creationId="{1413BA84-D345-488C-BBBF-3DECEFB1B1A3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20" creationId="{1662F15C-943B-4AC1-BEA7-BC626DF36812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51" creationId="{69911C40-C929-4E58-80F8-C6A78353E821}"/>
          </ac:picMkLst>
        </pc:picChg>
        <pc:picChg chg="add mod">
          <ac:chgData name="吉武 和敏" userId="e4825ba96748af9c" providerId="LiveId" clId="{600C7EB4-1348-4339-AB82-A3EE5B116484}" dt="2021-07-06T08:44:21.556" v="4" actId="27614"/>
          <ac:picMkLst>
            <pc:docMk/>
            <pc:sldMk cId="363600399" sldId="260"/>
            <ac:picMk id="85" creationId="{9C79380A-5686-4539-A378-6E980C63DDBE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01" creationId="{080A69DE-86EE-4392-8ACF-41D1D31D0024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02" creationId="{670A0EA5-8480-487F-BB22-78177666E7DA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03" creationId="{F2969B6F-C86A-4E20-A9AF-CC335207C3BB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04" creationId="{EE0EB36C-F14E-46FE-975B-89B1C270701D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05" creationId="{EB484FBF-2BD4-4515-99B7-87276FF61928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06" creationId="{D2AE5233-429C-40B1-AFEE-64346AC14F4D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07" creationId="{74C5EBAB-4A8B-46D6-9EA8-B768D6DEA59F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08" creationId="{B93C3BE6-D158-4007-A6CB-EE310FF06BD0}"/>
          </ac:picMkLst>
        </pc:picChg>
        <pc:picChg chg="del">
          <ac:chgData name="吉武 和敏" userId="e4825ba96748af9c" providerId="LiveId" clId="{600C7EB4-1348-4339-AB82-A3EE5B116484}" dt="2021-07-06T08:44:15.866" v="2" actId="478"/>
          <ac:picMkLst>
            <pc:docMk/>
            <pc:sldMk cId="363600399" sldId="260"/>
            <ac:picMk id="119" creationId="{A2958A1D-EF64-4626-AD41-ABCEBB6FC5ED}"/>
          </ac:picMkLst>
        </pc:picChg>
      </pc:sldChg>
      <pc:sldChg chg="addSp delSp modSp add mod">
        <pc:chgData name="吉武 和敏" userId="e4825ba96748af9c" providerId="LiveId" clId="{600C7EB4-1348-4339-AB82-A3EE5B116484}" dt="2021-07-06T08:55:37.237" v="161" actId="20577"/>
        <pc:sldMkLst>
          <pc:docMk/>
          <pc:sldMk cId="1325269219" sldId="261"/>
        </pc:sldMkLst>
        <pc:spChg chg="add del mod">
          <ac:chgData name="吉武 和敏" userId="e4825ba96748af9c" providerId="LiveId" clId="{600C7EB4-1348-4339-AB82-A3EE5B116484}" dt="2021-07-06T08:55:31.077" v="156" actId="478"/>
          <ac:spMkLst>
            <pc:docMk/>
            <pc:sldMk cId="1325269219" sldId="261"/>
            <ac:spMk id="4" creationId="{85489E56-EC16-4D1E-9DE2-A1540C5B67DE}"/>
          </ac:spMkLst>
        </pc:spChg>
        <pc:spChg chg="add mod">
          <ac:chgData name="吉武 和敏" userId="e4825ba96748af9c" providerId="LiveId" clId="{600C7EB4-1348-4339-AB82-A3EE5B116484}" dt="2021-07-06T08:55:37.237" v="161" actId="20577"/>
          <ac:spMkLst>
            <pc:docMk/>
            <pc:sldMk cId="1325269219" sldId="261"/>
            <ac:spMk id="5" creationId="{4E929D03-F61C-4BE2-8D6E-1383100473F1}"/>
          </ac:spMkLst>
        </pc:spChg>
        <pc:picChg chg="add mod">
          <ac:chgData name="吉武 和敏" userId="e4825ba96748af9c" providerId="LiveId" clId="{600C7EB4-1348-4339-AB82-A3EE5B116484}" dt="2021-07-06T08:44:47.789" v="15" actId="27614"/>
          <ac:picMkLst>
            <pc:docMk/>
            <pc:sldMk cId="1325269219" sldId="261"/>
            <ac:picMk id="3" creationId="{BDD8B272-9400-4D42-8605-F2574AEE982C}"/>
          </ac:picMkLst>
        </pc:picChg>
      </pc:sldChg>
      <pc:sldChg chg="add del">
        <pc:chgData name="吉武 和敏" userId="e4825ba96748af9c" providerId="LiveId" clId="{600C7EB4-1348-4339-AB82-A3EE5B116484}" dt="2021-07-06T08:44:34.878" v="8" actId="47"/>
        <pc:sldMkLst>
          <pc:docMk/>
          <pc:sldMk cId="2234882533" sldId="262"/>
        </pc:sldMkLst>
      </pc:sldChg>
      <pc:sldChg chg="addSp delSp modSp add mod">
        <pc:chgData name="吉武 和敏" userId="e4825ba96748af9c" providerId="LiveId" clId="{600C7EB4-1348-4339-AB82-A3EE5B116484}" dt="2021-07-06T08:55:50.900" v="167" actId="20577"/>
        <pc:sldMkLst>
          <pc:docMk/>
          <pc:sldMk cId="3154137531" sldId="262"/>
        </pc:sldMkLst>
        <pc:spChg chg="add del mod">
          <ac:chgData name="吉武 和敏" userId="e4825ba96748af9c" providerId="LiveId" clId="{600C7EB4-1348-4339-AB82-A3EE5B116484}" dt="2021-07-06T08:55:42.165" v="162" actId="478"/>
          <ac:spMkLst>
            <pc:docMk/>
            <pc:sldMk cId="3154137531" sldId="262"/>
            <ac:spMk id="4" creationId="{FA56747A-C5EA-44A7-A617-CE55F3278D5D}"/>
          </ac:spMkLst>
        </pc:spChg>
        <pc:spChg chg="add mod">
          <ac:chgData name="吉武 和敏" userId="e4825ba96748af9c" providerId="LiveId" clId="{600C7EB4-1348-4339-AB82-A3EE5B116484}" dt="2021-07-06T08:55:50.900" v="167" actId="20577"/>
          <ac:spMkLst>
            <pc:docMk/>
            <pc:sldMk cId="3154137531" sldId="262"/>
            <ac:spMk id="5" creationId="{14FFFE7E-BF1D-4F31-A560-01C53E89999D}"/>
          </ac:spMkLst>
        </pc:spChg>
        <pc:picChg chg="add mod">
          <ac:chgData name="吉武 和敏" userId="e4825ba96748af9c" providerId="LiveId" clId="{600C7EB4-1348-4339-AB82-A3EE5B116484}" dt="2021-07-06T08:44:52.915" v="17" actId="27614"/>
          <ac:picMkLst>
            <pc:docMk/>
            <pc:sldMk cId="3154137531" sldId="262"/>
            <ac:picMk id="3" creationId="{3968BE61-2CD6-4DD0-83FA-429C6F146143}"/>
          </ac:picMkLst>
        </pc:picChg>
      </pc:sldChg>
      <pc:sldChg chg="add del">
        <pc:chgData name="吉武 和敏" userId="e4825ba96748af9c" providerId="LiveId" clId="{600C7EB4-1348-4339-AB82-A3EE5B116484}" dt="2021-07-06T08:44:53.436" v="18" actId="47"/>
        <pc:sldMkLst>
          <pc:docMk/>
          <pc:sldMk cId="263571144" sldId="263"/>
        </pc:sldMkLst>
      </pc:sldChg>
      <pc:sldChg chg="add del">
        <pc:chgData name="吉武 和敏" userId="e4825ba96748af9c" providerId="LiveId" clId="{600C7EB4-1348-4339-AB82-A3EE5B116484}" dt="2021-07-06T08:44:30.753" v="6" actId="47"/>
        <pc:sldMkLst>
          <pc:docMk/>
          <pc:sldMk cId="2446118483" sldId="263"/>
        </pc:sldMkLst>
      </pc:sldChg>
      <pc:sldChg chg="new del">
        <pc:chgData name="吉武 和敏" userId="e4825ba96748af9c" providerId="LiveId" clId="{600C7EB4-1348-4339-AB82-A3EE5B116484}" dt="2021-07-06T08:44:34.878" v="8" actId="47"/>
        <pc:sldMkLst>
          <pc:docMk/>
          <pc:sldMk cId="4109146864" sldId="263"/>
        </pc:sldMkLst>
      </pc:sldChg>
      <pc:sldChg chg="add del">
        <pc:chgData name="吉武 和敏" userId="e4825ba96748af9c" providerId="LiveId" clId="{600C7EB4-1348-4339-AB82-A3EE5B116484}" dt="2021-07-06T08:44:30.753" v="6" actId="47"/>
        <pc:sldMkLst>
          <pc:docMk/>
          <pc:sldMk cId="3224033489" sldId="264"/>
        </pc:sldMkLst>
      </pc:sldChg>
      <pc:sldChg chg="add del">
        <pc:chgData name="吉武 和敏" userId="e4825ba96748af9c" providerId="LiveId" clId="{600C7EB4-1348-4339-AB82-A3EE5B116484}" dt="2021-07-06T08:44:30.753" v="6" actId="47"/>
        <pc:sldMkLst>
          <pc:docMk/>
          <pc:sldMk cId="1537217434" sldId="26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6181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5500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1924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668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2513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6664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677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0748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274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880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855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039E0-2A3A-4A07-A1D7-43BC6B501AD1}" type="datetimeFigureOut">
              <a:rPr kumimoji="1" lang="ja-JP" altLang="en-US" smtClean="0"/>
              <a:t>2022/3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65E9A-13C7-420C-AD4E-9A0D903F2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131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kumimoji="1"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kumimoji="1"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>
            <a:extLst>
              <a:ext uri="{FF2B5EF4-FFF2-40B4-BE49-F238E27FC236}">
                <a16:creationId xmlns:a16="http://schemas.microsoft.com/office/drawing/2014/main" id="{78075D98-7B99-4468-8015-0F1CFDDC071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04"/>
          <a:stretch/>
        </p:blipFill>
        <p:spPr bwMode="auto">
          <a:xfrm>
            <a:off x="2609901" y="995451"/>
            <a:ext cx="1927749" cy="44012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294B0865-DA05-4956-82A4-3DF155642C8D}"/>
              </a:ext>
            </a:extLst>
          </p:cNvPr>
          <p:cNvSpPr/>
          <p:nvPr/>
        </p:nvSpPr>
        <p:spPr>
          <a:xfrm>
            <a:off x="2699326" y="995451"/>
            <a:ext cx="1838325" cy="2901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F48C57FB-4D10-48F3-97F2-4C4CF293B4A3}"/>
              </a:ext>
            </a:extLst>
          </p:cNvPr>
          <p:cNvSpPr/>
          <p:nvPr/>
        </p:nvSpPr>
        <p:spPr>
          <a:xfrm>
            <a:off x="3270826" y="995451"/>
            <a:ext cx="1838325" cy="2901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97BE2363-34C3-4E24-8D96-8BE315918EA2}"/>
              </a:ext>
            </a:extLst>
          </p:cNvPr>
          <p:cNvSpPr/>
          <p:nvPr/>
        </p:nvSpPr>
        <p:spPr>
          <a:xfrm rot="18000000">
            <a:off x="3868860" y="551957"/>
            <a:ext cx="12105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t"/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</a:rPr>
              <a:t>After SRE</a:t>
            </a:r>
            <a:endParaRPr lang="en-US" altLang="ja-JP" dirty="0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674045DB-91FF-41DD-8A94-49EED595D297}"/>
              </a:ext>
            </a:extLst>
          </p:cNvPr>
          <p:cNvSpPr/>
          <p:nvPr/>
        </p:nvSpPr>
        <p:spPr>
          <a:xfrm rot="18000000">
            <a:off x="3201178" y="468662"/>
            <a:ext cx="14029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t"/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</a:rPr>
              <a:t>Before SRE</a:t>
            </a:r>
            <a:endParaRPr lang="en-US" altLang="ja-JP" dirty="0"/>
          </a:p>
        </p:txBody>
      </p:sp>
      <p:pic>
        <p:nvPicPr>
          <p:cNvPr id="38" name="Picture 2">
            <a:extLst>
              <a:ext uri="{FF2B5EF4-FFF2-40B4-BE49-F238E27FC236}">
                <a16:creationId xmlns:a16="http://schemas.microsoft.com/office/drawing/2014/main" id="{89FD6679-1BA9-4A7F-927E-C62B5AAEADA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234" b="13329"/>
          <a:stretch/>
        </p:blipFill>
        <p:spPr bwMode="auto">
          <a:xfrm>
            <a:off x="4844325" y="556366"/>
            <a:ext cx="6369050" cy="21000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4">
            <a:extLst>
              <a:ext uri="{FF2B5EF4-FFF2-40B4-BE49-F238E27FC236}">
                <a16:creationId xmlns:a16="http://schemas.microsoft.com/office/drawing/2014/main" id="{82F5437E-102B-4B05-BBC1-DD4EFB8FDD3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867" b="13478"/>
          <a:stretch/>
        </p:blipFill>
        <p:spPr bwMode="auto">
          <a:xfrm>
            <a:off x="4672171" y="4351126"/>
            <a:ext cx="6439039" cy="21361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66377CC-8C68-4552-AB31-02AA76A4A8D4}"/>
              </a:ext>
            </a:extLst>
          </p:cNvPr>
          <p:cNvSpPr txBox="1"/>
          <p:nvPr/>
        </p:nvSpPr>
        <p:spPr>
          <a:xfrm>
            <a:off x="8873144" y="8945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57.95%</a:t>
            </a:r>
            <a:endParaRPr kumimoji="1" lang="ja-JP" altLang="en-US" dirty="0"/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ED62F230-FE59-4B4C-891C-7C2C3C5996C0}"/>
              </a:ext>
            </a:extLst>
          </p:cNvPr>
          <p:cNvCxnSpPr/>
          <p:nvPr/>
        </p:nvCxnSpPr>
        <p:spPr>
          <a:xfrm>
            <a:off x="9017924" y="774265"/>
            <a:ext cx="46482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A8ADA73-0EC4-4DA1-AB4C-8C1CA8C77747}"/>
              </a:ext>
            </a:extLst>
          </p:cNvPr>
          <p:cNvSpPr txBox="1"/>
          <p:nvPr/>
        </p:nvSpPr>
        <p:spPr>
          <a:xfrm>
            <a:off x="8873144" y="3942434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76.54%</a:t>
            </a:r>
            <a:endParaRPr kumimoji="1" lang="ja-JP" altLang="en-US" dirty="0"/>
          </a:p>
        </p:txBody>
      </p: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5EA16070-61E7-45C3-B4EC-C319A9E2F1DF}"/>
              </a:ext>
            </a:extLst>
          </p:cNvPr>
          <p:cNvCxnSpPr/>
          <p:nvPr/>
        </p:nvCxnSpPr>
        <p:spPr>
          <a:xfrm>
            <a:off x="9017924" y="4707754"/>
            <a:ext cx="464820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718756D-C31A-4A9D-97B7-48F89C1D157F}"/>
              </a:ext>
            </a:extLst>
          </p:cNvPr>
          <p:cNvSpPr txBox="1"/>
          <p:nvPr/>
        </p:nvSpPr>
        <p:spPr>
          <a:xfrm rot="16200000">
            <a:off x="6219404" y="298468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100</a:t>
            </a:r>
            <a:endParaRPr kumimoji="1" lang="ja-JP" altLang="en-US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C20AF24-F880-419B-BEEA-C3A27EDF0739}"/>
              </a:ext>
            </a:extLst>
          </p:cNvPr>
          <p:cNvSpPr txBox="1"/>
          <p:nvPr/>
        </p:nvSpPr>
        <p:spPr>
          <a:xfrm rot="16200000">
            <a:off x="6521376" y="298468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250</a:t>
            </a:r>
            <a:endParaRPr kumimoji="1" lang="ja-JP" altLang="en-US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3064DA6-BF73-4C57-9CA9-A6A9FC7189F5}"/>
              </a:ext>
            </a:extLst>
          </p:cNvPr>
          <p:cNvSpPr txBox="1"/>
          <p:nvPr/>
        </p:nvSpPr>
        <p:spPr>
          <a:xfrm rot="16200000">
            <a:off x="6854883" y="298468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400</a:t>
            </a:r>
            <a:endParaRPr kumimoji="1" lang="ja-JP" altLang="en-US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55A2B58-E26D-4504-AC2E-01D57788F540}"/>
              </a:ext>
            </a:extLst>
          </p:cNvPr>
          <p:cNvSpPr txBox="1"/>
          <p:nvPr/>
        </p:nvSpPr>
        <p:spPr>
          <a:xfrm rot="16200000">
            <a:off x="7112203" y="298468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600</a:t>
            </a:r>
            <a:endParaRPr kumimoji="1" lang="ja-JP" altLang="en-US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4EDDAC1-F790-413E-A4B5-E5822A641E65}"/>
              </a:ext>
            </a:extLst>
          </p:cNvPr>
          <p:cNvSpPr txBox="1"/>
          <p:nvPr/>
        </p:nvSpPr>
        <p:spPr>
          <a:xfrm rot="16200000">
            <a:off x="7390082" y="2984682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900</a:t>
            </a:r>
            <a:endParaRPr kumimoji="1" lang="ja-JP" altLang="en-US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6865AE58-043B-4FB0-A308-D5EA342F7C84}"/>
              </a:ext>
            </a:extLst>
          </p:cNvPr>
          <p:cNvSpPr txBox="1"/>
          <p:nvPr/>
        </p:nvSpPr>
        <p:spPr>
          <a:xfrm rot="16200000">
            <a:off x="7512680" y="3043192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1200</a:t>
            </a:r>
            <a:endParaRPr kumimoji="1" lang="ja-JP" altLang="en-US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0CDC0EA-58D9-45E0-AD79-E7361616239F}"/>
              </a:ext>
            </a:extLst>
          </p:cNvPr>
          <p:cNvSpPr txBox="1"/>
          <p:nvPr/>
        </p:nvSpPr>
        <p:spPr>
          <a:xfrm rot="16200000">
            <a:off x="7682106" y="3043192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1500</a:t>
            </a:r>
            <a:endParaRPr kumimoji="1" lang="ja-JP" altLang="en-US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BBDF4C2-3F79-4E02-B08D-367DB905DCDD}"/>
              </a:ext>
            </a:extLst>
          </p:cNvPr>
          <p:cNvSpPr txBox="1"/>
          <p:nvPr/>
        </p:nvSpPr>
        <p:spPr>
          <a:xfrm rot="16200000">
            <a:off x="7908185" y="3043192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2000</a:t>
            </a:r>
            <a:endParaRPr kumimoji="1" lang="ja-JP" altLang="en-US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DE45D2E-F64B-45B5-A3D1-DE0D6F67B56E}"/>
              </a:ext>
            </a:extLst>
          </p:cNvPr>
          <p:cNvSpPr txBox="1"/>
          <p:nvPr/>
        </p:nvSpPr>
        <p:spPr>
          <a:xfrm rot="16200000">
            <a:off x="8082960" y="3043192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2500</a:t>
            </a:r>
            <a:endParaRPr kumimoji="1" lang="ja-JP" altLang="en-US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AC1E332-A0C7-411D-A386-4CB61BA36425}"/>
              </a:ext>
            </a:extLst>
          </p:cNvPr>
          <p:cNvSpPr txBox="1"/>
          <p:nvPr/>
        </p:nvSpPr>
        <p:spPr>
          <a:xfrm rot="16200000">
            <a:off x="8251345" y="3043192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3000</a:t>
            </a:r>
            <a:endParaRPr kumimoji="1" lang="ja-JP" altLang="en-US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466E468-4131-4762-A72A-080F645E7F6F}"/>
              </a:ext>
            </a:extLst>
          </p:cNvPr>
          <p:cNvSpPr txBox="1"/>
          <p:nvPr/>
        </p:nvSpPr>
        <p:spPr>
          <a:xfrm rot="16200000">
            <a:off x="8487566" y="3043192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4000</a:t>
            </a:r>
            <a:endParaRPr kumimoji="1" lang="ja-JP" altLang="en-US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686E6D2-A406-4557-A203-9AC0B2ED5F15}"/>
              </a:ext>
            </a:extLst>
          </p:cNvPr>
          <p:cNvSpPr txBox="1"/>
          <p:nvPr/>
        </p:nvSpPr>
        <p:spPr>
          <a:xfrm rot="16200000">
            <a:off x="8694051" y="3043192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7000</a:t>
            </a:r>
            <a:endParaRPr kumimoji="1" lang="ja-JP" altLang="en-US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1C25B1D-C0F8-41CA-98EE-CE50F06770E5}"/>
              </a:ext>
            </a:extLst>
          </p:cNvPr>
          <p:cNvSpPr txBox="1"/>
          <p:nvPr/>
        </p:nvSpPr>
        <p:spPr>
          <a:xfrm rot="16200000">
            <a:off x="8835448" y="3101702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15000</a:t>
            </a:r>
            <a:endParaRPr kumimoji="1" lang="ja-JP" altLang="en-US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CAC1D8B-5F0B-4F3D-AF65-54387BE8B140}"/>
              </a:ext>
            </a:extLst>
          </p:cNvPr>
          <p:cNvSpPr txBox="1"/>
          <p:nvPr/>
        </p:nvSpPr>
        <p:spPr>
          <a:xfrm rot="16200000">
            <a:off x="9024909" y="3101702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48500</a:t>
            </a:r>
            <a:endParaRPr kumimoji="1" lang="ja-JP" altLang="en-US" dirty="0"/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247A3164-8A41-45F6-8C49-682AC87FC4A0}"/>
              </a:ext>
            </a:extLst>
          </p:cNvPr>
          <p:cNvCxnSpPr/>
          <p:nvPr/>
        </p:nvCxnSpPr>
        <p:spPr>
          <a:xfrm>
            <a:off x="647284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D68EBDFC-8D89-4DCB-BD41-0EC755F5C7C3}"/>
              </a:ext>
            </a:extLst>
          </p:cNvPr>
          <p:cNvCxnSpPr/>
          <p:nvPr/>
        </p:nvCxnSpPr>
        <p:spPr>
          <a:xfrm>
            <a:off x="680812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87E5C0CF-E737-4426-914A-854672BF4F6B}"/>
              </a:ext>
            </a:extLst>
          </p:cNvPr>
          <p:cNvCxnSpPr/>
          <p:nvPr/>
        </p:nvCxnSpPr>
        <p:spPr>
          <a:xfrm>
            <a:off x="711292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61FD9E21-A9ED-4407-9C3F-B1FEEBDCE63B}"/>
              </a:ext>
            </a:extLst>
          </p:cNvPr>
          <p:cNvCxnSpPr/>
          <p:nvPr/>
        </p:nvCxnSpPr>
        <p:spPr>
          <a:xfrm>
            <a:off x="740248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325F202B-5BAB-4CCA-A735-A0490645B9C2}"/>
              </a:ext>
            </a:extLst>
          </p:cNvPr>
          <p:cNvCxnSpPr/>
          <p:nvPr/>
        </p:nvCxnSpPr>
        <p:spPr>
          <a:xfrm>
            <a:off x="766918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A21B6008-04CC-4C0B-843D-711F7956D4D2}"/>
              </a:ext>
            </a:extLst>
          </p:cNvPr>
          <p:cNvCxnSpPr/>
          <p:nvPr/>
        </p:nvCxnSpPr>
        <p:spPr>
          <a:xfrm>
            <a:off x="785206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1B28EF0C-C48E-41B9-B423-696A89E69FBF}"/>
              </a:ext>
            </a:extLst>
          </p:cNvPr>
          <p:cNvCxnSpPr/>
          <p:nvPr/>
        </p:nvCxnSpPr>
        <p:spPr>
          <a:xfrm>
            <a:off x="800446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7D457C31-150B-42EC-A260-1F86AE02C9F7}"/>
              </a:ext>
            </a:extLst>
          </p:cNvPr>
          <p:cNvCxnSpPr/>
          <p:nvPr/>
        </p:nvCxnSpPr>
        <p:spPr>
          <a:xfrm>
            <a:off x="824068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433145C6-858F-4238-9B8F-7CBC980BF9D1}"/>
              </a:ext>
            </a:extLst>
          </p:cNvPr>
          <p:cNvCxnSpPr/>
          <p:nvPr/>
        </p:nvCxnSpPr>
        <p:spPr>
          <a:xfrm>
            <a:off x="841594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414C62F1-D68E-4E73-B6F0-95989AAD7668}"/>
              </a:ext>
            </a:extLst>
          </p:cNvPr>
          <p:cNvCxnSpPr/>
          <p:nvPr/>
        </p:nvCxnSpPr>
        <p:spPr>
          <a:xfrm>
            <a:off x="858358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8B643327-79F8-4CAA-BF62-F30862E5205B}"/>
              </a:ext>
            </a:extLst>
          </p:cNvPr>
          <p:cNvCxnSpPr/>
          <p:nvPr/>
        </p:nvCxnSpPr>
        <p:spPr>
          <a:xfrm>
            <a:off x="881218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445DDD2B-C804-42D8-B772-6C50DA7AD57F}"/>
              </a:ext>
            </a:extLst>
          </p:cNvPr>
          <p:cNvCxnSpPr/>
          <p:nvPr/>
        </p:nvCxnSpPr>
        <p:spPr>
          <a:xfrm>
            <a:off x="903316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68615E2C-5A2D-4A91-88CF-FA023C56A548}"/>
              </a:ext>
            </a:extLst>
          </p:cNvPr>
          <p:cNvCxnSpPr/>
          <p:nvPr/>
        </p:nvCxnSpPr>
        <p:spPr>
          <a:xfrm>
            <a:off x="923128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89BD50E0-5298-49AC-88F4-CBF2FF734E43}"/>
              </a:ext>
            </a:extLst>
          </p:cNvPr>
          <p:cNvCxnSpPr/>
          <p:nvPr/>
        </p:nvCxnSpPr>
        <p:spPr>
          <a:xfrm>
            <a:off x="9406544" y="2608130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D2D307C-4DA8-46F1-BA68-DAA7E44FE619}"/>
              </a:ext>
            </a:extLst>
          </p:cNvPr>
          <p:cNvSpPr txBox="1"/>
          <p:nvPr/>
        </p:nvSpPr>
        <p:spPr>
          <a:xfrm rot="16200000">
            <a:off x="6217856" y="686381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100</a:t>
            </a:r>
            <a:endParaRPr kumimoji="1" lang="ja-JP" altLang="en-US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AE49BC0D-7455-4B72-9351-6267AB96E9F7}"/>
              </a:ext>
            </a:extLst>
          </p:cNvPr>
          <p:cNvSpPr txBox="1"/>
          <p:nvPr/>
        </p:nvSpPr>
        <p:spPr>
          <a:xfrm rot="16200000">
            <a:off x="6519828" y="686381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250</a:t>
            </a:r>
            <a:endParaRPr kumimoji="1" lang="ja-JP" altLang="en-US" dirty="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A4D24C6-E9AD-4DF5-9A4F-183C89012D54}"/>
              </a:ext>
            </a:extLst>
          </p:cNvPr>
          <p:cNvSpPr txBox="1"/>
          <p:nvPr/>
        </p:nvSpPr>
        <p:spPr>
          <a:xfrm rot="16200000">
            <a:off x="6853335" y="686381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400</a:t>
            </a:r>
            <a:endParaRPr kumimoji="1" lang="ja-JP" altLang="en-US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20C8133-CF3F-4021-8EC1-48134B394DED}"/>
              </a:ext>
            </a:extLst>
          </p:cNvPr>
          <p:cNvSpPr txBox="1"/>
          <p:nvPr/>
        </p:nvSpPr>
        <p:spPr>
          <a:xfrm rot="16200000">
            <a:off x="7110655" y="686381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600</a:t>
            </a:r>
            <a:endParaRPr kumimoji="1" lang="ja-JP" altLang="en-US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E8535DA-5847-4D40-A5D7-77A64E6E3F5F}"/>
              </a:ext>
            </a:extLst>
          </p:cNvPr>
          <p:cNvSpPr txBox="1"/>
          <p:nvPr/>
        </p:nvSpPr>
        <p:spPr>
          <a:xfrm rot="16200000">
            <a:off x="7388534" y="686381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900</a:t>
            </a:r>
            <a:endParaRPr kumimoji="1" lang="ja-JP" altLang="en-US" dirty="0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4866212D-A393-4782-9276-65BF45F0A7CE}"/>
              </a:ext>
            </a:extLst>
          </p:cNvPr>
          <p:cNvSpPr txBox="1"/>
          <p:nvPr/>
        </p:nvSpPr>
        <p:spPr>
          <a:xfrm rot="16200000">
            <a:off x="7511132" y="692232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1200</a:t>
            </a:r>
            <a:endParaRPr kumimoji="1" lang="ja-JP" altLang="en-US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0E8DF553-31AD-4654-99C4-722F58DAD9BB}"/>
              </a:ext>
            </a:extLst>
          </p:cNvPr>
          <p:cNvSpPr txBox="1"/>
          <p:nvPr/>
        </p:nvSpPr>
        <p:spPr>
          <a:xfrm rot="16200000">
            <a:off x="7680558" y="692232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1500</a:t>
            </a:r>
            <a:endParaRPr kumimoji="1" lang="ja-JP" altLang="en-US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C41A417D-822D-4278-BCA0-12A91CCD4F04}"/>
              </a:ext>
            </a:extLst>
          </p:cNvPr>
          <p:cNvSpPr txBox="1"/>
          <p:nvPr/>
        </p:nvSpPr>
        <p:spPr>
          <a:xfrm rot="16200000">
            <a:off x="7906637" y="692232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2000</a:t>
            </a:r>
            <a:endParaRPr kumimoji="1" lang="ja-JP" altLang="en-US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8F6AC48B-1EB8-4EFB-A8E4-ED9ECD25C26E}"/>
              </a:ext>
            </a:extLst>
          </p:cNvPr>
          <p:cNvSpPr txBox="1"/>
          <p:nvPr/>
        </p:nvSpPr>
        <p:spPr>
          <a:xfrm rot="16200000">
            <a:off x="8081412" y="692232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2500</a:t>
            </a:r>
            <a:endParaRPr kumimoji="1" lang="ja-JP" altLang="en-US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2548D013-D9AC-44C4-A1BD-0E186939685B}"/>
              </a:ext>
            </a:extLst>
          </p:cNvPr>
          <p:cNvSpPr txBox="1"/>
          <p:nvPr/>
        </p:nvSpPr>
        <p:spPr>
          <a:xfrm rot="16200000">
            <a:off x="8249797" y="692232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3000</a:t>
            </a:r>
            <a:endParaRPr kumimoji="1" lang="ja-JP" altLang="en-US" dirty="0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013D0B63-6060-4AAA-BADA-067828938C40}"/>
              </a:ext>
            </a:extLst>
          </p:cNvPr>
          <p:cNvSpPr txBox="1"/>
          <p:nvPr/>
        </p:nvSpPr>
        <p:spPr>
          <a:xfrm rot="16200000">
            <a:off x="8486018" y="692232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4000</a:t>
            </a:r>
            <a:endParaRPr kumimoji="1" lang="ja-JP" altLang="en-US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B8BB362F-149C-4FD9-A857-FFC70AF032F5}"/>
              </a:ext>
            </a:extLst>
          </p:cNvPr>
          <p:cNvSpPr txBox="1"/>
          <p:nvPr/>
        </p:nvSpPr>
        <p:spPr>
          <a:xfrm rot="16200000">
            <a:off x="8692503" y="692232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7000</a:t>
            </a:r>
            <a:endParaRPr kumimoji="1" lang="ja-JP" altLang="en-US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EBD4F420-11C4-44A0-8C8C-8601BC3BF69B}"/>
              </a:ext>
            </a:extLst>
          </p:cNvPr>
          <p:cNvSpPr txBox="1"/>
          <p:nvPr/>
        </p:nvSpPr>
        <p:spPr>
          <a:xfrm rot="16200000">
            <a:off x="8833900" y="6980838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15000</a:t>
            </a:r>
            <a:endParaRPr kumimoji="1" lang="ja-JP" altLang="en-US" dirty="0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241B4FCB-A560-442A-AFD5-A61D83D37EE2}"/>
              </a:ext>
            </a:extLst>
          </p:cNvPr>
          <p:cNvSpPr txBox="1"/>
          <p:nvPr/>
        </p:nvSpPr>
        <p:spPr>
          <a:xfrm rot="16200000">
            <a:off x="9023361" y="6980838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dirty="0"/>
              <a:t>48500</a:t>
            </a:r>
            <a:endParaRPr kumimoji="1" lang="ja-JP" altLang="en-US" dirty="0"/>
          </a:p>
        </p:txBody>
      </p: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09B36567-BDCD-4DD1-860D-912893751CAF}"/>
              </a:ext>
            </a:extLst>
          </p:cNvPr>
          <p:cNvCxnSpPr/>
          <p:nvPr/>
        </p:nvCxnSpPr>
        <p:spPr>
          <a:xfrm>
            <a:off x="647129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4CCADDBC-E348-4C12-BCF4-F4AD93709FDE}"/>
              </a:ext>
            </a:extLst>
          </p:cNvPr>
          <p:cNvCxnSpPr/>
          <p:nvPr/>
        </p:nvCxnSpPr>
        <p:spPr>
          <a:xfrm>
            <a:off x="680657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8184A1F3-6BF4-487E-853E-21C62217D3B1}"/>
              </a:ext>
            </a:extLst>
          </p:cNvPr>
          <p:cNvCxnSpPr/>
          <p:nvPr/>
        </p:nvCxnSpPr>
        <p:spPr>
          <a:xfrm>
            <a:off x="711137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線コネクタ 90">
            <a:extLst>
              <a:ext uri="{FF2B5EF4-FFF2-40B4-BE49-F238E27FC236}">
                <a16:creationId xmlns:a16="http://schemas.microsoft.com/office/drawing/2014/main" id="{4258BDDE-35D0-4A9C-8F2E-B349CD5AC35D}"/>
              </a:ext>
            </a:extLst>
          </p:cNvPr>
          <p:cNvCxnSpPr/>
          <p:nvPr/>
        </p:nvCxnSpPr>
        <p:spPr>
          <a:xfrm>
            <a:off x="740093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9F8B7F7A-B70E-40B4-AC00-0B7FBF9FA214}"/>
              </a:ext>
            </a:extLst>
          </p:cNvPr>
          <p:cNvCxnSpPr/>
          <p:nvPr/>
        </p:nvCxnSpPr>
        <p:spPr>
          <a:xfrm>
            <a:off x="766763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id="{BDFA3CA4-D042-4456-B711-49D0976F646C}"/>
              </a:ext>
            </a:extLst>
          </p:cNvPr>
          <p:cNvCxnSpPr/>
          <p:nvPr/>
        </p:nvCxnSpPr>
        <p:spPr>
          <a:xfrm>
            <a:off x="785051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B1A0913F-34D5-4E40-9E41-6B6F3B8BA923}"/>
              </a:ext>
            </a:extLst>
          </p:cNvPr>
          <p:cNvCxnSpPr/>
          <p:nvPr/>
        </p:nvCxnSpPr>
        <p:spPr>
          <a:xfrm>
            <a:off x="800291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直線コネクタ 94">
            <a:extLst>
              <a:ext uri="{FF2B5EF4-FFF2-40B4-BE49-F238E27FC236}">
                <a16:creationId xmlns:a16="http://schemas.microsoft.com/office/drawing/2014/main" id="{90B26F0A-463A-41F0-834E-A445B4E00F6E}"/>
              </a:ext>
            </a:extLst>
          </p:cNvPr>
          <p:cNvCxnSpPr/>
          <p:nvPr/>
        </p:nvCxnSpPr>
        <p:spPr>
          <a:xfrm>
            <a:off x="823913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A6222213-E606-4B17-9D8B-53D34E21EADE}"/>
              </a:ext>
            </a:extLst>
          </p:cNvPr>
          <p:cNvCxnSpPr/>
          <p:nvPr/>
        </p:nvCxnSpPr>
        <p:spPr>
          <a:xfrm>
            <a:off x="841439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E1B03511-D861-4953-AEA2-940438BC3658}"/>
              </a:ext>
            </a:extLst>
          </p:cNvPr>
          <p:cNvCxnSpPr/>
          <p:nvPr/>
        </p:nvCxnSpPr>
        <p:spPr>
          <a:xfrm>
            <a:off x="858203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1BED2E11-5B2D-4CFC-B888-9D39FA83C466}"/>
              </a:ext>
            </a:extLst>
          </p:cNvPr>
          <p:cNvCxnSpPr/>
          <p:nvPr/>
        </p:nvCxnSpPr>
        <p:spPr>
          <a:xfrm>
            <a:off x="881063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1333D759-2CFB-4109-A2FA-216FAE07FF4D}"/>
              </a:ext>
            </a:extLst>
          </p:cNvPr>
          <p:cNvCxnSpPr/>
          <p:nvPr/>
        </p:nvCxnSpPr>
        <p:spPr>
          <a:xfrm>
            <a:off x="903161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48E8F83C-CF9C-4047-940A-3DD15C7B6003}"/>
              </a:ext>
            </a:extLst>
          </p:cNvPr>
          <p:cNvCxnSpPr/>
          <p:nvPr/>
        </p:nvCxnSpPr>
        <p:spPr>
          <a:xfrm>
            <a:off x="922973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id="{327DF156-6DE9-4667-B943-7CDA47D5B0C3}"/>
              </a:ext>
            </a:extLst>
          </p:cNvPr>
          <p:cNvCxnSpPr/>
          <p:nvPr/>
        </p:nvCxnSpPr>
        <p:spPr>
          <a:xfrm>
            <a:off x="9404996" y="6487266"/>
            <a:ext cx="0" cy="293356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20ACB979-61BC-4E66-ADB7-B41FEE5DDB6A}"/>
              </a:ext>
            </a:extLst>
          </p:cNvPr>
          <p:cNvSpPr txBox="1"/>
          <p:nvPr/>
        </p:nvSpPr>
        <p:spPr>
          <a:xfrm>
            <a:off x="61476" y="8394657"/>
            <a:ext cx="1314652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0" b="1" dirty="0"/>
              <a:t>Supplementary Figure 1.</a:t>
            </a:r>
            <a:r>
              <a:rPr kumimoji="1" lang="en-US" altLang="ja-JP" sz="1800" dirty="0"/>
              <a:t> </a:t>
            </a:r>
            <a:r>
              <a:rPr lang="en-US" altLang="ja-JP" sz="1800" dirty="0">
                <a:effectLst/>
                <a:ea typeface="Times New Roman" panose="02020603050405020304" pitchFamily="18" charset="0"/>
              </a:rPr>
              <a:t>Size distribution of extracted DNA.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</a:p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A) Results of electrophoresis using a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apeStation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B) Densitometry following electrophoresis using a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apeStation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before SRE treatment. Peak at 100 bp = marker. The percentage of DNA fragments in the range of 7,000 - 60,000 is shown. C) Densitometry analyzed using a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apeStation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fter SRE treatment.</a:t>
            </a:r>
            <a:endParaRPr kumimoji="1" lang="en-US" altLang="ja-JP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2FE4DAE1-9FD5-4D79-8F09-FA9815AC287E}"/>
              </a:ext>
            </a:extLst>
          </p:cNvPr>
          <p:cNvSpPr txBox="1"/>
          <p:nvPr/>
        </p:nvSpPr>
        <p:spPr>
          <a:xfrm>
            <a:off x="1857328" y="59509"/>
            <a:ext cx="462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F6C790EF-5A90-4001-83E3-9D4492823C80}"/>
              </a:ext>
            </a:extLst>
          </p:cNvPr>
          <p:cNvSpPr txBox="1"/>
          <p:nvPr/>
        </p:nvSpPr>
        <p:spPr>
          <a:xfrm>
            <a:off x="4874484" y="59509"/>
            <a:ext cx="462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75351C89-C52E-4038-8F84-F591C7CC9672}"/>
              </a:ext>
            </a:extLst>
          </p:cNvPr>
          <p:cNvSpPr txBox="1"/>
          <p:nvPr/>
        </p:nvSpPr>
        <p:spPr>
          <a:xfrm>
            <a:off x="4874484" y="3660937"/>
            <a:ext cx="462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BB25AC6-7C1C-455A-8946-F25EC77D0A66}"/>
              </a:ext>
            </a:extLst>
          </p:cNvPr>
          <p:cNvSpPr txBox="1"/>
          <p:nvPr/>
        </p:nvSpPr>
        <p:spPr>
          <a:xfrm>
            <a:off x="2116220" y="260824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8,500</a:t>
            </a:r>
            <a:endParaRPr kumimoji="1" lang="ja-JP" altLang="en-US" sz="1200" dirty="0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09EB251F-3BCF-4D22-9556-97AEB3628A39}"/>
              </a:ext>
            </a:extLst>
          </p:cNvPr>
          <p:cNvSpPr txBox="1"/>
          <p:nvPr/>
        </p:nvSpPr>
        <p:spPr>
          <a:xfrm>
            <a:off x="2116220" y="276523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5,000</a:t>
            </a:r>
            <a:endParaRPr kumimoji="1" lang="ja-JP" altLang="en-US" sz="1200" dirty="0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75E12772-87D7-4D26-89BC-C03E3C7BE34E}"/>
              </a:ext>
            </a:extLst>
          </p:cNvPr>
          <p:cNvSpPr txBox="1"/>
          <p:nvPr/>
        </p:nvSpPr>
        <p:spPr>
          <a:xfrm>
            <a:off x="2116220" y="2928444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7,000</a:t>
            </a:r>
            <a:endParaRPr kumimoji="1" lang="ja-JP" altLang="en-US" sz="1200" dirty="0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1010B6EB-1B44-4CD6-A740-698CC8EFB133}"/>
              </a:ext>
            </a:extLst>
          </p:cNvPr>
          <p:cNvSpPr txBox="1"/>
          <p:nvPr/>
        </p:nvSpPr>
        <p:spPr>
          <a:xfrm>
            <a:off x="2116220" y="3098986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,000</a:t>
            </a:r>
            <a:endParaRPr kumimoji="1" lang="ja-JP" altLang="en-US" sz="1200" dirty="0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743D97F7-FCA7-40D9-A929-20F8168B4433}"/>
              </a:ext>
            </a:extLst>
          </p:cNvPr>
          <p:cNvSpPr txBox="1"/>
          <p:nvPr/>
        </p:nvSpPr>
        <p:spPr>
          <a:xfrm>
            <a:off x="2116220" y="3303241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,000</a:t>
            </a:r>
            <a:endParaRPr kumimoji="1" lang="ja-JP" altLang="en-US" sz="1200" dirty="0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B0B6BE90-F205-4937-965D-F2D005B43442}"/>
              </a:ext>
            </a:extLst>
          </p:cNvPr>
          <p:cNvSpPr txBox="1"/>
          <p:nvPr/>
        </p:nvSpPr>
        <p:spPr>
          <a:xfrm>
            <a:off x="2116220" y="3455129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,500</a:t>
            </a:r>
            <a:endParaRPr kumimoji="1" lang="ja-JP" altLang="en-US" sz="1200" dirty="0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2012F54B-EE51-4CA1-8F0D-069DF08407C3}"/>
              </a:ext>
            </a:extLst>
          </p:cNvPr>
          <p:cNvSpPr txBox="1"/>
          <p:nvPr/>
        </p:nvSpPr>
        <p:spPr>
          <a:xfrm>
            <a:off x="2116220" y="3608868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,000</a:t>
            </a:r>
            <a:endParaRPr kumimoji="1" lang="ja-JP" altLang="en-US" sz="1200" dirty="0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BFB39E63-559A-4204-8429-BA2FBED75729}"/>
              </a:ext>
            </a:extLst>
          </p:cNvPr>
          <p:cNvSpPr txBox="1"/>
          <p:nvPr/>
        </p:nvSpPr>
        <p:spPr>
          <a:xfrm>
            <a:off x="2116220" y="3790923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,500</a:t>
            </a:r>
            <a:endParaRPr kumimoji="1" lang="ja-JP" altLang="en-US" sz="1200" dirty="0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C138CA0D-42E2-4BB6-97BF-8B1735846581}"/>
              </a:ext>
            </a:extLst>
          </p:cNvPr>
          <p:cNvSpPr txBox="1"/>
          <p:nvPr/>
        </p:nvSpPr>
        <p:spPr>
          <a:xfrm>
            <a:off x="2116220" y="3916267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,200</a:t>
            </a:r>
            <a:endParaRPr kumimoji="1" lang="ja-JP" altLang="en-US" sz="1200" dirty="0"/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6B07E0E2-3624-4CC9-A55E-89B62A67D7D8}"/>
              </a:ext>
            </a:extLst>
          </p:cNvPr>
          <p:cNvSpPr txBox="1"/>
          <p:nvPr/>
        </p:nvSpPr>
        <p:spPr>
          <a:xfrm>
            <a:off x="2116220" y="406139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900</a:t>
            </a:r>
            <a:endParaRPr kumimoji="1" lang="ja-JP" altLang="en-US" sz="1200" dirty="0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D04A4D24-06E5-4F6A-A194-6DEC100C5E3B}"/>
              </a:ext>
            </a:extLst>
          </p:cNvPr>
          <p:cNvSpPr txBox="1"/>
          <p:nvPr/>
        </p:nvSpPr>
        <p:spPr>
          <a:xfrm>
            <a:off x="2116220" y="431400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00</a:t>
            </a:r>
            <a:endParaRPr kumimoji="1" lang="ja-JP" altLang="en-US" sz="1200" dirty="0"/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D3D8BE17-78DA-4F27-8D3E-296676700815}"/>
              </a:ext>
            </a:extLst>
          </p:cNvPr>
          <p:cNvSpPr txBox="1"/>
          <p:nvPr/>
        </p:nvSpPr>
        <p:spPr>
          <a:xfrm>
            <a:off x="2116220" y="454296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00</a:t>
            </a:r>
            <a:endParaRPr kumimoji="1" lang="ja-JP" altLang="en-US" sz="1200" dirty="0"/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7D65DD1F-5C31-4D01-83BF-37973D566D3F}"/>
              </a:ext>
            </a:extLst>
          </p:cNvPr>
          <p:cNvSpPr txBox="1"/>
          <p:nvPr/>
        </p:nvSpPr>
        <p:spPr>
          <a:xfrm>
            <a:off x="2116220" y="481641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50</a:t>
            </a:r>
            <a:endParaRPr kumimoji="1" lang="ja-JP" altLang="en-US" sz="1200" dirty="0"/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99262630-8E26-43E3-B8C6-55393FD6CE3F}"/>
              </a:ext>
            </a:extLst>
          </p:cNvPr>
          <p:cNvSpPr txBox="1"/>
          <p:nvPr/>
        </p:nvSpPr>
        <p:spPr>
          <a:xfrm>
            <a:off x="2116220" y="511676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00</a:t>
            </a:r>
            <a:endParaRPr kumimoji="1" lang="ja-JP" altLang="en-US" sz="1200" dirty="0"/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4DCE1A64-ED3F-4539-BD5E-256226D2E61A}"/>
              </a:ext>
            </a:extLst>
          </p:cNvPr>
          <p:cNvSpPr txBox="1"/>
          <p:nvPr/>
        </p:nvSpPr>
        <p:spPr>
          <a:xfrm>
            <a:off x="2116220" y="2066477"/>
            <a:ext cx="437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[bp]</a:t>
            </a:r>
          </a:p>
        </p:txBody>
      </p:sp>
    </p:spTree>
    <p:extLst>
      <p:ext uri="{BB962C8B-B14F-4D97-AF65-F5344CB8AC3E}">
        <p14:creationId xmlns:p14="http://schemas.microsoft.com/office/powerpoint/2010/main" val="2799955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, 折れ線グラフ&#10;&#10;自動的に生成された説明">
            <a:extLst>
              <a:ext uri="{FF2B5EF4-FFF2-40B4-BE49-F238E27FC236}">
                <a16:creationId xmlns:a16="http://schemas.microsoft.com/office/drawing/2014/main" id="{99D4E84A-3734-D049-9D1A-9AC94ABD87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000" y="0"/>
            <a:ext cx="9171898" cy="917189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CD95059-A079-6843-8516-3BCD3155570C}"/>
              </a:ext>
            </a:extLst>
          </p:cNvPr>
          <p:cNvSpPr txBox="1"/>
          <p:nvPr/>
        </p:nvSpPr>
        <p:spPr>
          <a:xfrm>
            <a:off x="509665" y="9075003"/>
            <a:ext cx="11557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Supplementary Figure 2. Whole genome dot plot analysis of </a:t>
            </a:r>
            <a:r>
              <a:rPr kumimoji="1" lang="en-US" altLang="ja-JP" sz="1600" i="1" dirty="0" err="1"/>
              <a:t>Gasterosteus</a:t>
            </a:r>
            <a:r>
              <a:rPr kumimoji="1" lang="en-US" altLang="ja-JP" sz="1600" i="1" dirty="0"/>
              <a:t> </a:t>
            </a:r>
            <a:r>
              <a:rPr kumimoji="1" lang="en-US" altLang="ja-JP" sz="1600" i="1" dirty="0" err="1"/>
              <a:t>nipponicus</a:t>
            </a:r>
            <a:r>
              <a:rPr kumimoji="1" lang="en-US" altLang="ja-JP" sz="1600" dirty="0"/>
              <a:t> and </a:t>
            </a:r>
            <a:r>
              <a:rPr kumimoji="1" lang="en-US" altLang="ja-JP" sz="1600" i="1" dirty="0" err="1"/>
              <a:t>Gasterosteus</a:t>
            </a:r>
            <a:r>
              <a:rPr kumimoji="1" lang="en-US" altLang="ja-JP" sz="1600" i="1" dirty="0"/>
              <a:t> aculeatus</a:t>
            </a:r>
          </a:p>
          <a:p>
            <a:r>
              <a:rPr kumimoji="1" lang="en" altLang="ja-JP" sz="1600" dirty="0"/>
              <a:t>In Figure 3, unoriented contigs are included as small contigs separate from the chromosomes. </a:t>
            </a:r>
          </a:p>
          <a:p>
            <a:r>
              <a:rPr kumimoji="1" lang="en" altLang="ja-JP" sz="1600" dirty="0"/>
              <a:t>In this figure, unoriented contigs are excluded from the dot plot</a:t>
            </a:r>
            <a:r>
              <a:rPr kumimoji="1" lang="en-US" altLang="ja-JP" sz="1600" dirty="0"/>
              <a:t> to compare the size of the chromosomes.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341227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図 84" descr="パソコンの画面&#10;&#10;中程度の精度で自動的に生成された説明">
            <a:extLst>
              <a:ext uri="{FF2B5EF4-FFF2-40B4-BE49-F238E27FC236}">
                <a16:creationId xmlns:a16="http://schemas.microsoft.com/office/drawing/2014/main" id="{9C79380A-5686-4539-A378-6E980C63DD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000" y="0"/>
            <a:ext cx="9906000" cy="9906000"/>
          </a:xfrm>
          <a:prstGeom prst="rect">
            <a:avLst/>
          </a:prstGeom>
        </p:spPr>
      </p:pic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C1963826-252C-4558-8BED-ABAB4DFC4E53}"/>
              </a:ext>
            </a:extLst>
          </p:cNvPr>
          <p:cNvSpPr txBox="1"/>
          <p:nvPr/>
        </p:nvSpPr>
        <p:spPr>
          <a:xfrm>
            <a:off x="0" y="9536668"/>
            <a:ext cx="12202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Supplementary Figure 3. Whole-genome dot plot for </a:t>
            </a:r>
            <a:r>
              <a:rPr kumimoji="1" lang="en-US" altLang="ja-JP" sz="1600" i="1" dirty="0"/>
              <a:t>G. aculeatus </a:t>
            </a:r>
            <a:r>
              <a:rPr kumimoji="1" lang="en-US" altLang="ja-JP" sz="1600" dirty="0"/>
              <a:t>(</a:t>
            </a:r>
            <a:r>
              <a:rPr kumimoji="1" lang="en-US" altLang="ja-JP" sz="1600" i="1" dirty="0"/>
              <a:t>x</a:t>
            </a:r>
            <a:r>
              <a:rPr kumimoji="1" lang="en-US" altLang="ja-JP" sz="1600" dirty="0"/>
              <a:t>-axis) and SELDLA-extended </a:t>
            </a:r>
            <a:r>
              <a:rPr kumimoji="1" lang="en-US" altLang="ja-JP" sz="1600" i="1" dirty="0"/>
              <a:t>G. </a:t>
            </a:r>
            <a:r>
              <a:rPr kumimoji="1" lang="en-US" altLang="ja-JP" sz="1600" i="1" dirty="0" err="1"/>
              <a:t>nipponicus</a:t>
            </a:r>
            <a:r>
              <a:rPr kumimoji="1" lang="en-US" altLang="ja-JP" sz="1600" i="1" dirty="0"/>
              <a:t> </a:t>
            </a:r>
            <a:r>
              <a:rPr kumimoji="1" lang="en-US" altLang="ja-JP" sz="1600" dirty="0"/>
              <a:t>using 100 single sperm (</a:t>
            </a:r>
            <a:r>
              <a:rPr kumimoji="1" lang="en-US" altLang="ja-JP" sz="1600" i="1" dirty="0"/>
              <a:t>y</a:t>
            </a:r>
            <a:r>
              <a:rPr kumimoji="1" lang="en-US" altLang="ja-JP" sz="1600" dirty="0"/>
              <a:t>-axis)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636003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コンピューターのスクリーンショット&#10;&#10;低い精度で自動的に生成された説明">
            <a:extLst>
              <a:ext uri="{FF2B5EF4-FFF2-40B4-BE49-F238E27FC236}">
                <a16:creationId xmlns:a16="http://schemas.microsoft.com/office/drawing/2014/main" id="{512A46F9-DFAD-465D-A2E6-BB600816A3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000" y="0"/>
            <a:ext cx="9906000" cy="9906000"/>
          </a:xfrm>
          <a:prstGeom prst="rect">
            <a:avLst/>
          </a:prstGeom>
        </p:spPr>
      </p:pic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F9953033-7996-49BF-99C7-781199D3B854}"/>
              </a:ext>
            </a:extLst>
          </p:cNvPr>
          <p:cNvSpPr txBox="1"/>
          <p:nvPr/>
        </p:nvSpPr>
        <p:spPr>
          <a:xfrm>
            <a:off x="0" y="9536668"/>
            <a:ext cx="12202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Supplementary Figure 4. Whole-genome dot plot for </a:t>
            </a:r>
            <a:r>
              <a:rPr kumimoji="1" lang="en-US" altLang="ja-JP" sz="1600" i="1" dirty="0"/>
              <a:t>G. aculeatus </a:t>
            </a:r>
            <a:r>
              <a:rPr kumimoji="1" lang="en-US" altLang="ja-JP" sz="1600" dirty="0"/>
              <a:t>(</a:t>
            </a:r>
            <a:r>
              <a:rPr kumimoji="1" lang="en-US" altLang="ja-JP" sz="1600" i="1" dirty="0"/>
              <a:t>x</a:t>
            </a:r>
            <a:r>
              <a:rPr kumimoji="1" lang="en-US" altLang="ja-JP" sz="1600" dirty="0"/>
              <a:t>-axis) and SELDLA-extended </a:t>
            </a:r>
            <a:r>
              <a:rPr kumimoji="1" lang="en-US" altLang="ja-JP" sz="1600" i="1" dirty="0"/>
              <a:t>G. </a:t>
            </a:r>
            <a:r>
              <a:rPr kumimoji="1" lang="en-US" altLang="ja-JP" sz="1600" i="1" dirty="0" err="1"/>
              <a:t>nipponicus</a:t>
            </a:r>
            <a:r>
              <a:rPr kumimoji="1" lang="en-US" altLang="ja-JP" sz="1600" i="1" dirty="0"/>
              <a:t> </a:t>
            </a:r>
            <a:r>
              <a:rPr kumimoji="1" lang="en-US" altLang="ja-JP" sz="1600" dirty="0"/>
              <a:t>using 200 single sperm (</a:t>
            </a:r>
            <a:r>
              <a:rPr kumimoji="1" lang="en-US" altLang="ja-JP" sz="1600" i="1" dirty="0"/>
              <a:t>y</a:t>
            </a:r>
            <a:r>
              <a:rPr kumimoji="1" lang="en-US" altLang="ja-JP" sz="1600" dirty="0"/>
              <a:t>-axis)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7893424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コンピューターのスクリーンショット&#10;&#10;中程度の精度で自動的に生成された説明">
            <a:extLst>
              <a:ext uri="{FF2B5EF4-FFF2-40B4-BE49-F238E27FC236}">
                <a16:creationId xmlns:a16="http://schemas.microsoft.com/office/drawing/2014/main" id="{BDD8B272-9400-4D42-8605-F2574AEE98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000" y="0"/>
            <a:ext cx="9906000" cy="9906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E929D03-F61C-4BE2-8D6E-1383100473F1}"/>
              </a:ext>
            </a:extLst>
          </p:cNvPr>
          <p:cNvSpPr txBox="1"/>
          <p:nvPr/>
        </p:nvSpPr>
        <p:spPr>
          <a:xfrm>
            <a:off x="0" y="9536668"/>
            <a:ext cx="12202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Supplementary Figure 5. Whole-genome dot plot for </a:t>
            </a:r>
            <a:r>
              <a:rPr kumimoji="1" lang="en-US" altLang="ja-JP" sz="1600" i="1" dirty="0"/>
              <a:t>G. aculeatus </a:t>
            </a:r>
            <a:r>
              <a:rPr kumimoji="1" lang="en-US" altLang="ja-JP" sz="1600" dirty="0"/>
              <a:t>(</a:t>
            </a:r>
            <a:r>
              <a:rPr kumimoji="1" lang="en-US" altLang="ja-JP" sz="1600" i="1" dirty="0"/>
              <a:t>x</a:t>
            </a:r>
            <a:r>
              <a:rPr kumimoji="1" lang="en-US" altLang="ja-JP" sz="1600" dirty="0"/>
              <a:t>-axis) and SELDLA-extended </a:t>
            </a:r>
            <a:r>
              <a:rPr kumimoji="1" lang="en-US" altLang="ja-JP" sz="1600" i="1" dirty="0"/>
              <a:t>G. </a:t>
            </a:r>
            <a:r>
              <a:rPr kumimoji="1" lang="en-US" altLang="ja-JP" sz="1600" i="1" dirty="0" err="1"/>
              <a:t>nipponicus</a:t>
            </a:r>
            <a:r>
              <a:rPr kumimoji="1" lang="en-US" altLang="ja-JP" sz="1600" i="1" dirty="0"/>
              <a:t> </a:t>
            </a:r>
            <a:r>
              <a:rPr kumimoji="1" lang="en-US" altLang="ja-JP" sz="1600" dirty="0"/>
              <a:t>using 400 single sperm (</a:t>
            </a:r>
            <a:r>
              <a:rPr kumimoji="1" lang="en-US" altLang="ja-JP" sz="1600" i="1" dirty="0"/>
              <a:t>y</a:t>
            </a:r>
            <a:r>
              <a:rPr kumimoji="1" lang="en-US" altLang="ja-JP" sz="1600" dirty="0"/>
              <a:t>-axis)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3252692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コンピューターのスクリーンショット&#10;&#10;中程度の精度で自動的に生成された説明">
            <a:extLst>
              <a:ext uri="{FF2B5EF4-FFF2-40B4-BE49-F238E27FC236}">
                <a16:creationId xmlns:a16="http://schemas.microsoft.com/office/drawing/2014/main" id="{3968BE61-2CD6-4DD0-83FA-429C6F1461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000" y="0"/>
            <a:ext cx="9906000" cy="9906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4FFFE7E-BF1D-4F31-A560-01C53E89999D}"/>
              </a:ext>
            </a:extLst>
          </p:cNvPr>
          <p:cNvSpPr txBox="1"/>
          <p:nvPr/>
        </p:nvSpPr>
        <p:spPr>
          <a:xfrm>
            <a:off x="0" y="9536668"/>
            <a:ext cx="12202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Supplementary Figure 6. Whole-genome dot plot for </a:t>
            </a:r>
            <a:r>
              <a:rPr kumimoji="1" lang="en-US" altLang="ja-JP" sz="1600" i="1" dirty="0"/>
              <a:t>G. aculeatus </a:t>
            </a:r>
            <a:r>
              <a:rPr kumimoji="1" lang="en-US" altLang="ja-JP" sz="1600" dirty="0"/>
              <a:t>(</a:t>
            </a:r>
            <a:r>
              <a:rPr kumimoji="1" lang="en-US" altLang="ja-JP" sz="1600" i="1" dirty="0"/>
              <a:t>x</a:t>
            </a:r>
            <a:r>
              <a:rPr kumimoji="1" lang="en-US" altLang="ja-JP" sz="1600" dirty="0"/>
              <a:t>-axis) and SELDLA-extended </a:t>
            </a:r>
            <a:r>
              <a:rPr kumimoji="1" lang="en-US" altLang="ja-JP" sz="1600" i="1" dirty="0"/>
              <a:t>G. </a:t>
            </a:r>
            <a:r>
              <a:rPr kumimoji="1" lang="en-US" altLang="ja-JP" sz="1600" i="1" dirty="0" err="1"/>
              <a:t>nipponicus</a:t>
            </a:r>
            <a:r>
              <a:rPr kumimoji="1" lang="en-US" altLang="ja-JP" sz="1600" i="1" dirty="0"/>
              <a:t> </a:t>
            </a:r>
            <a:r>
              <a:rPr kumimoji="1" lang="en-US" altLang="ja-JP" sz="1600" dirty="0"/>
              <a:t>using 800 single sperm (</a:t>
            </a:r>
            <a:r>
              <a:rPr kumimoji="1" lang="en-US" altLang="ja-JP" sz="1600" i="1" dirty="0"/>
              <a:t>y</a:t>
            </a:r>
            <a:r>
              <a:rPr kumimoji="1" lang="en-US" altLang="ja-JP" sz="1600" dirty="0"/>
              <a:t>-axis)</a:t>
            </a:r>
            <a:endParaRPr kumimoji="1"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154137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761</TotalTime>
  <Words>278</Words>
  <Application>Microsoft Office PowerPoint</Application>
  <PresentationFormat>ユーザー設定</PresentationFormat>
  <Paragraphs>59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武 和敏</dc:creator>
  <cp:lastModifiedBy>Kazutoshi Yoshitake</cp:lastModifiedBy>
  <cp:revision>7</cp:revision>
  <dcterms:created xsi:type="dcterms:W3CDTF">2020-05-01T10:12:35Z</dcterms:created>
  <dcterms:modified xsi:type="dcterms:W3CDTF">2022-03-02T03:02:04Z</dcterms:modified>
</cp:coreProperties>
</file>